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552" r:id="rId2"/>
    <p:sldId id="534" r:id="rId3"/>
    <p:sldId id="558" r:id="rId4"/>
    <p:sldId id="559" r:id="rId5"/>
    <p:sldId id="553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72"/>
    <p:restoredTop sz="95850"/>
  </p:normalViewPr>
  <p:slideViewPr>
    <p:cSldViewPr snapToGrid="0" snapToObjects="1">
      <p:cViewPr varScale="1">
        <p:scale>
          <a:sx n="83" d="100"/>
          <a:sy n="83" d="100"/>
        </p:scale>
        <p:origin x="3400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B95AE8-F928-BE43-91E8-342AEC00C5A6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7F486-4F0C-864A-AA88-95DB8AC41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761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te that the dose was low,</a:t>
            </a:r>
            <a:r>
              <a:rPr lang="en-US" baseline="0" dirty="0"/>
              <a:t> but still produced a significant behavioral effect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B39F0D-7CA7-CE48-A80C-55336046D401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075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457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562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986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684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019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184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98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87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243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792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14528-C0F9-9B45-8F23-E63496402B38}" type="datetimeFigureOut">
              <a:rPr lang="en-US" smtClean="0"/>
              <a:t>10/1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AB296-C111-CB4D-840C-EB7FEE0BFD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428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14.png"/><Relationship Id="rId18" Type="http://schemas.microsoft.com/office/2007/relationships/hdphoto" Target="../media/hdphoto6.wdp"/><Relationship Id="rId3" Type="http://schemas.openxmlformats.org/officeDocument/2006/relationships/image" Target="../media/image8.jpeg"/><Relationship Id="rId7" Type="http://schemas.openxmlformats.org/officeDocument/2006/relationships/image" Target="../media/image11.png"/><Relationship Id="rId12" Type="http://schemas.microsoft.com/office/2007/relationships/hdphoto" Target="../media/hdphoto4.wdp"/><Relationship Id="rId17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6" Type="http://schemas.microsoft.com/office/2007/relationships/hdphoto" Target="../media/hdphoto5.wdp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13.png"/><Relationship Id="rId5" Type="http://schemas.openxmlformats.org/officeDocument/2006/relationships/image" Target="../media/image10.png"/><Relationship Id="rId15" Type="http://schemas.openxmlformats.org/officeDocument/2006/relationships/image" Target="../media/image16.png"/><Relationship Id="rId10" Type="http://schemas.microsoft.com/office/2007/relationships/hdphoto" Target="../media/hdphoto3.wdp"/><Relationship Id="rId19" Type="http://schemas.openxmlformats.org/officeDocument/2006/relationships/image" Target="../media/image18.png"/><Relationship Id="rId4" Type="http://schemas.openxmlformats.org/officeDocument/2006/relationships/image" Target="../media/image9.jpeg"/><Relationship Id="rId9" Type="http://schemas.openxmlformats.org/officeDocument/2006/relationships/image" Target="../media/image12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microsoft.com/office/2007/relationships/hdphoto" Target="../media/hdphoto8.wdp"/><Relationship Id="rId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0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5141E8DF-2C2F-074D-A9FF-59B4B5039521}"/>
              </a:ext>
            </a:extLst>
          </p:cNvPr>
          <p:cNvSpPr txBox="1"/>
          <p:nvPr/>
        </p:nvSpPr>
        <p:spPr>
          <a:xfrm>
            <a:off x="4459059" y="3019458"/>
            <a:ext cx="1349408" cy="32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54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AP </a:t>
            </a:r>
            <a:r>
              <a:rPr lang="en-US" sz="154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US" sz="154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93A1582-9639-AE48-8523-6565EB8C82B8}"/>
              </a:ext>
            </a:extLst>
          </p:cNvPr>
          <p:cNvSpPr txBox="1"/>
          <p:nvPr/>
        </p:nvSpPr>
        <p:spPr>
          <a:xfrm>
            <a:off x="5656820" y="9753701"/>
            <a:ext cx="1984839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Rajbhandari Figure S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EFA50D8-B6D4-C540-A85A-199460F4BA3F}"/>
              </a:ext>
            </a:extLst>
          </p:cNvPr>
          <p:cNvSpPr txBox="1"/>
          <p:nvPr/>
        </p:nvSpPr>
        <p:spPr>
          <a:xfrm>
            <a:off x="4023126" y="2869626"/>
            <a:ext cx="38985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E6B29FE-292E-C242-9AF6-010F8CB6BE88}"/>
              </a:ext>
            </a:extLst>
          </p:cNvPr>
          <p:cNvSpPr txBox="1"/>
          <p:nvPr/>
        </p:nvSpPr>
        <p:spPr>
          <a:xfrm>
            <a:off x="125629" y="168439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4" name="TextBox 8">
            <a:extLst>
              <a:ext uri="{FF2B5EF4-FFF2-40B4-BE49-F238E27FC236}">
                <a16:creationId xmlns:a16="http://schemas.microsoft.com/office/drawing/2014/main" id="{A24F33DB-9A92-184E-AFA4-675F340CB1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386" y="3197010"/>
            <a:ext cx="665860" cy="227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880" dirty="0">
                <a:solidFill>
                  <a:schemeClr val="bg1"/>
                </a:solidFill>
                <a:latin typeface="Arial" charset="0"/>
              </a:rPr>
              <a:t>BMA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EE2B0FF-0CAC-574D-83BF-23D951E2A85D}"/>
              </a:ext>
            </a:extLst>
          </p:cNvPr>
          <p:cNvSpPr txBox="1"/>
          <p:nvPr/>
        </p:nvSpPr>
        <p:spPr>
          <a:xfrm>
            <a:off x="82722" y="2869626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90737F4-3EA0-CB47-8FE8-1BF8D833101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9115" r="69167" b="2339"/>
          <a:stretch/>
        </p:blipFill>
        <p:spPr>
          <a:xfrm flipH="1">
            <a:off x="4360224" y="3300396"/>
            <a:ext cx="1557062" cy="2384441"/>
          </a:xfrm>
          <a:prstGeom prst="rect">
            <a:avLst/>
          </a:prstGeom>
          <a:ln>
            <a:solidFill>
              <a:schemeClr val="bg1"/>
            </a:solidFill>
          </a:ln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DF56710-71BF-A24D-B782-6420B43E7487}"/>
              </a:ext>
            </a:extLst>
          </p:cNvPr>
          <p:cNvCxnSpPr>
            <a:cxnSpLocks/>
          </p:cNvCxnSpPr>
          <p:nvPr/>
        </p:nvCxnSpPr>
        <p:spPr>
          <a:xfrm flipH="1">
            <a:off x="6030587" y="4665861"/>
            <a:ext cx="304635" cy="220014"/>
          </a:xfrm>
          <a:prstGeom prst="straightConnector1">
            <a:avLst/>
          </a:prstGeom>
          <a:ln w="50800">
            <a:solidFill>
              <a:schemeClr val="accent6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oup 15">
            <a:extLst>
              <a:ext uri="{FF2B5EF4-FFF2-40B4-BE49-F238E27FC236}">
                <a16:creationId xmlns:a16="http://schemas.microsoft.com/office/drawing/2014/main" id="{25707DB3-DD5B-AC46-AE8C-F13C8A6EB85A}"/>
              </a:ext>
            </a:extLst>
          </p:cNvPr>
          <p:cNvGrpSpPr/>
          <p:nvPr/>
        </p:nvGrpSpPr>
        <p:grpSpPr>
          <a:xfrm flipH="1">
            <a:off x="5944988" y="3275891"/>
            <a:ext cx="1604702" cy="2413435"/>
            <a:chOff x="5410200" y="1719487"/>
            <a:chExt cx="3009900" cy="4118193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B715784-B643-B840-8493-82C8532511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4038" t="15614"/>
            <a:stretch/>
          </p:blipFill>
          <p:spPr>
            <a:xfrm>
              <a:off x="5410200" y="1719487"/>
              <a:ext cx="3009900" cy="411819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12213609-61B3-034F-8ED6-9363DC2D23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923" t="55328" r="75962" b="30619"/>
            <a:stretch/>
          </p:blipFill>
          <p:spPr>
            <a:xfrm flipH="1">
              <a:off x="5516448" y="5064300"/>
              <a:ext cx="827898" cy="685800"/>
            </a:xfrm>
            <a:prstGeom prst="rect">
              <a:avLst/>
            </a:prstGeom>
            <a:ln>
              <a:noFill/>
            </a:ln>
          </p:spPr>
        </p:pic>
      </p:grp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792D9F06-CA5F-AD40-B9EA-5B16DFBCBBA5}"/>
              </a:ext>
            </a:extLst>
          </p:cNvPr>
          <p:cNvCxnSpPr>
            <a:cxnSpLocks/>
          </p:cNvCxnSpPr>
          <p:nvPr/>
        </p:nvCxnSpPr>
        <p:spPr>
          <a:xfrm flipH="1">
            <a:off x="4927364" y="4867549"/>
            <a:ext cx="304635" cy="220014"/>
          </a:xfrm>
          <a:prstGeom prst="straightConnector1">
            <a:avLst/>
          </a:prstGeom>
          <a:ln w="50800">
            <a:solidFill>
              <a:schemeClr val="accent6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9F36D1A7-95BA-254A-B842-F20BEC666445}"/>
              </a:ext>
            </a:extLst>
          </p:cNvPr>
          <p:cNvCxnSpPr>
            <a:cxnSpLocks/>
          </p:cNvCxnSpPr>
          <p:nvPr/>
        </p:nvCxnSpPr>
        <p:spPr>
          <a:xfrm flipH="1">
            <a:off x="6276857" y="5105046"/>
            <a:ext cx="221467" cy="141120"/>
          </a:xfrm>
          <a:prstGeom prst="straightConnector1">
            <a:avLst/>
          </a:prstGeom>
          <a:ln w="50800">
            <a:solidFill>
              <a:schemeClr val="accent6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89AB610-1BA7-BE45-9B57-F3EBC3BF37C9}"/>
              </a:ext>
            </a:extLst>
          </p:cNvPr>
          <p:cNvSpPr txBox="1"/>
          <p:nvPr/>
        </p:nvSpPr>
        <p:spPr>
          <a:xfrm flipH="1">
            <a:off x="4719315" y="5029200"/>
            <a:ext cx="609637" cy="227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42636A-0467-6746-8B68-CD172B315854}"/>
              </a:ext>
            </a:extLst>
          </p:cNvPr>
          <p:cNvSpPr txBox="1"/>
          <p:nvPr/>
        </p:nvSpPr>
        <p:spPr>
          <a:xfrm flipH="1">
            <a:off x="6166362" y="5296232"/>
            <a:ext cx="677250" cy="227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A</a:t>
            </a:r>
          </a:p>
        </p:txBody>
      </p:sp>
      <p:sp>
        <p:nvSpPr>
          <p:cNvPr id="24" name="Freeform 23">
            <a:extLst>
              <a:ext uri="{FF2B5EF4-FFF2-40B4-BE49-F238E27FC236}">
                <a16:creationId xmlns:a16="http://schemas.microsoft.com/office/drawing/2014/main" id="{CD9AE4CB-6E94-CC4D-9ACC-7F22B4372CFD}"/>
              </a:ext>
            </a:extLst>
          </p:cNvPr>
          <p:cNvSpPr/>
          <p:nvPr/>
        </p:nvSpPr>
        <p:spPr>
          <a:xfrm>
            <a:off x="4683692" y="4277710"/>
            <a:ext cx="559055" cy="992448"/>
          </a:xfrm>
          <a:custGeom>
            <a:avLst/>
            <a:gdLst>
              <a:gd name="connsiteX0" fmla="*/ 997894 w 1022356"/>
              <a:gd name="connsiteY0" fmla="*/ 4830 h 1826009"/>
              <a:gd name="connsiteX1" fmla="*/ 1021748 w 1022356"/>
              <a:gd name="connsiteY1" fmla="*/ 251320 h 1826009"/>
              <a:gd name="connsiteX2" fmla="*/ 1013797 w 1022356"/>
              <a:gd name="connsiteY2" fmla="*/ 410346 h 1826009"/>
              <a:gd name="connsiteX3" fmla="*/ 997894 w 1022356"/>
              <a:gd name="connsiteY3" fmla="*/ 640934 h 1826009"/>
              <a:gd name="connsiteX4" fmla="*/ 958138 w 1022356"/>
              <a:gd name="connsiteY4" fmla="*/ 815863 h 1826009"/>
              <a:gd name="connsiteX5" fmla="*/ 950187 w 1022356"/>
              <a:gd name="connsiteY5" fmla="*/ 943083 h 1826009"/>
              <a:gd name="connsiteX6" fmla="*/ 926333 w 1022356"/>
              <a:gd name="connsiteY6" fmla="*/ 1157769 h 1826009"/>
              <a:gd name="connsiteX7" fmla="*/ 926333 w 1022356"/>
              <a:gd name="connsiteY7" fmla="*/ 1277038 h 1826009"/>
              <a:gd name="connsiteX8" fmla="*/ 775258 w 1022356"/>
              <a:gd name="connsiteY8" fmla="*/ 1595090 h 1826009"/>
              <a:gd name="connsiteX9" fmla="*/ 719599 w 1022356"/>
              <a:gd name="connsiteY9" fmla="*/ 1706409 h 1826009"/>
              <a:gd name="connsiteX10" fmla="*/ 608280 w 1022356"/>
              <a:gd name="connsiteY10" fmla="*/ 1809776 h 1826009"/>
              <a:gd name="connsiteX11" fmla="*/ 401547 w 1022356"/>
              <a:gd name="connsiteY11" fmla="*/ 1817727 h 1826009"/>
              <a:gd name="connsiteX12" fmla="*/ 274326 w 1022356"/>
              <a:gd name="connsiteY12" fmla="*/ 1730263 h 1826009"/>
              <a:gd name="connsiteX13" fmla="*/ 51689 w 1022356"/>
              <a:gd name="connsiteY13" fmla="*/ 1459918 h 1826009"/>
              <a:gd name="connsiteX14" fmla="*/ 3981 w 1022356"/>
              <a:gd name="connsiteY14" fmla="*/ 1292941 h 1826009"/>
              <a:gd name="connsiteX15" fmla="*/ 123251 w 1022356"/>
              <a:gd name="connsiteY15" fmla="*/ 1173671 h 1826009"/>
              <a:gd name="connsiteX16" fmla="*/ 202764 w 1022356"/>
              <a:gd name="connsiteY16" fmla="*/ 998743 h 1826009"/>
              <a:gd name="connsiteX17" fmla="*/ 385644 w 1022356"/>
              <a:gd name="connsiteY17" fmla="*/ 847668 h 1826009"/>
              <a:gd name="connsiteX18" fmla="*/ 489011 w 1022356"/>
              <a:gd name="connsiteY18" fmla="*/ 760203 h 1826009"/>
              <a:gd name="connsiteX19" fmla="*/ 489011 w 1022356"/>
              <a:gd name="connsiteY19" fmla="*/ 680690 h 1826009"/>
              <a:gd name="connsiteX20" fmla="*/ 608280 w 1022356"/>
              <a:gd name="connsiteY20" fmla="*/ 569372 h 1826009"/>
              <a:gd name="connsiteX21" fmla="*/ 640086 w 1022356"/>
              <a:gd name="connsiteY21" fmla="*/ 489859 h 1826009"/>
              <a:gd name="connsiteX22" fmla="*/ 719599 w 1022356"/>
              <a:gd name="connsiteY22" fmla="*/ 378541 h 1826009"/>
              <a:gd name="connsiteX23" fmla="*/ 822966 w 1022356"/>
              <a:gd name="connsiteY23" fmla="*/ 243369 h 1826009"/>
              <a:gd name="connsiteX24" fmla="*/ 870673 w 1022356"/>
              <a:gd name="connsiteY24" fmla="*/ 147953 h 1826009"/>
              <a:gd name="connsiteX25" fmla="*/ 902479 w 1022356"/>
              <a:gd name="connsiteY25" fmla="*/ 92294 h 1826009"/>
              <a:gd name="connsiteX26" fmla="*/ 997894 w 1022356"/>
              <a:gd name="connsiteY26" fmla="*/ 4830 h 18260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</a:cxnLst>
            <a:rect l="l" t="t" r="r" b="b"/>
            <a:pathLst>
              <a:path w="1022356" h="1826009">
                <a:moveTo>
                  <a:pt x="997894" y="4830"/>
                </a:moveTo>
                <a:cubicBezTo>
                  <a:pt x="1017772" y="31334"/>
                  <a:pt x="1019098" y="183734"/>
                  <a:pt x="1021748" y="251320"/>
                </a:cubicBezTo>
                <a:cubicBezTo>
                  <a:pt x="1024399" y="318906"/>
                  <a:pt x="1017773" y="345410"/>
                  <a:pt x="1013797" y="410346"/>
                </a:cubicBezTo>
                <a:cubicBezTo>
                  <a:pt x="1009821" y="475282"/>
                  <a:pt x="1007170" y="573348"/>
                  <a:pt x="997894" y="640934"/>
                </a:cubicBezTo>
                <a:cubicBezTo>
                  <a:pt x="988618" y="708520"/>
                  <a:pt x="966089" y="765505"/>
                  <a:pt x="958138" y="815863"/>
                </a:cubicBezTo>
                <a:cubicBezTo>
                  <a:pt x="950187" y="866221"/>
                  <a:pt x="955488" y="886099"/>
                  <a:pt x="950187" y="943083"/>
                </a:cubicBezTo>
                <a:cubicBezTo>
                  <a:pt x="944886" y="1000067"/>
                  <a:pt x="930309" y="1102110"/>
                  <a:pt x="926333" y="1157769"/>
                </a:cubicBezTo>
                <a:cubicBezTo>
                  <a:pt x="922357" y="1213428"/>
                  <a:pt x="951512" y="1204151"/>
                  <a:pt x="926333" y="1277038"/>
                </a:cubicBezTo>
                <a:cubicBezTo>
                  <a:pt x="901154" y="1349925"/>
                  <a:pt x="809714" y="1523528"/>
                  <a:pt x="775258" y="1595090"/>
                </a:cubicBezTo>
                <a:cubicBezTo>
                  <a:pt x="740802" y="1666652"/>
                  <a:pt x="747429" y="1670628"/>
                  <a:pt x="719599" y="1706409"/>
                </a:cubicBezTo>
                <a:cubicBezTo>
                  <a:pt x="691769" y="1742190"/>
                  <a:pt x="661289" y="1791223"/>
                  <a:pt x="608280" y="1809776"/>
                </a:cubicBezTo>
                <a:cubicBezTo>
                  <a:pt x="555271" y="1828329"/>
                  <a:pt x="457206" y="1830979"/>
                  <a:pt x="401547" y="1817727"/>
                </a:cubicBezTo>
                <a:cubicBezTo>
                  <a:pt x="345888" y="1804475"/>
                  <a:pt x="332636" y="1789898"/>
                  <a:pt x="274326" y="1730263"/>
                </a:cubicBezTo>
                <a:cubicBezTo>
                  <a:pt x="216016" y="1670628"/>
                  <a:pt x="96746" y="1532805"/>
                  <a:pt x="51689" y="1459918"/>
                </a:cubicBezTo>
                <a:cubicBezTo>
                  <a:pt x="6632" y="1387031"/>
                  <a:pt x="-7946" y="1340649"/>
                  <a:pt x="3981" y="1292941"/>
                </a:cubicBezTo>
                <a:cubicBezTo>
                  <a:pt x="15908" y="1245233"/>
                  <a:pt x="90120" y="1222704"/>
                  <a:pt x="123251" y="1173671"/>
                </a:cubicBezTo>
                <a:cubicBezTo>
                  <a:pt x="156382" y="1124638"/>
                  <a:pt x="159032" y="1053077"/>
                  <a:pt x="202764" y="998743"/>
                </a:cubicBezTo>
                <a:cubicBezTo>
                  <a:pt x="246496" y="944409"/>
                  <a:pt x="337936" y="887425"/>
                  <a:pt x="385644" y="847668"/>
                </a:cubicBezTo>
                <a:cubicBezTo>
                  <a:pt x="433352" y="807911"/>
                  <a:pt x="471783" y="788033"/>
                  <a:pt x="489011" y="760203"/>
                </a:cubicBezTo>
                <a:cubicBezTo>
                  <a:pt x="506239" y="732373"/>
                  <a:pt x="469133" y="712495"/>
                  <a:pt x="489011" y="680690"/>
                </a:cubicBezTo>
                <a:cubicBezTo>
                  <a:pt x="508889" y="648885"/>
                  <a:pt x="583101" y="601177"/>
                  <a:pt x="608280" y="569372"/>
                </a:cubicBezTo>
                <a:cubicBezTo>
                  <a:pt x="633459" y="537567"/>
                  <a:pt x="621533" y="521664"/>
                  <a:pt x="640086" y="489859"/>
                </a:cubicBezTo>
                <a:cubicBezTo>
                  <a:pt x="658639" y="458054"/>
                  <a:pt x="689119" y="419623"/>
                  <a:pt x="719599" y="378541"/>
                </a:cubicBezTo>
                <a:cubicBezTo>
                  <a:pt x="750079" y="337459"/>
                  <a:pt x="797787" y="281800"/>
                  <a:pt x="822966" y="243369"/>
                </a:cubicBezTo>
                <a:cubicBezTo>
                  <a:pt x="848145" y="204938"/>
                  <a:pt x="857421" y="173132"/>
                  <a:pt x="870673" y="147953"/>
                </a:cubicBezTo>
                <a:cubicBezTo>
                  <a:pt x="883925" y="122774"/>
                  <a:pt x="885251" y="116148"/>
                  <a:pt x="902479" y="92294"/>
                </a:cubicBezTo>
                <a:cubicBezTo>
                  <a:pt x="919707" y="68440"/>
                  <a:pt x="978016" y="-21674"/>
                  <a:pt x="997894" y="4830"/>
                </a:cubicBezTo>
                <a:close/>
              </a:path>
            </a:pathLst>
          </a:custGeom>
          <a:noFill/>
          <a:ln w="127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14"/>
          </a:p>
        </p:txBody>
      </p:sp>
      <p:sp>
        <p:nvSpPr>
          <p:cNvPr id="25" name="Freeform 24">
            <a:extLst>
              <a:ext uri="{FF2B5EF4-FFF2-40B4-BE49-F238E27FC236}">
                <a16:creationId xmlns:a16="http://schemas.microsoft.com/office/drawing/2014/main" id="{43F98B23-F724-B94D-9E3A-1CEFDA108F5C}"/>
              </a:ext>
            </a:extLst>
          </p:cNvPr>
          <p:cNvSpPr/>
          <p:nvPr/>
        </p:nvSpPr>
        <p:spPr>
          <a:xfrm>
            <a:off x="4772962" y="4885875"/>
            <a:ext cx="362766" cy="217817"/>
          </a:xfrm>
          <a:custGeom>
            <a:avLst/>
            <a:gdLst>
              <a:gd name="connsiteX0" fmla="*/ 0 w 675861"/>
              <a:gd name="connsiteY0" fmla="*/ 0 h 405810"/>
              <a:gd name="connsiteX1" fmla="*/ 159026 w 675861"/>
              <a:gd name="connsiteY1" fmla="*/ 127221 h 405810"/>
              <a:gd name="connsiteX2" fmla="*/ 365760 w 675861"/>
              <a:gd name="connsiteY2" fmla="*/ 286247 h 405810"/>
              <a:gd name="connsiteX3" fmla="*/ 588396 w 675861"/>
              <a:gd name="connsiteY3" fmla="*/ 397565 h 405810"/>
              <a:gd name="connsiteX4" fmla="*/ 675861 w 675861"/>
              <a:gd name="connsiteY4" fmla="*/ 397565 h 4058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75861" h="405810">
                <a:moveTo>
                  <a:pt x="0" y="0"/>
                </a:moveTo>
                <a:cubicBezTo>
                  <a:pt x="49033" y="39756"/>
                  <a:pt x="98066" y="79513"/>
                  <a:pt x="159026" y="127221"/>
                </a:cubicBezTo>
                <a:cubicBezTo>
                  <a:pt x="219986" y="174929"/>
                  <a:pt x="294198" y="241190"/>
                  <a:pt x="365760" y="286247"/>
                </a:cubicBezTo>
                <a:cubicBezTo>
                  <a:pt x="437322" y="331304"/>
                  <a:pt x="536713" y="379012"/>
                  <a:pt x="588396" y="397565"/>
                </a:cubicBezTo>
                <a:cubicBezTo>
                  <a:pt x="640079" y="416118"/>
                  <a:pt x="675861" y="397565"/>
                  <a:pt x="675861" y="397565"/>
                </a:cubicBezTo>
              </a:path>
            </a:pathLst>
          </a:custGeom>
          <a:noFill/>
          <a:ln w="1587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14"/>
          </a:p>
        </p:txBody>
      </p:sp>
      <p:sp>
        <p:nvSpPr>
          <p:cNvPr id="26" name="Freeform 25">
            <a:extLst>
              <a:ext uri="{FF2B5EF4-FFF2-40B4-BE49-F238E27FC236}">
                <a16:creationId xmlns:a16="http://schemas.microsoft.com/office/drawing/2014/main" id="{C040C6AF-9E4D-5245-913C-E08307B91702}"/>
              </a:ext>
            </a:extLst>
          </p:cNvPr>
          <p:cNvSpPr/>
          <p:nvPr/>
        </p:nvSpPr>
        <p:spPr>
          <a:xfrm rot="561374">
            <a:off x="6306779" y="4271371"/>
            <a:ext cx="558815" cy="974438"/>
          </a:xfrm>
          <a:custGeom>
            <a:avLst/>
            <a:gdLst>
              <a:gd name="connsiteX0" fmla="*/ 997894 w 1022356"/>
              <a:gd name="connsiteY0" fmla="*/ 4830 h 1826009"/>
              <a:gd name="connsiteX1" fmla="*/ 1021748 w 1022356"/>
              <a:gd name="connsiteY1" fmla="*/ 251320 h 1826009"/>
              <a:gd name="connsiteX2" fmla="*/ 1013797 w 1022356"/>
              <a:gd name="connsiteY2" fmla="*/ 410346 h 1826009"/>
              <a:gd name="connsiteX3" fmla="*/ 997894 w 1022356"/>
              <a:gd name="connsiteY3" fmla="*/ 640934 h 1826009"/>
              <a:gd name="connsiteX4" fmla="*/ 958138 w 1022356"/>
              <a:gd name="connsiteY4" fmla="*/ 815863 h 1826009"/>
              <a:gd name="connsiteX5" fmla="*/ 950187 w 1022356"/>
              <a:gd name="connsiteY5" fmla="*/ 943083 h 1826009"/>
              <a:gd name="connsiteX6" fmla="*/ 926333 w 1022356"/>
              <a:gd name="connsiteY6" fmla="*/ 1157769 h 1826009"/>
              <a:gd name="connsiteX7" fmla="*/ 926333 w 1022356"/>
              <a:gd name="connsiteY7" fmla="*/ 1277038 h 1826009"/>
              <a:gd name="connsiteX8" fmla="*/ 775258 w 1022356"/>
              <a:gd name="connsiteY8" fmla="*/ 1595090 h 1826009"/>
              <a:gd name="connsiteX9" fmla="*/ 719599 w 1022356"/>
              <a:gd name="connsiteY9" fmla="*/ 1706409 h 1826009"/>
              <a:gd name="connsiteX10" fmla="*/ 608280 w 1022356"/>
              <a:gd name="connsiteY10" fmla="*/ 1809776 h 1826009"/>
              <a:gd name="connsiteX11" fmla="*/ 401547 w 1022356"/>
              <a:gd name="connsiteY11" fmla="*/ 1817727 h 1826009"/>
              <a:gd name="connsiteX12" fmla="*/ 274326 w 1022356"/>
              <a:gd name="connsiteY12" fmla="*/ 1730263 h 1826009"/>
              <a:gd name="connsiteX13" fmla="*/ 51689 w 1022356"/>
              <a:gd name="connsiteY13" fmla="*/ 1459918 h 1826009"/>
              <a:gd name="connsiteX14" fmla="*/ 3981 w 1022356"/>
              <a:gd name="connsiteY14" fmla="*/ 1292941 h 1826009"/>
              <a:gd name="connsiteX15" fmla="*/ 123251 w 1022356"/>
              <a:gd name="connsiteY15" fmla="*/ 1173671 h 1826009"/>
              <a:gd name="connsiteX16" fmla="*/ 202764 w 1022356"/>
              <a:gd name="connsiteY16" fmla="*/ 998743 h 1826009"/>
              <a:gd name="connsiteX17" fmla="*/ 385644 w 1022356"/>
              <a:gd name="connsiteY17" fmla="*/ 847668 h 1826009"/>
              <a:gd name="connsiteX18" fmla="*/ 489011 w 1022356"/>
              <a:gd name="connsiteY18" fmla="*/ 760203 h 1826009"/>
              <a:gd name="connsiteX19" fmla="*/ 489011 w 1022356"/>
              <a:gd name="connsiteY19" fmla="*/ 680690 h 1826009"/>
              <a:gd name="connsiteX20" fmla="*/ 608280 w 1022356"/>
              <a:gd name="connsiteY20" fmla="*/ 569372 h 1826009"/>
              <a:gd name="connsiteX21" fmla="*/ 640086 w 1022356"/>
              <a:gd name="connsiteY21" fmla="*/ 489859 h 1826009"/>
              <a:gd name="connsiteX22" fmla="*/ 719599 w 1022356"/>
              <a:gd name="connsiteY22" fmla="*/ 378541 h 1826009"/>
              <a:gd name="connsiteX23" fmla="*/ 822966 w 1022356"/>
              <a:gd name="connsiteY23" fmla="*/ 243369 h 1826009"/>
              <a:gd name="connsiteX24" fmla="*/ 870673 w 1022356"/>
              <a:gd name="connsiteY24" fmla="*/ 147953 h 1826009"/>
              <a:gd name="connsiteX25" fmla="*/ 902479 w 1022356"/>
              <a:gd name="connsiteY25" fmla="*/ 92294 h 1826009"/>
              <a:gd name="connsiteX26" fmla="*/ 997894 w 1022356"/>
              <a:gd name="connsiteY26" fmla="*/ 4830 h 182600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</a:cxnLst>
            <a:rect l="l" t="t" r="r" b="b"/>
            <a:pathLst>
              <a:path w="1022356" h="1826009">
                <a:moveTo>
                  <a:pt x="997894" y="4830"/>
                </a:moveTo>
                <a:cubicBezTo>
                  <a:pt x="1017772" y="31334"/>
                  <a:pt x="1019098" y="183734"/>
                  <a:pt x="1021748" y="251320"/>
                </a:cubicBezTo>
                <a:cubicBezTo>
                  <a:pt x="1024399" y="318906"/>
                  <a:pt x="1017773" y="345410"/>
                  <a:pt x="1013797" y="410346"/>
                </a:cubicBezTo>
                <a:cubicBezTo>
                  <a:pt x="1009821" y="475282"/>
                  <a:pt x="1007170" y="573348"/>
                  <a:pt x="997894" y="640934"/>
                </a:cubicBezTo>
                <a:cubicBezTo>
                  <a:pt x="988618" y="708520"/>
                  <a:pt x="966089" y="765505"/>
                  <a:pt x="958138" y="815863"/>
                </a:cubicBezTo>
                <a:cubicBezTo>
                  <a:pt x="950187" y="866221"/>
                  <a:pt x="955488" y="886099"/>
                  <a:pt x="950187" y="943083"/>
                </a:cubicBezTo>
                <a:cubicBezTo>
                  <a:pt x="944886" y="1000067"/>
                  <a:pt x="930309" y="1102110"/>
                  <a:pt x="926333" y="1157769"/>
                </a:cubicBezTo>
                <a:cubicBezTo>
                  <a:pt x="922357" y="1213428"/>
                  <a:pt x="951512" y="1204151"/>
                  <a:pt x="926333" y="1277038"/>
                </a:cubicBezTo>
                <a:cubicBezTo>
                  <a:pt x="901154" y="1349925"/>
                  <a:pt x="809714" y="1523528"/>
                  <a:pt x="775258" y="1595090"/>
                </a:cubicBezTo>
                <a:cubicBezTo>
                  <a:pt x="740802" y="1666652"/>
                  <a:pt x="747429" y="1670628"/>
                  <a:pt x="719599" y="1706409"/>
                </a:cubicBezTo>
                <a:cubicBezTo>
                  <a:pt x="691769" y="1742190"/>
                  <a:pt x="661289" y="1791223"/>
                  <a:pt x="608280" y="1809776"/>
                </a:cubicBezTo>
                <a:cubicBezTo>
                  <a:pt x="555271" y="1828329"/>
                  <a:pt x="457206" y="1830979"/>
                  <a:pt x="401547" y="1817727"/>
                </a:cubicBezTo>
                <a:cubicBezTo>
                  <a:pt x="345888" y="1804475"/>
                  <a:pt x="332636" y="1789898"/>
                  <a:pt x="274326" y="1730263"/>
                </a:cubicBezTo>
                <a:cubicBezTo>
                  <a:pt x="216016" y="1670628"/>
                  <a:pt x="96746" y="1532805"/>
                  <a:pt x="51689" y="1459918"/>
                </a:cubicBezTo>
                <a:cubicBezTo>
                  <a:pt x="6632" y="1387031"/>
                  <a:pt x="-7946" y="1340649"/>
                  <a:pt x="3981" y="1292941"/>
                </a:cubicBezTo>
                <a:cubicBezTo>
                  <a:pt x="15908" y="1245233"/>
                  <a:pt x="90120" y="1222704"/>
                  <a:pt x="123251" y="1173671"/>
                </a:cubicBezTo>
                <a:cubicBezTo>
                  <a:pt x="156382" y="1124638"/>
                  <a:pt x="159032" y="1053077"/>
                  <a:pt x="202764" y="998743"/>
                </a:cubicBezTo>
                <a:cubicBezTo>
                  <a:pt x="246496" y="944409"/>
                  <a:pt x="337936" y="887425"/>
                  <a:pt x="385644" y="847668"/>
                </a:cubicBezTo>
                <a:cubicBezTo>
                  <a:pt x="433352" y="807911"/>
                  <a:pt x="471783" y="788033"/>
                  <a:pt x="489011" y="760203"/>
                </a:cubicBezTo>
                <a:cubicBezTo>
                  <a:pt x="506239" y="732373"/>
                  <a:pt x="469133" y="712495"/>
                  <a:pt x="489011" y="680690"/>
                </a:cubicBezTo>
                <a:cubicBezTo>
                  <a:pt x="508889" y="648885"/>
                  <a:pt x="583101" y="601177"/>
                  <a:pt x="608280" y="569372"/>
                </a:cubicBezTo>
                <a:cubicBezTo>
                  <a:pt x="633459" y="537567"/>
                  <a:pt x="621533" y="521664"/>
                  <a:pt x="640086" y="489859"/>
                </a:cubicBezTo>
                <a:cubicBezTo>
                  <a:pt x="658639" y="458054"/>
                  <a:pt x="689119" y="419623"/>
                  <a:pt x="719599" y="378541"/>
                </a:cubicBezTo>
                <a:cubicBezTo>
                  <a:pt x="750079" y="337459"/>
                  <a:pt x="797787" y="281800"/>
                  <a:pt x="822966" y="243369"/>
                </a:cubicBezTo>
                <a:cubicBezTo>
                  <a:pt x="848145" y="204938"/>
                  <a:pt x="857421" y="173132"/>
                  <a:pt x="870673" y="147953"/>
                </a:cubicBezTo>
                <a:cubicBezTo>
                  <a:pt x="883925" y="122774"/>
                  <a:pt x="885251" y="116148"/>
                  <a:pt x="902479" y="92294"/>
                </a:cubicBezTo>
                <a:cubicBezTo>
                  <a:pt x="919707" y="68440"/>
                  <a:pt x="978016" y="-21674"/>
                  <a:pt x="997894" y="4830"/>
                </a:cubicBezTo>
                <a:close/>
              </a:path>
            </a:pathLst>
          </a:custGeom>
          <a:noFill/>
          <a:ln w="127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14"/>
          </a:p>
        </p:txBody>
      </p:sp>
      <p:sp>
        <p:nvSpPr>
          <p:cNvPr id="27" name="Freeform 26">
            <a:extLst>
              <a:ext uri="{FF2B5EF4-FFF2-40B4-BE49-F238E27FC236}">
                <a16:creationId xmlns:a16="http://schemas.microsoft.com/office/drawing/2014/main" id="{1637F947-C802-DE4E-8730-64481D3BB677}"/>
              </a:ext>
            </a:extLst>
          </p:cNvPr>
          <p:cNvSpPr/>
          <p:nvPr/>
        </p:nvSpPr>
        <p:spPr>
          <a:xfrm>
            <a:off x="6024493" y="5087563"/>
            <a:ext cx="479581" cy="461159"/>
          </a:xfrm>
          <a:custGeom>
            <a:avLst/>
            <a:gdLst>
              <a:gd name="connsiteX0" fmla="*/ 424372 w 893499"/>
              <a:gd name="connsiteY0" fmla="*/ 0 h 859176"/>
              <a:gd name="connsiteX1" fmla="*/ 265346 w 893499"/>
              <a:gd name="connsiteY1" fmla="*/ 135172 h 859176"/>
              <a:gd name="connsiteX2" fmla="*/ 66563 w 893499"/>
              <a:gd name="connsiteY2" fmla="*/ 349857 h 859176"/>
              <a:gd name="connsiteX3" fmla="*/ 2953 w 893499"/>
              <a:gd name="connsiteY3" fmla="*/ 524786 h 859176"/>
              <a:gd name="connsiteX4" fmla="*/ 146076 w 893499"/>
              <a:gd name="connsiteY4" fmla="*/ 763325 h 859176"/>
              <a:gd name="connsiteX5" fmla="*/ 321005 w 893499"/>
              <a:gd name="connsiteY5" fmla="*/ 826936 h 859176"/>
              <a:gd name="connsiteX6" fmla="*/ 583398 w 893499"/>
              <a:gd name="connsiteY6" fmla="*/ 850790 h 859176"/>
              <a:gd name="connsiteX7" fmla="*/ 742424 w 893499"/>
              <a:gd name="connsiteY7" fmla="*/ 683812 h 859176"/>
              <a:gd name="connsiteX8" fmla="*/ 845791 w 893499"/>
              <a:gd name="connsiteY8" fmla="*/ 508883 h 859176"/>
              <a:gd name="connsiteX9" fmla="*/ 893499 w 893499"/>
              <a:gd name="connsiteY9" fmla="*/ 294198 h 8591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893499" h="859176">
                <a:moveTo>
                  <a:pt x="424372" y="0"/>
                </a:moveTo>
                <a:cubicBezTo>
                  <a:pt x="374676" y="38431"/>
                  <a:pt x="324981" y="76863"/>
                  <a:pt x="265346" y="135172"/>
                </a:cubicBezTo>
                <a:cubicBezTo>
                  <a:pt x="205711" y="193482"/>
                  <a:pt x="110295" y="284921"/>
                  <a:pt x="66563" y="349857"/>
                </a:cubicBezTo>
                <a:cubicBezTo>
                  <a:pt x="22831" y="414793"/>
                  <a:pt x="-10299" y="455875"/>
                  <a:pt x="2953" y="524786"/>
                </a:cubicBezTo>
                <a:cubicBezTo>
                  <a:pt x="16205" y="593697"/>
                  <a:pt x="93067" y="712967"/>
                  <a:pt x="146076" y="763325"/>
                </a:cubicBezTo>
                <a:cubicBezTo>
                  <a:pt x="199085" y="813683"/>
                  <a:pt x="248118" y="812359"/>
                  <a:pt x="321005" y="826936"/>
                </a:cubicBezTo>
                <a:cubicBezTo>
                  <a:pt x="393892" y="841513"/>
                  <a:pt x="513162" y="874644"/>
                  <a:pt x="583398" y="850790"/>
                </a:cubicBezTo>
                <a:cubicBezTo>
                  <a:pt x="653634" y="826936"/>
                  <a:pt x="698692" y="740796"/>
                  <a:pt x="742424" y="683812"/>
                </a:cubicBezTo>
                <a:cubicBezTo>
                  <a:pt x="786156" y="626828"/>
                  <a:pt x="820612" y="573819"/>
                  <a:pt x="845791" y="508883"/>
                </a:cubicBezTo>
                <a:cubicBezTo>
                  <a:pt x="870970" y="443947"/>
                  <a:pt x="893499" y="294198"/>
                  <a:pt x="893499" y="294198"/>
                </a:cubicBezTo>
              </a:path>
            </a:pathLst>
          </a:custGeom>
          <a:noFill/>
          <a:ln w="1270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14"/>
          </a:p>
        </p:txBody>
      </p: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078C0D89-1255-5748-BAF0-6D7E2861FC7D}"/>
              </a:ext>
            </a:extLst>
          </p:cNvPr>
          <p:cNvCxnSpPr>
            <a:cxnSpLocks/>
          </p:cNvCxnSpPr>
          <p:nvPr/>
        </p:nvCxnSpPr>
        <p:spPr>
          <a:xfrm>
            <a:off x="6578635" y="4232429"/>
            <a:ext cx="63787" cy="225055"/>
          </a:xfrm>
          <a:prstGeom prst="straightConnector1">
            <a:avLst/>
          </a:prstGeom>
          <a:ln w="50800">
            <a:solidFill>
              <a:schemeClr val="accent6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BFEFC999-1B22-6A41-ADB6-84B93D3EE188}"/>
              </a:ext>
            </a:extLst>
          </p:cNvPr>
          <p:cNvSpPr txBox="1"/>
          <p:nvPr/>
        </p:nvSpPr>
        <p:spPr>
          <a:xfrm>
            <a:off x="666063" y="3486492"/>
            <a:ext cx="1349408" cy="32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AP </a:t>
            </a:r>
            <a:r>
              <a:rPr lang="en-US" sz="154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pic>
        <p:nvPicPr>
          <p:cNvPr id="90" name="Picture 4">
            <a:extLst>
              <a:ext uri="{FF2B5EF4-FFF2-40B4-BE49-F238E27FC236}">
                <a16:creationId xmlns:a16="http://schemas.microsoft.com/office/drawing/2014/main" id="{3A91B22F-066F-1246-A0D4-F18CF8E69770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4523" r="28448" b="-417"/>
          <a:stretch>
            <a:fillRect/>
          </a:stretch>
        </p:blipFill>
        <p:spPr bwMode="auto">
          <a:xfrm>
            <a:off x="510835" y="3760210"/>
            <a:ext cx="1594471" cy="19437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08" name="TextBox 8">
            <a:extLst>
              <a:ext uri="{FF2B5EF4-FFF2-40B4-BE49-F238E27FC236}">
                <a16:creationId xmlns:a16="http://schemas.microsoft.com/office/drawing/2014/main" id="{E737642D-E5C2-5E41-A6D8-1DE331E454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8070" y="5184827"/>
            <a:ext cx="76198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00" dirty="0">
                <a:solidFill>
                  <a:schemeClr val="bg1"/>
                </a:solidFill>
                <a:latin typeface="Arial" charset="0"/>
              </a:rPr>
              <a:t>BMA</a:t>
            </a:r>
          </a:p>
        </p:txBody>
      </p:sp>
      <p:sp>
        <p:nvSpPr>
          <p:cNvPr id="113" name="TextBox 8">
            <a:extLst>
              <a:ext uri="{FF2B5EF4-FFF2-40B4-BE49-F238E27FC236}">
                <a16:creationId xmlns:a16="http://schemas.microsoft.com/office/drawing/2014/main" id="{73B5D01B-C4B0-AE46-B0EA-D60E316F76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1026" y="4091151"/>
            <a:ext cx="76198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00" dirty="0" err="1">
                <a:solidFill>
                  <a:schemeClr val="bg1"/>
                </a:solidFill>
                <a:latin typeface="Arial" charset="0"/>
              </a:rPr>
              <a:t>CeA</a:t>
            </a:r>
            <a:endParaRPr lang="en-US" sz="1100" dirty="0">
              <a:solidFill>
                <a:schemeClr val="bg1"/>
              </a:solidFill>
              <a:latin typeface="Arial" charset="0"/>
            </a:endParaRPr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id="{89BDA9EF-1148-2346-AD1F-FBAEA7A4D861}"/>
              </a:ext>
            </a:extLst>
          </p:cNvPr>
          <p:cNvSpPr/>
          <p:nvPr/>
        </p:nvSpPr>
        <p:spPr>
          <a:xfrm>
            <a:off x="1308070" y="3837411"/>
            <a:ext cx="649100" cy="694609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18" name="Freeform 117">
            <a:extLst>
              <a:ext uri="{FF2B5EF4-FFF2-40B4-BE49-F238E27FC236}">
                <a16:creationId xmlns:a16="http://schemas.microsoft.com/office/drawing/2014/main" id="{458774C2-531F-A24D-8AD5-0E5C349D8B85}"/>
              </a:ext>
            </a:extLst>
          </p:cNvPr>
          <p:cNvSpPr/>
          <p:nvPr/>
        </p:nvSpPr>
        <p:spPr>
          <a:xfrm>
            <a:off x="860147" y="4742593"/>
            <a:ext cx="843464" cy="665092"/>
          </a:xfrm>
          <a:custGeom>
            <a:avLst/>
            <a:gdLst>
              <a:gd name="connsiteX0" fmla="*/ 0 w 573168"/>
              <a:gd name="connsiteY0" fmla="*/ 543339 h 543339"/>
              <a:gd name="connsiteX1" fmla="*/ 198782 w 573168"/>
              <a:gd name="connsiteY1" fmla="*/ 437322 h 543339"/>
              <a:gd name="connsiteX2" fmla="*/ 384313 w 573168"/>
              <a:gd name="connsiteY2" fmla="*/ 318052 h 543339"/>
              <a:gd name="connsiteX3" fmla="*/ 556591 w 573168"/>
              <a:gd name="connsiteY3" fmla="*/ 119270 h 543339"/>
              <a:gd name="connsiteX4" fmla="*/ 556591 w 573168"/>
              <a:gd name="connsiteY4" fmla="*/ 0 h 5433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73168" h="543339">
                <a:moveTo>
                  <a:pt x="0" y="543339"/>
                </a:moveTo>
                <a:cubicBezTo>
                  <a:pt x="67365" y="509104"/>
                  <a:pt x="134730" y="474870"/>
                  <a:pt x="198782" y="437322"/>
                </a:cubicBezTo>
                <a:cubicBezTo>
                  <a:pt x="262834" y="399774"/>
                  <a:pt x="324678" y="371061"/>
                  <a:pt x="384313" y="318052"/>
                </a:cubicBezTo>
                <a:cubicBezTo>
                  <a:pt x="443948" y="265043"/>
                  <a:pt x="527878" y="172279"/>
                  <a:pt x="556591" y="119270"/>
                </a:cubicBezTo>
                <a:cubicBezTo>
                  <a:pt x="585304" y="66261"/>
                  <a:pt x="570947" y="33130"/>
                  <a:pt x="556591" y="0"/>
                </a:cubicBezTo>
              </a:path>
            </a:pathLst>
          </a:cu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grpSp>
        <p:nvGrpSpPr>
          <p:cNvPr id="12" name="Group 11"/>
          <p:cNvGrpSpPr/>
          <p:nvPr/>
        </p:nvGrpSpPr>
        <p:grpSpPr>
          <a:xfrm>
            <a:off x="2135210" y="3514359"/>
            <a:ext cx="1812152" cy="1666169"/>
            <a:chOff x="1837190" y="3253193"/>
            <a:chExt cx="1842454" cy="1694031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0FBE6A09-8BAF-784A-B78D-AC8FE74352FA}"/>
                </a:ext>
              </a:extLst>
            </p:cNvPr>
            <p:cNvSpPr txBox="1"/>
            <p:nvPr/>
          </p:nvSpPr>
          <p:spPr>
            <a:xfrm>
              <a:off x="2094173" y="3253193"/>
              <a:ext cx="1397620" cy="3348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54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AP </a:t>
              </a:r>
              <a:r>
                <a:rPr lang="en-US" sz="154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3176197E-6B8B-AD4E-A2DD-C88E66A630ED}"/>
                </a:ext>
              </a:extLst>
            </p:cNvPr>
            <p:cNvGrpSpPr/>
            <p:nvPr/>
          </p:nvGrpSpPr>
          <p:grpSpPr>
            <a:xfrm>
              <a:off x="1837190" y="3543415"/>
              <a:ext cx="1842454" cy="1403809"/>
              <a:chOff x="2698553" y="3219736"/>
              <a:chExt cx="3994150" cy="3043237"/>
            </a:xfrm>
          </p:grpSpPr>
          <p:pic>
            <p:nvPicPr>
              <p:cNvPr id="99" name="Picture 6">
                <a:extLst>
                  <a:ext uri="{FF2B5EF4-FFF2-40B4-BE49-F238E27FC236}">
                    <a16:creationId xmlns:a16="http://schemas.microsoft.com/office/drawing/2014/main" id="{3A6C23E8-7760-E247-8467-CF6E3AEFF3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screen">
                <a:lum bright="-6000" contrast="4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98553" y="3219736"/>
                <a:ext cx="3994150" cy="3043237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01" name="TextBox 9">
                <a:extLst>
                  <a:ext uri="{FF2B5EF4-FFF2-40B4-BE49-F238E27FC236}">
                    <a16:creationId xmlns:a16="http://schemas.microsoft.com/office/drawing/2014/main" id="{F43510C9-A474-7949-BF7B-332C8BF1005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2308750">
                <a:off x="4600614" y="3491836"/>
                <a:ext cx="1138237" cy="576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charset="0"/>
                    <a:ea typeface="MS PGothic" charset="0"/>
                    <a:cs typeface="MS PGothic" charset="0"/>
                  </a:defRPr>
                </a:lvl9pPr>
              </a:lstStyle>
              <a:p>
                <a:r>
                  <a:rPr lang="en-US" sz="1100" dirty="0">
                    <a:solidFill>
                      <a:schemeClr val="bg1"/>
                    </a:solidFill>
                    <a:latin typeface="Arial" charset="0"/>
                  </a:rPr>
                  <a:t>ICCs</a:t>
                </a:r>
              </a:p>
            </p:txBody>
          </p:sp>
        </p:grpSp>
        <p:sp>
          <p:nvSpPr>
            <p:cNvPr id="119" name="Freeform 118">
              <a:extLst>
                <a:ext uri="{FF2B5EF4-FFF2-40B4-BE49-F238E27FC236}">
                  <a16:creationId xmlns:a16="http://schemas.microsoft.com/office/drawing/2014/main" id="{13C7BB76-7F18-A640-AF31-1897C5081407}"/>
                </a:ext>
              </a:extLst>
            </p:cNvPr>
            <p:cNvSpPr/>
            <p:nvPr/>
          </p:nvSpPr>
          <p:spPr>
            <a:xfrm>
              <a:off x="2598306" y="3540749"/>
              <a:ext cx="587932" cy="747123"/>
            </a:xfrm>
            <a:custGeom>
              <a:avLst/>
              <a:gdLst>
                <a:gd name="connsiteX0" fmla="*/ 0 w 816441"/>
                <a:gd name="connsiteY0" fmla="*/ 0 h 762329"/>
                <a:gd name="connsiteX1" fmla="*/ 132522 w 816441"/>
                <a:gd name="connsiteY1" fmla="*/ 185531 h 762329"/>
                <a:gd name="connsiteX2" fmla="*/ 344557 w 816441"/>
                <a:gd name="connsiteY2" fmla="*/ 477079 h 762329"/>
                <a:gd name="connsiteX3" fmla="*/ 543339 w 816441"/>
                <a:gd name="connsiteY3" fmla="*/ 728870 h 762329"/>
                <a:gd name="connsiteX4" fmla="*/ 715618 w 816441"/>
                <a:gd name="connsiteY4" fmla="*/ 755374 h 762329"/>
                <a:gd name="connsiteX5" fmla="*/ 808383 w 816441"/>
                <a:gd name="connsiteY5" fmla="*/ 689113 h 762329"/>
                <a:gd name="connsiteX6" fmla="*/ 795131 w 816441"/>
                <a:gd name="connsiteY6" fmla="*/ 596348 h 762329"/>
                <a:gd name="connsiteX7" fmla="*/ 662609 w 816441"/>
                <a:gd name="connsiteY7" fmla="*/ 410818 h 762329"/>
                <a:gd name="connsiteX8" fmla="*/ 490331 w 816441"/>
                <a:gd name="connsiteY8" fmla="*/ 278296 h 762329"/>
                <a:gd name="connsiteX9" fmla="*/ 318052 w 816441"/>
                <a:gd name="connsiteY9" fmla="*/ 145774 h 762329"/>
                <a:gd name="connsiteX10" fmla="*/ 159026 w 816441"/>
                <a:gd name="connsiteY10" fmla="*/ 26505 h 7623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816441" h="762329">
                  <a:moveTo>
                    <a:pt x="0" y="0"/>
                  </a:moveTo>
                  <a:cubicBezTo>
                    <a:pt x="37548" y="53009"/>
                    <a:pt x="132522" y="185531"/>
                    <a:pt x="132522" y="185531"/>
                  </a:cubicBezTo>
                  <a:cubicBezTo>
                    <a:pt x="189948" y="265044"/>
                    <a:pt x="276087" y="386522"/>
                    <a:pt x="344557" y="477079"/>
                  </a:cubicBezTo>
                  <a:cubicBezTo>
                    <a:pt x="413027" y="567636"/>
                    <a:pt x="481496" y="682488"/>
                    <a:pt x="543339" y="728870"/>
                  </a:cubicBezTo>
                  <a:cubicBezTo>
                    <a:pt x="605183" y="775253"/>
                    <a:pt x="671444" y="762000"/>
                    <a:pt x="715618" y="755374"/>
                  </a:cubicBezTo>
                  <a:cubicBezTo>
                    <a:pt x="759792" y="748748"/>
                    <a:pt x="795131" y="715617"/>
                    <a:pt x="808383" y="689113"/>
                  </a:cubicBezTo>
                  <a:cubicBezTo>
                    <a:pt x="821635" y="662609"/>
                    <a:pt x="819427" y="642730"/>
                    <a:pt x="795131" y="596348"/>
                  </a:cubicBezTo>
                  <a:cubicBezTo>
                    <a:pt x="770835" y="549966"/>
                    <a:pt x="713409" y="463827"/>
                    <a:pt x="662609" y="410818"/>
                  </a:cubicBezTo>
                  <a:cubicBezTo>
                    <a:pt x="611809" y="357809"/>
                    <a:pt x="490331" y="278296"/>
                    <a:pt x="490331" y="278296"/>
                  </a:cubicBezTo>
                  <a:lnTo>
                    <a:pt x="318052" y="145774"/>
                  </a:lnTo>
                  <a:cubicBezTo>
                    <a:pt x="262835" y="103809"/>
                    <a:pt x="210930" y="65157"/>
                    <a:pt x="159026" y="26505"/>
                  </a:cubicBezTo>
                </a:path>
              </a:pathLst>
            </a:cu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121" name="TextBox 8">
              <a:extLst>
                <a:ext uri="{FF2B5EF4-FFF2-40B4-BE49-F238E27FC236}">
                  <a16:creationId xmlns:a16="http://schemas.microsoft.com/office/drawing/2014/main" id="{64C94099-C32B-C441-965E-EA1CE247F33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36573" y="4034800"/>
              <a:ext cx="692715" cy="2659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9pPr>
            </a:lstStyle>
            <a:p>
              <a:r>
                <a:rPr lang="en-US" sz="1100" dirty="0">
                  <a:solidFill>
                    <a:schemeClr val="bg1"/>
                  </a:solidFill>
                  <a:latin typeface="Arial" charset="0"/>
                </a:rPr>
                <a:t>BMA</a:t>
              </a:r>
            </a:p>
          </p:txBody>
        </p:sp>
      </p:grpSp>
      <p:sp>
        <p:nvSpPr>
          <p:cNvPr id="122" name="TextBox 14">
            <a:extLst>
              <a:ext uri="{FF2B5EF4-FFF2-40B4-BE49-F238E27FC236}">
                <a16:creationId xmlns:a16="http://schemas.microsoft.com/office/drawing/2014/main" id="{678457E6-8B90-E247-BF93-7F7EE02A79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479" y="4594963"/>
            <a:ext cx="45236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00" dirty="0">
                <a:solidFill>
                  <a:schemeClr val="bg1"/>
                </a:solidFill>
                <a:latin typeface="Arial" charset="0"/>
                <a:cs typeface="Arial" charset="0"/>
              </a:rPr>
              <a:t>BL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308DF7B-D3CE-D942-927F-B712E613C010}"/>
              </a:ext>
            </a:extLst>
          </p:cNvPr>
          <p:cNvSpPr txBox="1"/>
          <p:nvPr/>
        </p:nvSpPr>
        <p:spPr>
          <a:xfrm>
            <a:off x="3000191" y="236150"/>
            <a:ext cx="2414002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cyap1-EGFP  mic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27FB937-84B8-6048-9A34-848458FCAB30}"/>
              </a:ext>
            </a:extLst>
          </p:cNvPr>
          <p:cNvSpPr txBox="1"/>
          <p:nvPr/>
        </p:nvSpPr>
        <p:spPr>
          <a:xfrm>
            <a:off x="1081858" y="3051325"/>
            <a:ext cx="2414002" cy="32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4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cyap1-EGFP  mic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141E8DF-2C2F-074D-A9FF-59B4B5039521}"/>
              </a:ext>
            </a:extLst>
          </p:cNvPr>
          <p:cNvSpPr txBox="1"/>
          <p:nvPr/>
        </p:nvSpPr>
        <p:spPr>
          <a:xfrm>
            <a:off x="5978597" y="2985361"/>
            <a:ext cx="1471237" cy="32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AP mRN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A35CD90-54DC-2143-B4AF-90F7D2D7DC0F}"/>
              </a:ext>
            </a:extLst>
          </p:cNvPr>
          <p:cNvGrpSpPr/>
          <p:nvPr/>
        </p:nvGrpSpPr>
        <p:grpSpPr>
          <a:xfrm>
            <a:off x="3258854" y="539227"/>
            <a:ext cx="2301575" cy="1799090"/>
            <a:chOff x="576243" y="595946"/>
            <a:chExt cx="2092341" cy="163553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775AEA8-EF13-BD4D-BFD1-A3E7A8FA889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76243" y="903984"/>
              <a:ext cx="2092341" cy="1327498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C700C63-8D85-C44F-8BD6-B46915B3833A}"/>
                </a:ext>
              </a:extLst>
            </p:cNvPr>
            <p:cNvSpPr txBox="1"/>
            <p:nvPr/>
          </p:nvSpPr>
          <p:spPr>
            <a:xfrm>
              <a:off x="1041723" y="595946"/>
              <a:ext cx="1226735" cy="29938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54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AP </a:t>
              </a:r>
              <a:r>
                <a:rPr lang="en-US" sz="154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A4CE2C1-A196-4B4F-8F7A-DBAAAA32661D}"/>
                </a:ext>
              </a:extLst>
            </p:cNvPr>
            <p:cNvSpPr txBox="1"/>
            <p:nvPr/>
          </p:nvSpPr>
          <p:spPr>
            <a:xfrm rot="19702277" flipH="1">
              <a:off x="863242" y="1901796"/>
              <a:ext cx="557434" cy="207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8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A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C4854516-5087-EE4B-8B79-E5F3A2478940}"/>
              </a:ext>
            </a:extLst>
          </p:cNvPr>
          <p:cNvGrpSpPr/>
          <p:nvPr/>
        </p:nvGrpSpPr>
        <p:grpSpPr>
          <a:xfrm>
            <a:off x="792950" y="569499"/>
            <a:ext cx="2303227" cy="1826597"/>
            <a:chOff x="-3408412" y="721555"/>
            <a:chExt cx="2093843" cy="166054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3025F41-5B7E-7149-89CA-58D5B991FDC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3408412" y="1002372"/>
              <a:ext cx="2093843" cy="1379726"/>
            </a:xfrm>
            <a:prstGeom prst="rect">
              <a:avLst/>
            </a:prstGeom>
          </p:spPr>
        </p:pic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C700C63-8D85-C44F-8BD6-B46915B3833A}"/>
                </a:ext>
              </a:extLst>
            </p:cNvPr>
            <p:cNvSpPr txBox="1"/>
            <p:nvPr/>
          </p:nvSpPr>
          <p:spPr>
            <a:xfrm>
              <a:off x="-2989740" y="721555"/>
              <a:ext cx="1226735" cy="29938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54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AP </a:t>
              </a:r>
              <a:r>
                <a:rPr lang="en-US" sz="154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387D260-C80A-B245-9135-4F368C71E6A0}"/>
                </a:ext>
              </a:extLst>
            </p:cNvPr>
            <p:cNvSpPr txBox="1"/>
            <p:nvPr/>
          </p:nvSpPr>
          <p:spPr>
            <a:xfrm rot="19233214" flipH="1">
              <a:off x="-3154447" y="1996562"/>
              <a:ext cx="557434" cy="207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8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24533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Box 22">
            <a:extLst>
              <a:ext uri="{FF2B5EF4-FFF2-40B4-BE49-F238E27FC236}">
                <a16:creationId xmlns:a16="http://schemas.microsoft.com/office/drawing/2014/main" id="{E164AE9F-D10F-8643-978B-5DD9AB54F2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3453" y="6824789"/>
            <a:ext cx="1260281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>
                <a:solidFill>
                  <a:srgbClr val="FF0000"/>
                </a:solidFill>
                <a:latin typeface="Arial" charset="0"/>
              </a:rPr>
              <a:t>PAC1 </a:t>
            </a:r>
            <a:r>
              <a:rPr lang="en-US" sz="1114" dirty="0">
                <a:solidFill>
                  <a:srgbClr val="00B050"/>
                </a:solidFill>
                <a:latin typeface="Arial" charset="0"/>
              </a:rPr>
              <a:t>GFP</a:t>
            </a:r>
            <a:r>
              <a:rPr lang="en-US" sz="1114" dirty="0">
                <a:latin typeface="Arial" charset="0"/>
              </a:rPr>
              <a:t> </a:t>
            </a:r>
            <a:r>
              <a:rPr lang="en-US" sz="1114" dirty="0">
                <a:solidFill>
                  <a:srgbClr val="0070C0"/>
                </a:solidFill>
                <a:latin typeface="Arial" charset="0"/>
              </a:rPr>
              <a:t>DAP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B5D2894-DACC-9040-B6DE-00C7FE92C63A}"/>
              </a:ext>
            </a:extLst>
          </p:cNvPr>
          <p:cNvSpPr txBox="1"/>
          <p:nvPr/>
        </p:nvSpPr>
        <p:spPr>
          <a:xfrm>
            <a:off x="1019358" y="836708"/>
            <a:ext cx="1106072" cy="2785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10" b="1" dirty="0">
                <a:latin typeface="Arial" panose="020B0604020202020204" pitchFamily="34" charset="0"/>
                <a:cs typeface="Arial" panose="020B0604020202020204" pitchFamily="34" charset="0"/>
              </a:rPr>
              <a:t>PAC1 mRNA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8F80C4AE-8642-134E-8131-7F60F89641C4}"/>
              </a:ext>
            </a:extLst>
          </p:cNvPr>
          <p:cNvGrpSpPr/>
          <p:nvPr/>
        </p:nvGrpSpPr>
        <p:grpSpPr>
          <a:xfrm>
            <a:off x="2987908" y="4906635"/>
            <a:ext cx="4526280" cy="1256114"/>
            <a:chOff x="7723835" y="4062112"/>
            <a:chExt cx="3459602" cy="764459"/>
          </a:xfrm>
        </p:grpSpPr>
        <p:pic>
          <p:nvPicPr>
            <p:cNvPr id="38" name="Picture 37" descr="M1S1merge2_Gallery.jpg">
              <a:extLst>
                <a:ext uri="{FF2B5EF4-FFF2-40B4-BE49-F238E27FC236}">
                  <a16:creationId xmlns:a16="http://schemas.microsoft.com/office/drawing/2014/main" id="{6F954CD9-A02D-374D-8D54-7688935DF4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747" b="67980"/>
            <a:stretch/>
          </p:blipFill>
          <p:spPr>
            <a:xfrm flipH="1" flipV="1">
              <a:off x="7723835" y="4062113"/>
              <a:ext cx="1117832" cy="76445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9" name="Picture 38" descr="M1S1merge2_Gallery.jpg">
              <a:extLst>
                <a:ext uri="{FF2B5EF4-FFF2-40B4-BE49-F238E27FC236}">
                  <a16:creationId xmlns:a16="http://schemas.microsoft.com/office/drawing/2014/main" id="{7CECC08E-E97B-7C44-B1BD-AE1F377DD5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36268" b="33194"/>
            <a:stretch/>
          </p:blipFill>
          <p:spPr>
            <a:xfrm flipH="1" flipV="1">
              <a:off x="8891472" y="4065695"/>
              <a:ext cx="1102920" cy="76087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0" name="Picture 39" descr="M1S1merge2_Gallery.jpg">
              <a:extLst>
                <a:ext uri="{FF2B5EF4-FFF2-40B4-BE49-F238E27FC236}">
                  <a16:creationId xmlns:a16="http://schemas.microsoft.com/office/drawing/2014/main" id="{172587CA-C1EF-C642-B5F5-07CE7B9ABD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69727"/>
            <a:stretch/>
          </p:blipFill>
          <p:spPr>
            <a:xfrm flipH="1" flipV="1">
              <a:off x="10065605" y="4062112"/>
              <a:ext cx="1117832" cy="76445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sp>
        <p:nvSpPr>
          <p:cNvPr id="41" name="Freeform 40">
            <a:extLst>
              <a:ext uri="{FF2B5EF4-FFF2-40B4-BE49-F238E27FC236}">
                <a16:creationId xmlns:a16="http://schemas.microsoft.com/office/drawing/2014/main" id="{60D909EF-A00E-7B4A-AAEC-98AF512BABF4}"/>
              </a:ext>
            </a:extLst>
          </p:cNvPr>
          <p:cNvSpPr/>
          <p:nvPr/>
        </p:nvSpPr>
        <p:spPr>
          <a:xfrm>
            <a:off x="3226809" y="3751562"/>
            <a:ext cx="321470" cy="307182"/>
          </a:xfrm>
          <a:custGeom>
            <a:avLst/>
            <a:gdLst>
              <a:gd name="connsiteX0" fmla="*/ 519546 w 519546"/>
              <a:gd name="connsiteY0" fmla="*/ 0 h 496455"/>
              <a:gd name="connsiteX1" fmla="*/ 404091 w 519546"/>
              <a:gd name="connsiteY1" fmla="*/ 103909 h 496455"/>
              <a:gd name="connsiteX2" fmla="*/ 277091 w 519546"/>
              <a:gd name="connsiteY2" fmla="*/ 207818 h 496455"/>
              <a:gd name="connsiteX3" fmla="*/ 161637 w 519546"/>
              <a:gd name="connsiteY3" fmla="*/ 334818 h 496455"/>
              <a:gd name="connsiteX4" fmla="*/ 69273 w 519546"/>
              <a:gd name="connsiteY4" fmla="*/ 427182 h 496455"/>
              <a:gd name="connsiteX5" fmla="*/ 0 w 519546"/>
              <a:gd name="connsiteY5" fmla="*/ 496455 h 4964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519546" h="496455">
                <a:moveTo>
                  <a:pt x="519546" y="0"/>
                </a:moveTo>
                <a:cubicBezTo>
                  <a:pt x="482023" y="34636"/>
                  <a:pt x="444500" y="69273"/>
                  <a:pt x="404091" y="103909"/>
                </a:cubicBezTo>
                <a:cubicBezTo>
                  <a:pt x="363682" y="138545"/>
                  <a:pt x="317500" y="169333"/>
                  <a:pt x="277091" y="207818"/>
                </a:cubicBezTo>
                <a:cubicBezTo>
                  <a:pt x="236682" y="246303"/>
                  <a:pt x="196273" y="298257"/>
                  <a:pt x="161637" y="334818"/>
                </a:cubicBezTo>
                <a:cubicBezTo>
                  <a:pt x="127001" y="371379"/>
                  <a:pt x="69273" y="427182"/>
                  <a:pt x="69273" y="427182"/>
                </a:cubicBezTo>
                <a:lnTo>
                  <a:pt x="0" y="496455"/>
                </a:lnTo>
              </a:path>
            </a:pathLst>
          </a:cu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14"/>
          </a:p>
        </p:txBody>
      </p:sp>
      <p:sp>
        <p:nvSpPr>
          <p:cNvPr id="43" name="TextBox 22">
            <a:extLst>
              <a:ext uri="{FF2B5EF4-FFF2-40B4-BE49-F238E27FC236}">
                <a16:creationId xmlns:a16="http://schemas.microsoft.com/office/drawing/2014/main" id="{730693B3-F6A0-264A-9883-97D77F94F7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75353" y="4654615"/>
            <a:ext cx="704039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 err="1">
                <a:solidFill>
                  <a:srgbClr val="FF0000"/>
                </a:solidFill>
                <a:latin typeface="Arial" charset="0"/>
              </a:rPr>
              <a:t>mcherry</a:t>
            </a:r>
            <a:endParaRPr lang="en-US" sz="1114" dirty="0">
              <a:solidFill>
                <a:srgbClr val="FF0000"/>
              </a:solidFill>
              <a:latin typeface="Arial" charset="0"/>
            </a:endParaRPr>
          </a:p>
        </p:txBody>
      </p:sp>
      <p:sp>
        <p:nvSpPr>
          <p:cNvPr id="44" name="TextBox 22">
            <a:extLst>
              <a:ext uri="{FF2B5EF4-FFF2-40B4-BE49-F238E27FC236}">
                <a16:creationId xmlns:a16="http://schemas.microsoft.com/office/drawing/2014/main" id="{8F647C60-3728-4845-B057-296E35E0DB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5917" y="4678372"/>
            <a:ext cx="516488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>
                <a:solidFill>
                  <a:srgbClr val="0070C0"/>
                </a:solidFill>
                <a:latin typeface="Arial" charset="0"/>
              </a:rPr>
              <a:t>DAPI</a:t>
            </a:r>
          </a:p>
        </p:txBody>
      </p:sp>
      <p:sp>
        <p:nvSpPr>
          <p:cNvPr id="45" name="TextBox 22">
            <a:extLst>
              <a:ext uri="{FF2B5EF4-FFF2-40B4-BE49-F238E27FC236}">
                <a16:creationId xmlns:a16="http://schemas.microsoft.com/office/drawing/2014/main" id="{A9E6E382-CD5C-A647-AD97-6C9016F419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34380" y="4659980"/>
            <a:ext cx="1075936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 err="1">
                <a:solidFill>
                  <a:srgbClr val="FF0000"/>
                </a:solidFill>
                <a:latin typeface="Arial" charset="0"/>
              </a:rPr>
              <a:t>mcherry</a:t>
            </a:r>
            <a:r>
              <a:rPr lang="en-US" sz="1114" dirty="0">
                <a:latin typeface="Arial" charset="0"/>
              </a:rPr>
              <a:t> </a:t>
            </a:r>
            <a:r>
              <a:rPr lang="en-US" sz="1114" dirty="0">
                <a:solidFill>
                  <a:srgbClr val="0070C0"/>
                </a:solidFill>
                <a:latin typeface="Arial" charset="0"/>
              </a:rPr>
              <a:t>DAPI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53ED7DD-E9DA-F147-9088-610B905536FB}"/>
              </a:ext>
            </a:extLst>
          </p:cNvPr>
          <p:cNvGrpSpPr/>
          <p:nvPr/>
        </p:nvGrpSpPr>
        <p:grpSpPr>
          <a:xfrm>
            <a:off x="3082008" y="7031278"/>
            <a:ext cx="4157855" cy="1688114"/>
            <a:chOff x="632413" y="3293073"/>
            <a:chExt cx="7255886" cy="2945935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8483A9A-5935-3A4C-AE5D-7627A023AC6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screen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65491" y="3718501"/>
              <a:ext cx="971550" cy="72866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53A96BD4-28E0-B849-B4D3-28036BCB8997}"/>
                </a:ext>
              </a:extLst>
            </p:cNvPr>
            <p:cNvCxnSpPr/>
            <p:nvPr/>
          </p:nvCxnSpPr>
          <p:spPr>
            <a:xfrm flipV="1">
              <a:off x="1996481" y="3375074"/>
              <a:ext cx="440347" cy="585447"/>
            </a:xfrm>
            <a:prstGeom prst="line">
              <a:avLst/>
            </a:prstGeom>
            <a:ln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C585E7B3-B59A-A54D-8F94-E7E3434175C3}"/>
                </a:ext>
              </a:extLst>
            </p:cNvPr>
            <p:cNvCxnSpPr/>
            <p:nvPr/>
          </p:nvCxnSpPr>
          <p:spPr>
            <a:xfrm>
              <a:off x="2016736" y="4082619"/>
              <a:ext cx="420092" cy="489574"/>
            </a:xfrm>
            <a:prstGeom prst="line">
              <a:avLst/>
            </a:prstGeom>
            <a:ln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FA3BEFA-5CE9-F745-B7F6-C1778B3DC8ED}"/>
                </a:ext>
              </a:extLst>
            </p:cNvPr>
            <p:cNvSpPr txBox="1"/>
            <p:nvPr/>
          </p:nvSpPr>
          <p:spPr>
            <a:xfrm rot="16200000">
              <a:off x="2229137" y="5159787"/>
              <a:ext cx="1209040" cy="633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0" b="1" dirty="0">
                  <a:latin typeface="Arial"/>
                  <a:cs typeface="Arial"/>
                </a:rPr>
                <a:t>Control </a:t>
              </a:r>
            </a:p>
            <a:p>
              <a:r>
                <a:rPr lang="en-US" sz="880" b="1" dirty="0">
                  <a:latin typeface="Arial"/>
                  <a:cs typeface="Arial"/>
                </a:rPr>
                <a:t>AAV-GFP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A70AEEE-E2C4-8C4E-AE4E-FA3D57E8942F}"/>
                </a:ext>
              </a:extLst>
            </p:cNvPr>
            <p:cNvSpPr txBox="1"/>
            <p:nvPr/>
          </p:nvSpPr>
          <p:spPr>
            <a:xfrm rot="16200000">
              <a:off x="417964" y="3894684"/>
              <a:ext cx="1600678" cy="3974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0" b="1" dirty="0">
                  <a:latin typeface="Arial"/>
                  <a:cs typeface="Arial"/>
                </a:rPr>
                <a:t>AAV-</a:t>
              </a:r>
              <a:r>
                <a:rPr lang="en-US" sz="880" b="1" dirty="0" err="1">
                  <a:latin typeface="Arial"/>
                  <a:cs typeface="Arial"/>
                </a:rPr>
                <a:t>Cre</a:t>
              </a:r>
              <a:r>
                <a:rPr lang="en-US" sz="880" b="1" dirty="0">
                  <a:latin typeface="Arial"/>
                  <a:cs typeface="Arial"/>
                </a:rPr>
                <a:t>-GFP</a:t>
              </a:r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1138B14C-29F7-D644-A30B-CF54AE335640}"/>
                </a:ext>
              </a:extLst>
            </p:cNvPr>
            <p:cNvSpPr/>
            <p:nvPr/>
          </p:nvSpPr>
          <p:spPr>
            <a:xfrm>
              <a:off x="1753169" y="3750858"/>
              <a:ext cx="250114" cy="499376"/>
            </a:xfrm>
            <a:custGeom>
              <a:avLst/>
              <a:gdLst>
                <a:gd name="connsiteX0" fmla="*/ 104205 w 524582"/>
                <a:gd name="connsiteY0" fmla="*/ 0 h 869981"/>
                <a:gd name="connsiteX1" fmla="*/ 256605 w 524582"/>
                <a:gd name="connsiteY1" fmla="*/ 146050 h 869981"/>
                <a:gd name="connsiteX2" fmla="*/ 370905 w 524582"/>
                <a:gd name="connsiteY2" fmla="*/ 247650 h 869981"/>
                <a:gd name="connsiteX3" fmla="*/ 459805 w 524582"/>
                <a:gd name="connsiteY3" fmla="*/ 374650 h 869981"/>
                <a:gd name="connsiteX4" fmla="*/ 516955 w 524582"/>
                <a:gd name="connsiteY4" fmla="*/ 514350 h 869981"/>
                <a:gd name="connsiteX5" fmla="*/ 523305 w 524582"/>
                <a:gd name="connsiteY5" fmla="*/ 615950 h 869981"/>
                <a:gd name="connsiteX6" fmla="*/ 510605 w 524582"/>
                <a:gd name="connsiteY6" fmla="*/ 736600 h 869981"/>
                <a:gd name="connsiteX7" fmla="*/ 428055 w 524582"/>
                <a:gd name="connsiteY7" fmla="*/ 819150 h 869981"/>
                <a:gd name="connsiteX8" fmla="*/ 345505 w 524582"/>
                <a:gd name="connsiteY8" fmla="*/ 869950 h 869981"/>
                <a:gd name="connsiteX9" fmla="*/ 205805 w 524582"/>
                <a:gd name="connsiteY9" fmla="*/ 825500 h 869981"/>
                <a:gd name="connsiteX10" fmla="*/ 104205 w 524582"/>
                <a:gd name="connsiteY10" fmla="*/ 749300 h 869981"/>
                <a:gd name="connsiteX11" fmla="*/ 59755 w 524582"/>
                <a:gd name="connsiteY11" fmla="*/ 666750 h 869981"/>
                <a:gd name="connsiteX12" fmla="*/ 8955 w 524582"/>
                <a:gd name="connsiteY12" fmla="*/ 565150 h 869981"/>
                <a:gd name="connsiteX13" fmla="*/ 2605 w 524582"/>
                <a:gd name="connsiteY13" fmla="*/ 444500 h 869981"/>
                <a:gd name="connsiteX14" fmla="*/ 2605 w 524582"/>
                <a:gd name="connsiteY14" fmla="*/ 342900 h 869981"/>
                <a:gd name="connsiteX15" fmla="*/ 34355 w 524582"/>
                <a:gd name="connsiteY15" fmla="*/ 209550 h 869981"/>
                <a:gd name="connsiteX16" fmla="*/ 59755 w 524582"/>
                <a:gd name="connsiteY16" fmla="*/ 76200 h 869981"/>
                <a:gd name="connsiteX17" fmla="*/ 66105 w 524582"/>
                <a:gd name="connsiteY17" fmla="*/ 50800 h 869981"/>
                <a:gd name="connsiteX18" fmla="*/ 104205 w 524582"/>
                <a:gd name="connsiteY18" fmla="*/ 0 h 8699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524582" h="869981">
                  <a:moveTo>
                    <a:pt x="104205" y="0"/>
                  </a:moveTo>
                  <a:cubicBezTo>
                    <a:pt x="158180" y="52387"/>
                    <a:pt x="212155" y="104775"/>
                    <a:pt x="256605" y="146050"/>
                  </a:cubicBezTo>
                  <a:cubicBezTo>
                    <a:pt x="301055" y="187325"/>
                    <a:pt x="337038" y="209550"/>
                    <a:pt x="370905" y="247650"/>
                  </a:cubicBezTo>
                  <a:cubicBezTo>
                    <a:pt x="404772" y="285750"/>
                    <a:pt x="435463" y="330200"/>
                    <a:pt x="459805" y="374650"/>
                  </a:cubicBezTo>
                  <a:cubicBezTo>
                    <a:pt x="484147" y="419100"/>
                    <a:pt x="506372" y="474133"/>
                    <a:pt x="516955" y="514350"/>
                  </a:cubicBezTo>
                  <a:cubicBezTo>
                    <a:pt x="527538" y="554567"/>
                    <a:pt x="524363" y="578908"/>
                    <a:pt x="523305" y="615950"/>
                  </a:cubicBezTo>
                  <a:cubicBezTo>
                    <a:pt x="522247" y="652992"/>
                    <a:pt x="526480" y="702733"/>
                    <a:pt x="510605" y="736600"/>
                  </a:cubicBezTo>
                  <a:cubicBezTo>
                    <a:pt x="494730" y="770467"/>
                    <a:pt x="455572" y="796925"/>
                    <a:pt x="428055" y="819150"/>
                  </a:cubicBezTo>
                  <a:cubicBezTo>
                    <a:pt x="400538" y="841375"/>
                    <a:pt x="382547" y="868892"/>
                    <a:pt x="345505" y="869950"/>
                  </a:cubicBezTo>
                  <a:cubicBezTo>
                    <a:pt x="308463" y="871008"/>
                    <a:pt x="246022" y="845608"/>
                    <a:pt x="205805" y="825500"/>
                  </a:cubicBezTo>
                  <a:cubicBezTo>
                    <a:pt x="165588" y="805392"/>
                    <a:pt x="128547" y="775758"/>
                    <a:pt x="104205" y="749300"/>
                  </a:cubicBezTo>
                  <a:cubicBezTo>
                    <a:pt x="79863" y="722842"/>
                    <a:pt x="75630" y="697442"/>
                    <a:pt x="59755" y="666750"/>
                  </a:cubicBezTo>
                  <a:cubicBezTo>
                    <a:pt x="43880" y="636058"/>
                    <a:pt x="18480" y="602192"/>
                    <a:pt x="8955" y="565150"/>
                  </a:cubicBezTo>
                  <a:cubicBezTo>
                    <a:pt x="-570" y="528108"/>
                    <a:pt x="3663" y="481542"/>
                    <a:pt x="2605" y="444500"/>
                  </a:cubicBezTo>
                  <a:cubicBezTo>
                    <a:pt x="1547" y="407458"/>
                    <a:pt x="-2687" y="382058"/>
                    <a:pt x="2605" y="342900"/>
                  </a:cubicBezTo>
                  <a:cubicBezTo>
                    <a:pt x="7897" y="303742"/>
                    <a:pt x="24830" y="254000"/>
                    <a:pt x="34355" y="209550"/>
                  </a:cubicBezTo>
                  <a:cubicBezTo>
                    <a:pt x="43880" y="165100"/>
                    <a:pt x="54463" y="102658"/>
                    <a:pt x="59755" y="76200"/>
                  </a:cubicBezTo>
                  <a:cubicBezTo>
                    <a:pt x="65047" y="49742"/>
                    <a:pt x="66105" y="50800"/>
                    <a:pt x="66105" y="50800"/>
                  </a:cubicBezTo>
                  <a:lnTo>
                    <a:pt x="104205" y="0"/>
                  </a:lnTo>
                  <a:close/>
                </a:path>
              </a:pathLst>
            </a:custGeom>
            <a:noFill/>
            <a:ln w="3175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0">
                <a:solidFill>
                  <a:schemeClr val="tx1"/>
                </a:solidFill>
              </a:endParaRPr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EADD99C-B720-7E4B-96CD-DCF206DCBD4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screen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988941" y="5064844"/>
              <a:ext cx="971550" cy="72866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2363E933-F774-2143-8D8E-AAB37068E3C4}"/>
                </a:ext>
              </a:extLst>
            </p:cNvPr>
            <p:cNvSpPr/>
            <p:nvPr/>
          </p:nvSpPr>
          <p:spPr>
            <a:xfrm rot="21025607">
              <a:off x="3361469" y="5227987"/>
              <a:ext cx="233715" cy="489364"/>
            </a:xfrm>
            <a:custGeom>
              <a:avLst/>
              <a:gdLst>
                <a:gd name="connsiteX0" fmla="*/ 104205 w 524582"/>
                <a:gd name="connsiteY0" fmla="*/ 0 h 869981"/>
                <a:gd name="connsiteX1" fmla="*/ 256605 w 524582"/>
                <a:gd name="connsiteY1" fmla="*/ 146050 h 869981"/>
                <a:gd name="connsiteX2" fmla="*/ 370905 w 524582"/>
                <a:gd name="connsiteY2" fmla="*/ 247650 h 869981"/>
                <a:gd name="connsiteX3" fmla="*/ 459805 w 524582"/>
                <a:gd name="connsiteY3" fmla="*/ 374650 h 869981"/>
                <a:gd name="connsiteX4" fmla="*/ 516955 w 524582"/>
                <a:gd name="connsiteY4" fmla="*/ 514350 h 869981"/>
                <a:gd name="connsiteX5" fmla="*/ 523305 w 524582"/>
                <a:gd name="connsiteY5" fmla="*/ 615950 h 869981"/>
                <a:gd name="connsiteX6" fmla="*/ 510605 w 524582"/>
                <a:gd name="connsiteY6" fmla="*/ 736600 h 869981"/>
                <a:gd name="connsiteX7" fmla="*/ 428055 w 524582"/>
                <a:gd name="connsiteY7" fmla="*/ 819150 h 869981"/>
                <a:gd name="connsiteX8" fmla="*/ 345505 w 524582"/>
                <a:gd name="connsiteY8" fmla="*/ 869950 h 869981"/>
                <a:gd name="connsiteX9" fmla="*/ 205805 w 524582"/>
                <a:gd name="connsiteY9" fmla="*/ 825500 h 869981"/>
                <a:gd name="connsiteX10" fmla="*/ 104205 w 524582"/>
                <a:gd name="connsiteY10" fmla="*/ 749300 h 869981"/>
                <a:gd name="connsiteX11" fmla="*/ 59755 w 524582"/>
                <a:gd name="connsiteY11" fmla="*/ 666750 h 869981"/>
                <a:gd name="connsiteX12" fmla="*/ 8955 w 524582"/>
                <a:gd name="connsiteY12" fmla="*/ 565150 h 869981"/>
                <a:gd name="connsiteX13" fmla="*/ 2605 w 524582"/>
                <a:gd name="connsiteY13" fmla="*/ 444500 h 869981"/>
                <a:gd name="connsiteX14" fmla="*/ 2605 w 524582"/>
                <a:gd name="connsiteY14" fmla="*/ 342900 h 869981"/>
                <a:gd name="connsiteX15" fmla="*/ 34355 w 524582"/>
                <a:gd name="connsiteY15" fmla="*/ 209550 h 869981"/>
                <a:gd name="connsiteX16" fmla="*/ 59755 w 524582"/>
                <a:gd name="connsiteY16" fmla="*/ 76200 h 869981"/>
                <a:gd name="connsiteX17" fmla="*/ 66105 w 524582"/>
                <a:gd name="connsiteY17" fmla="*/ 50800 h 869981"/>
                <a:gd name="connsiteX18" fmla="*/ 104205 w 524582"/>
                <a:gd name="connsiteY18" fmla="*/ 0 h 8699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524582" h="869981">
                  <a:moveTo>
                    <a:pt x="104205" y="0"/>
                  </a:moveTo>
                  <a:cubicBezTo>
                    <a:pt x="158180" y="52387"/>
                    <a:pt x="212155" y="104775"/>
                    <a:pt x="256605" y="146050"/>
                  </a:cubicBezTo>
                  <a:cubicBezTo>
                    <a:pt x="301055" y="187325"/>
                    <a:pt x="337038" y="209550"/>
                    <a:pt x="370905" y="247650"/>
                  </a:cubicBezTo>
                  <a:cubicBezTo>
                    <a:pt x="404772" y="285750"/>
                    <a:pt x="435463" y="330200"/>
                    <a:pt x="459805" y="374650"/>
                  </a:cubicBezTo>
                  <a:cubicBezTo>
                    <a:pt x="484147" y="419100"/>
                    <a:pt x="506372" y="474133"/>
                    <a:pt x="516955" y="514350"/>
                  </a:cubicBezTo>
                  <a:cubicBezTo>
                    <a:pt x="527538" y="554567"/>
                    <a:pt x="524363" y="578908"/>
                    <a:pt x="523305" y="615950"/>
                  </a:cubicBezTo>
                  <a:cubicBezTo>
                    <a:pt x="522247" y="652992"/>
                    <a:pt x="526480" y="702733"/>
                    <a:pt x="510605" y="736600"/>
                  </a:cubicBezTo>
                  <a:cubicBezTo>
                    <a:pt x="494730" y="770467"/>
                    <a:pt x="455572" y="796925"/>
                    <a:pt x="428055" y="819150"/>
                  </a:cubicBezTo>
                  <a:cubicBezTo>
                    <a:pt x="400538" y="841375"/>
                    <a:pt x="382547" y="868892"/>
                    <a:pt x="345505" y="869950"/>
                  </a:cubicBezTo>
                  <a:cubicBezTo>
                    <a:pt x="308463" y="871008"/>
                    <a:pt x="246022" y="845608"/>
                    <a:pt x="205805" y="825500"/>
                  </a:cubicBezTo>
                  <a:cubicBezTo>
                    <a:pt x="165588" y="805392"/>
                    <a:pt x="128547" y="775758"/>
                    <a:pt x="104205" y="749300"/>
                  </a:cubicBezTo>
                  <a:cubicBezTo>
                    <a:pt x="79863" y="722842"/>
                    <a:pt x="75630" y="697442"/>
                    <a:pt x="59755" y="666750"/>
                  </a:cubicBezTo>
                  <a:cubicBezTo>
                    <a:pt x="43880" y="636058"/>
                    <a:pt x="18480" y="602192"/>
                    <a:pt x="8955" y="565150"/>
                  </a:cubicBezTo>
                  <a:cubicBezTo>
                    <a:pt x="-570" y="528108"/>
                    <a:pt x="3663" y="481542"/>
                    <a:pt x="2605" y="444500"/>
                  </a:cubicBezTo>
                  <a:cubicBezTo>
                    <a:pt x="1547" y="407458"/>
                    <a:pt x="-2687" y="382058"/>
                    <a:pt x="2605" y="342900"/>
                  </a:cubicBezTo>
                  <a:cubicBezTo>
                    <a:pt x="7897" y="303742"/>
                    <a:pt x="24830" y="254000"/>
                    <a:pt x="34355" y="209550"/>
                  </a:cubicBezTo>
                  <a:cubicBezTo>
                    <a:pt x="43880" y="165100"/>
                    <a:pt x="54463" y="102658"/>
                    <a:pt x="59755" y="76200"/>
                  </a:cubicBezTo>
                  <a:cubicBezTo>
                    <a:pt x="65047" y="49742"/>
                    <a:pt x="66105" y="50800"/>
                    <a:pt x="66105" y="50800"/>
                  </a:cubicBezTo>
                  <a:lnTo>
                    <a:pt x="104205" y="0"/>
                  </a:lnTo>
                  <a:close/>
                </a:path>
              </a:pathLst>
            </a:custGeom>
            <a:noFill/>
            <a:ln w="3175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0">
                <a:solidFill>
                  <a:schemeClr val="tx1"/>
                </a:solidFill>
              </a:endParaRPr>
            </a:p>
          </p:txBody>
        </p:sp>
        <p:pic>
          <p:nvPicPr>
            <p:cNvPr id="26" name="Content Placeholder 31">
              <a:extLst>
                <a:ext uri="{FF2B5EF4-FFF2-40B4-BE49-F238E27FC236}">
                  <a16:creationId xmlns:a16="http://schemas.microsoft.com/office/drawing/2014/main" id="{BE557F14-FB5E-404F-AF9F-02B799E683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screen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9596"/>
            <a:stretch/>
          </p:blipFill>
          <p:spPr>
            <a:xfrm>
              <a:off x="834113" y="3367981"/>
              <a:ext cx="3416371" cy="283424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A723A149-31E9-E848-8D78-21FBC08259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screen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24889" t="31176" r="25307" b="9001"/>
            <a:stretch/>
          </p:blipFill>
          <p:spPr>
            <a:xfrm>
              <a:off x="4633237" y="3306568"/>
              <a:ext cx="3255062" cy="293244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375DAE2D-7750-FA49-B263-C3436A56AB91}"/>
                </a:ext>
              </a:extLst>
            </p:cNvPr>
            <p:cNvCxnSpPr/>
            <p:nvPr/>
          </p:nvCxnSpPr>
          <p:spPr>
            <a:xfrm>
              <a:off x="2276601" y="4131546"/>
              <a:ext cx="70659" cy="104711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40462C7C-0FCA-B943-865A-4E5492AA1E0A}"/>
                </a:ext>
              </a:extLst>
            </p:cNvPr>
            <p:cNvCxnSpPr/>
            <p:nvPr/>
          </p:nvCxnSpPr>
          <p:spPr>
            <a:xfrm>
              <a:off x="2465546" y="4584379"/>
              <a:ext cx="70659" cy="104711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8BFD41FE-F99B-0944-B4A8-21900B4DCBE0}"/>
                </a:ext>
              </a:extLst>
            </p:cNvPr>
            <p:cNvCxnSpPr/>
            <p:nvPr/>
          </p:nvCxnSpPr>
          <p:spPr>
            <a:xfrm>
              <a:off x="632413" y="5989700"/>
              <a:ext cx="14282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2B8BB906-5C4C-9046-997F-10D0849AC9DC}"/>
                </a:ext>
              </a:extLst>
            </p:cNvPr>
            <p:cNvCxnSpPr/>
            <p:nvPr/>
          </p:nvCxnSpPr>
          <p:spPr>
            <a:xfrm>
              <a:off x="6070945" y="4519235"/>
              <a:ext cx="70659" cy="104711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661108EB-B233-3D48-9600-C08B20340D34}"/>
                </a:ext>
              </a:extLst>
            </p:cNvPr>
            <p:cNvCxnSpPr/>
            <p:nvPr/>
          </p:nvCxnSpPr>
          <p:spPr>
            <a:xfrm>
              <a:off x="5901651" y="4743846"/>
              <a:ext cx="70659" cy="104711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CFC8C911-6FB8-E848-8D13-1FF92D419BFA}"/>
                </a:ext>
              </a:extLst>
            </p:cNvPr>
            <p:cNvCxnSpPr/>
            <p:nvPr/>
          </p:nvCxnSpPr>
          <p:spPr>
            <a:xfrm>
              <a:off x="4799301" y="6049986"/>
              <a:ext cx="14282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FC8FA3D8-94C9-A949-9DFF-BF0353987889}"/>
                </a:ext>
              </a:extLst>
            </p:cNvPr>
            <p:cNvCxnSpPr/>
            <p:nvPr/>
          </p:nvCxnSpPr>
          <p:spPr>
            <a:xfrm flipV="1">
              <a:off x="6251902" y="3892181"/>
              <a:ext cx="624523" cy="642130"/>
            </a:xfrm>
            <a:prstGeom prst="line">
              <a:avLst/>
            </a:prstGeom>
            <a:ln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4A40701-F0BA-B94A-87BE-4CC69F3E0A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16980" y="4447164"/>
              <a:ext cx="821464" cy="298941"/>
            </a:xfrm>
            <a:prstGeom prst="line">
              <a:avLst/>
            </a:prstGeom>
            <a:ln>
              <a:solidFill>
                <a:schemeClr val="bg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AA06C275-E853-7F47-A161-B5A21FEC3D11}"/>
                </a:ext>
              </a:extLst>
            </p:cNvPr>
            <p:cNvSpPr/>
            <p:nvPr/>
          </p:nvSpPr>
          <p:spPr>
            <a:xfrm>
              <a:off x="6876425" y="3386356"/>
              <a:ext cx="932566" cy="1383416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8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30-40 % ↓ in PAC1 RNA speckles</a:t>
              </a: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FBE6BF0F-670B-3D48-A207-3C3C2B57E9BB}"/>
              </a:ext>
            </a:extLst>
          </p:cNvPr>
          <p:cNvSpPr txBox="1"/>
          <p:nvPr/>
        </p:nvSpPr>
        <p:spPr>
          <a:xfrm>
            <a:off x="5713452" y="9730333"/>
            <a:ext cx="1984839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Rajbhandari Figure S2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D3B80B81-48AB-B744-9163-AA4D5D017E13}"/>
              </a:ext>
            </a:extLst>
          </p:cNvPr>
          <p:cNvGrpSpPr/>
          <p:nvPr/>
        </p:nvGrpSpPr>
        <p:grpSpPr>
          <a:xfrm>
            <a:off x="723507" y="494027"/>
            <a:ext cx="3554029" cy="3252855"/>
            <a:chOff x="457178" y="1828389"/>
            <a:chExt cx="4646059" cy="4252346"/>
          </a:xfrm>
        </p:grpSpPr>
        <p:pic>
          <p:nvPicPr>
            <p:cNvPr id="53" name="Picture 3" descr="Screen Shot 2015-08-13 at 11.28.58 AM.png">
              <a:extLst>
                <a:ext uri="{FF2B5EF4-FFF2-40B4-BE49-F238E27FC236}">
                  <a16:creationId xmlns:a16="http://schemas.microsoft.com/office/drawing/2014/main" id="{1D3FFFAD-CFBC-364D-A33A-BD5DADFAD4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661"/>
            <a:stretch>
              <a:fillRect/>
            </a:stretch>
          </p:blipFill>
          <p:spPr bwMode="auto">
            <a:xfrm>
              <a:off x="476312" y="2645385"/>
              <a:ext cx="2222500" cy="343535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4" name="Picture 4" descr="Screen Shot 2015-08-13 at 11.29.54 AM.png">
              <a:extLst>
                <a:ext uri="{FF2B5EF4-FFF2-40B4-BE49-F238E27FC236}">
                  <a16:creationId xmlns:a16="http://schemas.microsoft.com/office/drawing/2014/main" id="{4CE9FFA7-8D4D-F144-B139-3A678A6581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8926"/>
            <a:stretch>
              <a:fillRect/>
            </a:stretch>
          </p:blipFill>
          <p:spPr bwMode="auto">
            <a:xfrm>
              <a:off x="2880737" y="2645385"/>
              <a:ext cx="2222500" cy="343535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267CED52-4222-7549-961E-60A1738F0DC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1141475" y="3339123"/>
              <a:ext cx="273050" cy="258762"/>
            </a:xfrm>
            <a:prstGeom prst="straightConnector1">
              <a:avLst/>
            </a:prstGeom>
            <a:noFill/>
            <a:ln w="50800">
              <a:solidFill>
                <a:schemeClr val="tx1"/>
              </a:solidFill>
              <a:round/>
              <a:headEnd/>
              <a:tailEnd type="arrow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200A53AB-2662-1241-A8D2-5A9384D5CCE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12825" y="4080485"/>
              <a:ext cx="273050" cy="258763"/>
            </a:xfrm>
            <a:prstGeom prst="straightConnector1">
              <a:avLst/>
            </a:prstGeom>
            <a:noFill/>
            <a:ln w="50800">
              <a:solidFill>
                <a:schemeClr val="tx1"/>
              </a:solidFill>
              <a:round/>
              <a:headEnd/>
              <a:tailEnd type="arrow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F4ABC3E2-47E5-1044-BE62-C512E19255E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483987" y="3324225"/>
              <a:ext cx="273050" cy="257175"/>
            </a:xfrm>
            <a:prstGeom prst="straightConnector1">
              <a:avLst/>
            </a:prstGeom>
            <a:noFill/>
            <a:ln w="50800">
              <a:solidFill>
                <a:schemeClr val="bg1"/>
              </a:solidFill>
              <a:round/>
              <a:headEnd/>
              <a:tailEnd type="arrow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41B44158-889D-3A4B-A2C0-69BE5DCC0E7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880737" y="4080485"/>
              <a:ext cx="273050" cy="258763"/>
            </a:xfrm>
            <a:prstGeom prst="straightConnector1">
              <a:avLst/>
            </a:prstGeom>
            <a:noFill/>
            <a:ln w="50800">
              <a:solidFill>
                <a:schemeClr val="bg1"/>
              </a:solidFill>
              <a:round/>
              <a:headEnd/>
              <a:tailEnd type="arrow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640A79A1-5E48-B641-830D-398495FB040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308287" y="3200400"/>
              <a:ext cx="282513" cy="319697"/>
            </a:xfrm>
            <a:prstGeom prst="straightConnector1">
              <a:avLst/>
            </a:prstGeom>
            <a:noFill/>
            <a:ln w="50800">
              <a:solidFill>
                <a:schemeClr val="tx1"/>
              </a:solidFill>
              <a:round/>
              <a:headEnd/>
              <a:tailEnd type="arrow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39E33E32-6B86-5741-A271-3D3DC563C1E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4800600" y="3505200"/>
              <a:ext cx="275213" cy="241910"/>
            </a:xfrm>
            <a:prstGeom prst="straightConnector1">
              <a:avLst/>
            </a:prstGeom>
            <a:noFill/>
            <a:ln w="50800">
              <a:solidFill>
                <a:schemeClr val="bg1"/>
              </a:solidFill>
              <a:round/>
              <a:headEnd/>
              <a:tailEnd type="arrow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F52B27A4-8922-384F-9475-512694FD8B11}"/>
                </a:ext>
              </a:extLst>
            </p:cNvPr>
            <p:cNvSpPr/>
            <p:nvPr/>
          </p:nvSpPr>
          <p:spPr>
            <a:xfrm>
              <a:off x="3325237" y="2663613"/>
              <a:ext cx="1373481" cy="2942152"/>
            </a:xfrm>
            <a:custGeom>
              <a:avLst/>
              <a:gdLst>
                <a:gd name="connsiteX0" fmla="*/ 1333500 w 1373481"/>
                <a:gd name="connsiteY0" fmla="*/ 822 h 2942152"/>
                <a:gd name="connsiteX1" fmla="*/ 1219200 w 1373481"/>
                <a:gd name="connsiteY1" fmla="*/ 191322 h 2942152"/>
                <a:gd name="connsiteX2" fmla="*/ 1079500 w 1373481"/>
                <a:gd name="connsiteY2" fmla="*/ 394522 h 2942152"/>
                <a:gd name="connsiteX3" fmla="*/ 939800 w 1373481"/>
                <a:gd name="connsiteY3" fmla="*/ 572322 h 2942152"/>
                <a:gd name="connsiteX4" fmla="*/ 850900 w 1373481"/>
                <a:gd name="connsiteY4" fmla="*/ 712022 h 2942152"/>
                <a:gd name="connsiteX5" fmla="*/ 787400 w 1373481"/>
                <a:gd name="connsiteY5" fmla="*/ 813622 h 2942152"/>
                <a:gd name="connsiteX6" fmla="*/ 736600 w 1373481"/>
                <a:gd name="connsiteY6" fmla="*/ 940622 h 2942152"/>
                <a:gd name="connsiteX7" fmla="*/ 647700 w 1373481"/>
                <a:gd name="connsiteY7" fmla="*/ 1029522 h 2942152"/>
                <a:gd name="connsiteX8" fmla="*/ 406400 w 1373481"/>
                <a:gd name="connsiteY8" fmla="*/ 1308922 h 2942152"/>
                <a:gd name="connsiteX9" fmla="*/ 317500 w 1373481"/>
                <a:gd name="connsiteY9" fmla="*/ 1435922 h 2942152"/>
                <a:gd name="connsiteX10" fmla="*/ 139700 w 1373481"/>
                <a:gd name="connsiteY10" fmla="*/ 1664522 h 2942152"/>
                <a:gd name="connsiteX11" fmla="*/ 88900 w 1373481"/>
                <a:gd name="connsiteY11" fmla="*/ 1829622 h 2942152"/>
                <a:gd name="connsiteX12" fmla="*/ 12700 w 1373481"/>
                <a:gd name="connsiteY12" fmla="*/ 1969322 h 2942152"/>
                <a:gd name="connsiteX13" fmla="*/ 0 w 1373481"/>
                <a:gd name="connsiteY13" fmla="*/ 2109022 h 2942152"/>
                <a:gd name="connsiteX14" fmla="*/ 0 w 1373481"/>
                <a:gd name="connsiteY14" fmla="*/ 2286822 h 2942152"/>
                <a:gd name="connsiteX15" fmla="*/ 12700 w 1373481"/>
                <a:gd name="connsiteY15" fmla="*/ 2464622 h 2942152"/>
                <a:gd name="connsiteX16" fmla="*/ 50800 w 1373481"/>
                <a:gd name="connsiteY16" fmla="*/ 2578922 h 2942152"/>
                <a:gd name="connsiteX17" fmla="*/ 139700 w 1373481"/>
                <a:gd name="connsiteY17" fmla="*/ 2655122 h 2942152"/>
                <a:gd name="connsiteX18" fmla="*/ 241300 w 1373481"/>
                <a:gd name="connsiteY18" fmla="*/ 2782122 h 2942152"/>
                <a:gd name="connsiteX19" fmla="*/ 419100 w 1373481"/>
                <a:gd name="connsiteY19" fmla="*/ 2909122 h 2942152"/>
                <a:gd name="connsiteX20" fmla="*/ 622300 w 1373481"/>
                <a:gd name="connsiteY20" fmla="*/ 2934522 h 2942152"/>
                <a:gd name="connsiteX21" fmla="*/ 825500 w 1373481"/>
                <a:gd name="connsiteY21" fmla="*/ 2934522 h 2942152"/>
                <a:gd name="connsiteX22" fmla="*/ 977900 w 1373481"/>
                <a:gd name="connsiteY22" fmla="*/ 2845622 h 2942152"/>
                <a:gd name="connsiteX23" fmla="*/ 1079500 w 1373481"/>
                <a:gd name="connsiteY23" fmla="*/ 2744022 h 2942152"/>
                <a:gd name="connsiteX24" fmla="*/ 1155700 w 1373481"/>
                <a:gd name="connsiteY24" fmla="*/ 2591622 h 2942152"/>
                <a:gd name="connsiteX25" fmla="*/ 1206500 w 1373481"/>
                <a:gd name="connsiteY25" fmla="*/ 2426522 h 2942152"/>
                <a:gd name="connsiteX26" fmla="*/ 1257300 w 1373481"/>
                <a:gd name="connsiteY26" fmla="*/ 2223322 h 2942152"/>
                <a:gd name="connsiteX27" fmla="*/ 1346200 w 1373481"/>
                <a:gd name="connsiteY27" fmla="*/ 1982022 h 2942152"/>
                <a:gd name="connsiteX28" fmla="*/ 1346200 w 1373481"/>
                <a:gd name="connsiteY28" fmla="*/ 1766122 h 2942152"/>
                <a:gd name="connsiteX29" fmla="*/ 1346200 w 1373481"/>
                <a:gd name="connsiteY29" fmla="*/ 1588322 h 2942152"/>
                <a:gd name="connsiteX30" fmla="*/ 1371600 w 1373481"/>
                <a:gd name="connsiteY30" fmla="*/ 1181922 h 2942152"/>
                <a:gd name="connsiteX31" fmla="*/ 1371600 w 1373481"/>
                <a:gd name="connsiteY31" fmla="*/ 940622 h 2942152"/>
                <a:gd name="connsiteX32" fmla="*/ 1371600 w 1373481"/>
                <a:gd name="connsiteY32" fmla="*/ 750122 h 2942152"/>
                <a:gd name="connsiteX33" fmla="*/ 1371600 w 1373481"/>
                <a:gd name="connsiteY33" fmla="*/ 559622 h 2942152"/>
                <a:gd name="connsiteX34" fmla="*/ 1358900 w 1373481"/>
                <a:gd name="connsiteY34" fmla="*/ 267522 h 2942152"/>
                <a:gd name="connsiteX35" fmla="*/ 1333500 w 1373481"/>
                <a:gd name="connsiteY35" fmla="*/ 822 h 29421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1373481" h="2942152">
                  <a:moveTo>
                    <a:pt x="1333500" y="822"/>
                  </a:moveTo>
                  <a:cubicBezTo>
                    <a:pt x="1310217" y="-11878"/>
                    <a:pt x="1261533" y="125705"/>
                    <a:pt x="1219200" y="191322"/>
                  </a:cubicBezTo>
                  <a:cubicBezTo>
                    <a:pt x="1176867" y="256939"/>
                    <a:pt x="1126067" y="331022"/>
                    <a:pt x="1079500" y="394522"/>
                  </a:cubicBezTo>
                  <a:cubicBezTo>
                    <a:pt x="1032933" y="458022"/>
                    <a:pt x="977900" y="519405"/>
                    <a:pt x="939800" y="572322"/>
                  </a:cubicBezTo>
                  <a:cubicBezTo>
                    <a:pt x="901700" y="625239"/>
                    <a:pt x="876300" y="671805"/>
                    <a:pt x="850900" y="712022"/>
                  </a:cubicBezTo>
                  <a:cubicBezTo>
                    <a:pt x="825500" y="752239"/>
                    <a:pt x="806450" y="775522"/>
                    <a:pt x="787400" y="813622"/>
                  </a:cubicBezTo>
                  <a:cubicBezTo>
                    <a:pt x="768350" y="851722"/>
                    <a:pt x="759883" y="904639"/>
                    <a:pt x="736600" y="940622"/>
                  </a:cubicBezTo>
                  <a:cubicBezTo>
                    <a:pt x="713317" y="976605"/>
                    <a:pt x="702733" y="968139"/>
                    <a:pt x="647700" y="1029522"/>
                  </a:cubicBezTo>
                  <a:cubicBezTo>
                    <a:pt x="592667" y="1090905"/>
                    <a:pt x="461433" y="1241189"/>
                    <a:pt x="406400" y="1308922"/>
                  </a:cubicBezTo>
                  <a:cubicBezTo>
                    <a:pt x="351367" y="1376655"/>
                    <a:pt x="361950" y="1376655"/>
                    <a:pt x="317500" y="1435922"/>
                  </a:cubicBezTo>
                  <a:cubicBezTo>
                    <a:pt x="273050" y="1495189"/>
                    <a:pt x="177800" y="1598905"/>
                    <a:pt x="139700" y="1664522"/>
                  </a:cubicBezTo>
                  <a:cubicBezTo>
                    <a:pt x="101600" y="1730139"/>
                    <a:pt x="110067" y="1778822"/>
                    <a:pt x="88900" y="1829622"/>
                  </a:cubicBezTo>
                  <a:cubicBezTo>
                    <a:pt x="67733" y="1880422"/>
                    <a:pt x="27517" y="1922755"/>
                    <a:pt x="12700" y="1969322"/>
                  </a:cubicBezTo>
                  <a:cubicBezTo>
                    <a:pt x="-2117" y="2015889"/>
                    <a:pt x="2117" y="2056105"/>
                    <a:pt x="0" y="2109022"/>
                  </a:cubicBezTo>
                  <a:cubicBezTo>
                    <a:pt x="-2117" y="2161939"/>
                    <a:pt x="-2117" y="2227555"/>
                    <a:pt x="0" y="2286822"/>
                  </a:cubicBezTo>
                  <a:cubicBezTo>
                    <a:pt x="2117" y="2346089"/>
                    <a:pt x="4233" y="2415939"/>
                    <a:pt x="12700" y="2464622"/>
                  </a:cubicBezTo>
                  <a:cubicBezTo>
                    <a:pt x="21167" y="2513305"/>
                    <a:pt x="29633" y="2547172"/>
                    <a:pt x="50800" y="2578922"/>
                  </a:cubicBezTo>
                  <a:cubicBezTo>
                    <a:pt x="71967" y="2610672"/>
                    <a:pt x="107950" y="2621255"/>
                    <a:pt x="139700" y="2655122"/>
                  </a:cubicBezTo>
                  <a:cubicBezTo>
                    <a:pt x="171450" y="2688989"/>
                    <a:pt x="194733" y="2739789"/>
                    <a:pt x="241300" y="2782122"/>
                  </a:cubicBezTo>
                  <a:cubicBezTo>
                    <a:pt x="287867" y="2824455"/>
                    <a:pt x="355600" y="2883722"/>
                    <a:pt x="419100" y="2909122"/>
                  </a:cubicBezTo>
                  <a:cubicBezTo>
                    <a:pt x="482600" y="2934522"/>
                    <a:pt x="554567" y="2930289"/>
                    <a:pt x="622300" y="2934522"/>
                  </a:cubicBezTo>
                  <a:cubicBezTo>
                    <a:pt x="690033" y="2938755"/>
                    <a:pt x="766233" y="2949339"/>
                    <a:pt x="825500" y="2934522"/>
                  </a:cubicBezTo>
                  <a:cubicBezTo>
                    <a:pt x="884767" y="2919705"/>
                    <a:pt x="935567" y="2877372"/>
                    <a:pt x="977900" y="2845622"/>
                  </a:cubicBezTo>
                  <a:cubicBezTo>
                    <a:pt x="1020233" y="2813872"/>
                    <a:pt x="1049867" y="2786355"/>
                    <a:pt x="1079500" y="2744022"/>
                  </a:cubicBezTo>
                  <a:cubicBezTo>
                    <a:pt x="1109133" y="2701689"/>
                    <a:pt x="1134533" y="2644539"/>
                    <a:pt x="1155700" y="2591622"/>
                  </a:cubicBezTo>
                  <a:cubicBezTo>
                    <a:pt x="1176867" y="2538705"/>
                    <a:pt x="1189567" y="2487905"/>
                    <a:pt x="1206500" y="2426522"/>
                  </a:cubicBezTo>
                  <a:cubicBezTo>
                    <a:pt x="1223433" y="2365139"/>
                    <a:pt x="1234017" y="2297405"/>
                    <a:pt x="1257300" y="2223322"/>
                  </a:cubicBezTo>
                  <a:cubicBezTo>
                    <a:pt x="1280583" y="2149239"/>
                    <a:pt x="1331383" y="2058222"/>
                    <a:pt x="1346200" y="1982022"/>
                  </a:cubicBezTo>
                  <a:cubicBezTo>
                    <a:pt x="1361017" y="1905822"/>
                    <a:pt x="1346200" y="1766122"/>
                    <a:pt x="1346200" y="1766122"/>
                  </a:cubicBezTo>
                  <a:cubicBezTo>
                    <a:pt x="1346200" y="1700505"/>
                    <a:pt x="1341967" y="1685689"/>
                    <a:pt x="1346200" y="1588322"/>
                  </a:cubicBezTo>
                  <a:cubicBezTo>
                    <a:pt x="1350433" y="1490955"/>
                    <a:pt x="1367367" y="1289872"/>
                    <a:pt x="1371600" y="1181922"/>
                  </a:cubicBezTo>
                  <a:cubicBezTo>
                    <a:pt x="1375833" y="1073972"/>
                    <a:pt x="1371600" y="940622"/>
                    <a:pt x="1371600" y="940622"/>
                  </a:cubicBezTo>
                  <a:lnTo>
                    <a:pt x="1371600" y="750122"/>
                  </a:lnTo>
                  <a:cubicBezTo>
                    <a:pt x="1371600" y="686622"/>
                    <a:pt x="1373717" y="640055"/>
                    <a:pt x="1371600" y="559622"/>
                  </a:cubicBezTo>
                  <a:cubicBezTo>
                    <a:pt x="1369483" y="479189"/>
                    <a:pt x="1363133" y="354305"/>
                    <a:pt x="1358900" y="267522"/>
                  </a:cubicBezTo>
                  <a:cubicBezTo>
                    <a:pt x="1354667" y="180739"/>
                    <a:pt x="1356783" y="13522"/>
                    <a:pt x="1333500" y="822"/>
                  </a:cubicBezTo>
                  <a:close/>
                </a:path>
              </a:pathLst>
            </a:custGeom>
            <a:noFill/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207">
                <a:solidFill>
                  <a:schemeClr val="tx1"/>
                </a:solidFill>
              </a:endParaRPr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385D86C5-F509-0B4E-A1CC-24287EDC4714}"/>
                </a:ext>
              </a:extLst>
            </p:cNvPr>
            <p:cNvSpPr/>
            <p:nvPr/>
          </p:nvSpPr>
          <p:spPr>
            <a:xfrm>
              <a:off x="2893000" y="4196432"/>
              <a:ext cx="587459" cy="516111"/>
            </a:xfrm>
            <a:custGeom>
              <a:avLst/>
              <a:gdLst>
                <a:gd name="connsiteX0" fmla="*/ 584637 w 587459"/>
                <a:gd name="connsiteY0" fmla="*/ 55503 h 516111"/>
                <a:gd name="connsiteX1" fmla="*/ 559237 w 587459"/>
                <a:gd name="connsiteY1" fmla="*/ 220603 h 516111"/>
                <a:gd name="connsiteX2" fmla="*/ 381437 w 587459"/>
                <a:gd name="connsiteY2" fmla="*/ 436503 h 516111"/>
                <a:gd name="connsiteX3" fmla="*/ 190937 w 587459"/>
                <a:gd name="connsiteY3" fmla="*/ 500003 h 516111"/>
                <a:gd name="connsiteX4" fmla="*/ 63937 w 587459"/>
                <a:gd name="connsiteY4" fmla="*/ 512703 h 516111"/>
                <a:gd name="connsiteX5" fmla="*/ 437 w 587459"/>
                <a:gd name="connsiteY5" fmla="*/ 449203 h 516111"/>
                <a:gd name="connsiteX6" fmla="*/ 38537 w 587459"/>
                <a:gd name="connsiteY6" fmla="*/ 347603 h 516111"/>
                <a:gd name="connsiteX7" fmla="*/ 89337 w 587459"/>
                <a:gd name="connsiteY7" fmla="*/ 258703 h 516111"/>
                <a:gd name="connsiteX8" fmla="*/ 229037 w 587459"/>
                <a:gd name="connsiteY8" fmla="*/ 169803 h 516111"/>
                <a:gd name="connsiteX9" fmla="*/ 356037 w 587459"/>
                <a:gd name="connsiteY9" fmla="*/ 68203 h 516111"/>
                <a:gd name="connsiteX10" fmla="*/ 495737 w 587459"/>
                <a:gd name="connsiteY10" fmla="*/ 4703 h 516111"/>
                <a:gd name="connsiteX11" fmla="*/ 584637 w 587459"/>
                <a:gd name="connsiteY11" fmla="*/ 4703 h 516111"/>
                <a:gd name="connsiteX12" fmla="*/ 584637 w 587459"/>
                <a:gd name="connsiteY12" fmla="*/ 4703 h 516111"/>
                <a:gd name="connsiteX13" fmla="*/ 508437 w 587459"/>
                <a:gd name="connsiteY13" fmla="*/ 322203 h 5161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587459" h="516111">
                  <a:moveTo>
                    <a:pt x="584637" y="55503"/>
                  </a:moveTo>
                  <a:cubicBezTo>
                    <a:pt x="588870" y="106303"/>
                    <a:pt x="593104" y="157103"/>
                    <a:pt x="559237" y="220603"/>
                  </a:cubicBezTo>
                  <a:cubicBezTo>
                    <a:pt x="525370" y="284103"/>
                    <a:pt x="442820" y="389936"/>
                    <a:pt x="381437" y="436503"/>
                  </a:cubicBezTo>
                  <a:cubicBezTo>
                    <a:pt x="320054" y="483070"/>
                    <a:pt x="243854" y="487303"/>
                    <a:pt x="190937" y="500003"/>
                  </a:cubicBezTo>
                  <a:cubicBezTo>
                    <a:pt x="138020" y="512703"/>
                    <a:pt x="95687" y="521170"/>
                    <a:pt x="63937" y="512703"/>
                  </a:cubicBezTo>
                  <a:cubicBezTo>
                    <a:pt x="32187" y="504236"/>
                    <a:pt x="4670" y="476720"/>
                    <a:pt x="437" y="449203"/>
                  </a:cubicBezTo>
                  <a:cubicBezTo>
                    <a:pt x="-3796" y="421686"/>
                    <a:pt x="23720" y="379353"/>
                    <a:pt x="38537" y="347603"/>
                  </a:cubicBezTo>
                  <a:cubicBezTo>
                    <a:pt x="53354" y="315853"/>
                    <a:pt x="57587" y="288336"/>
                    <a:pt x="89337" y="258703"/>
                  </a:cubicBezTo>
                  <a:cubicBezTo>
                    <a:pt x="121087" y="229070"/>
                    <a:pt x="184587" y="201553"/>
                    <a:pt x="229037" y="169803"/>
                  </a:cubicBezTo>
                  <a:cubicBezTo>
                    <a:pt x="273487" y="138053"/>
                    <a:pt x="311587" y="95720"/>
                    <a:pt x="356037" y="68203"/>
                  </a:cubicBezTo>
                  <a:cubicBezTo>
                    <a:pt x="400487" y="40686"/>
                    <a:pt x="457637" y="15286"/>
                    <a:pt x="495737" y="4703"/>
                  </a:cubicBezTo>
                  <a:cubicBezTo>
                    <a:pt x="533837" y="-5880"/>
                    <a:pt x="584637" y="4703"/>
                    <a:pt x="584637" y="4703"/>
                  </a:cubicBezTo>
                  <a:lnTo>
                    <a:pt x="584637" y="4703"/>
                  </a:lnTo>
                  <a:lnTo>
                    <a:pt x="508437" y="322203"/>
                  </a:lnTo>
                </a:path>
              </a:pathLst>
            </a:custGeom>
            <a:ln w="9525">
              <a:solidFill>
                <a:schemeClr val="bg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63" name="Freeform 62">
              <a:extLst>
                <a:ext uri="{FF2B5EF4-FFF2-40B4-BE49-F238E27FC236}">
                  <a16:creationId xmlns:a16="http://schemas.microsoft.com/office/drawing/2014/main" id="{2C12D079-B5CE-9B4E-8E7B-48BD2501E5F9}"/>
                </a:ext>
              </a:extLst>
            </p:cNvPr>
            <p:cNvSpPr/>
            <p:nvPr/>
          </p:nvSpPr>
          <p:spPr>
            <a:xfrm>
              <a:off x="3718804" y="3451417"/>
              <a:ext cx="331273" cy="331051"/>
            </a:xfrm>
            <a:custGeom>
              <a:avLst/>
              <a:gdLst>
                <a:gd name="connsiteX0" fmla="*/ 177933 w 331273"/>
                <a:gd name="connsiteY0" fmla="*/ 279818 h 331051"/>
                <a:gd name="connsiteX1" fmla="*/ 50933 w 331273"/>
                <a:gd name="connsiteY1" fmla="*/ 330618 h 331051"/>
                <a:gd name="connsiteX2" fmla="*/ 133 w 331273"/>
                <a:gd name="connsiteY2" fmla="*/ 254418 h 331051"/>
                <a:gd name="connsiteX3" fmla="*/ 63633 w 331273"/>
                <a:gd name="connsiteY3" fmla="*/ 152818 h 331051"/>
                <a:gd name="connsiteX4" fmla="*/ 203333 w 331273"/>
                <a:gd name="connsiteY4" fmla="*/ 13118 h 331051"/>
                <a:gd name="connsiteX5" fmla="*/ 317633 w 331273"/>
                <a:gd name="connsiteY5" fmla="*/ 13118 h 331051"/>
                <a:gd name="connsiteX6" fmla="*/ 330333 w 331273"/>
                <a:gd name="connsiteY6" fmla="*/ 76618 h 331051"/>
                <a:gd name="connsiteX7" fmla="*/ 330333 w 331273"/>
                <a:gd name="connsiteY7" fmla="*/ 114718 h 331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1273" h="331051">
                  <a:moveTo>
                    <a:pt x="177933" y="279818"/>
                  </a:moveTo>
                  <a:cubicBezTo>
                    <a:pt x="129249" y="307334"/>
                    <a:pt x="80566" y="334851"/>
                    <a:pt x="50933" y="330618"/>
                  </a:cubicBezTo>
                  <a:cubicBezTo>
                    <a:pt x="21300" y="326385"/>
                    <a:pt x="-1984" y="284051"/>
                    <a:pt x="133" y="254418"/>
                  </a:cubicBezTo>
                  <a:cubicBezTo>
                    <a:pt x="2250" y="224785"/>
                    <a:pt x="29766" y="193035"/>
                    <a:pt x="63633" y="152818"/>
                  </a:cubicBezTo>
                  <a:cubicBezTo>
                    <a:pt x="97500" y="112601"/>
                    <a:pt x="161000" y="36401"/>
                    <a:pt x="203333" y="13118"/>
                  </a:cubicBezTo>
                  <a:cubicBezTo>
                    <a:pt x="245666" y="-10165"/>
                    <a:pt x="296466" y="2535"/>
                    <a:pt x="317633" y="13118"/>
                  </a:cubicBezTo>
                  <a:cubicBezTo>
                    <a:pt x="338800" y="23701"/>
                    <a:pt x="328216" y="59685"/>
                    <a:pt x="330333" y="76618"/>
                  </a:cubicBezTo>
                  <a:cubicBezTo>
                    <a:pt x="332450" y="93551"/>
                    <a:pt x="330333" y="114718"/>
                    <a:pt x="330333" y="114718"/>
                  </a:cubicBezTo>
                </a:path>
              </a:pathLst>
            </a:custGeom>
            <a:ln w="9525">
              <a:solidFill>
                <a:schemeClr val="bg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E43F7AAF-1BAC-B047-8383-975D76D7A9A6}"/>
                </a:ext>
              </a:extLst>
            </p:cNvPr>
            <p:cNvSpPr/>
            <p:nvPr/>
          </p:nvSpPr>
          <p:spPr>
            <a:xfrm>
              <a:off x="4734937" y="3451731"/>
              <a:ext cx="190970" cy="787504"/>
            </a:xfrm>
            <a:custGeom>
              <a:avLst/>
              <a:gdLst>
                <a:gd name="connsiteX0" fmla="*/ 0 w 190970"/>
                <a:gd name="connsiteY0" fmla="*/ 787504 h 787504"/>
                <a:gd name="connsiteX1" fmla="*/ 177800 w 190970"/>
                <a:gd name="connsiteY1" fmla="*/ 698604 h 787504"/>
                <a:gd name="connsiteX2" fmla="*/ 177800 w 190970"/>
                <a:gd name="connsiteY2" fmla="*/ 482704 h 787504"/>
                <a:gd name="connsiteX3" fmla="*/ 177800 w 190970"/>
                <a:gd name="connsiteY3" fmla="*/ 292204 h 787504"/>
                <a:gd name="connsiteX4" fmla="*/ 127000 w 190970"/>
                <a:gd name="connsiteY4" fmla="*/ 89004 h 787504"/>
                <a:gd name="connsiteX5" fmla="*/ 38100 w 190970"/>
                <a:gd name="connsiteY5" fmla="*/ 12804 h 787504"/>
                <a:gd name="connsiteX6" fmla="*/ 0 w 190970"/>
                <a:gd name="connsiteY6" fmla="*/ 104 h 787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0970" h="787504">
                  <a:moveTo>
                    <a:pt x="0" y="787504"/>
                  </a:moveTo>
                  <a:cubicBezTo>
                    <a:pt x="74083" y="768454"/>
                    <a:pt x="148167" y="749404"/>
                    <a:pt x="177800" y="698604"/>
                  </a:cubicBezTo>
                  <a:cubicBezTo>
                    <a:pt x="207433" y="647804"/>
                    <a:pt x="177800" y="482704"/>
                    <a:pt x="177800" y="482704"/>
                  </a:cubicBezTo>
                  <a:cubicBezTo>
                    <a:pt x="177800" y="414971"/>
                    <a:pt x="186267" y="357821"/>
                    <a:pt x="177800" y="292204"/>
                  </a:cubicBezTo>
                  <a:cubicBezTo>
                    <a:pt x="169333" y="226587"/>
                    <a:pt x="150283" y="135571"/>
                    <a:pt x="127000" y="89004"/>
                  </a:cubicBezTo>
                  <a:cubicBezTo>
                    <a:pt x="103717" y="42437"/>
                    <a:pt x="59267" y="27621"/>
                    <a:pt x="38100" y="12804"/>
                  </a:cubicBezTo>
                  <a:cubicBezTo>
                    <a:pt x="16933" y="-2013"/>
                    <a:pt x="0" y="104"/>
                    <a:pt x="0" y="104"/>
                  </a:cubicBezTo>
                </a:path>
              </a:pathLst>
            </a:custGeom>
            <a:ln w="9525">
              <a:solidFill>
                <a:schemeClr val="bg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id="{3578CC22-B6CB-374F-AC4D-B390A9ECD3D1}"/>
                </a:ext>
              </a:extLst>
            </p:cNvPr>
            <p:cNvSpPr/>
            <p:nvPr/>
          </p:nvSpPr>
          <p:spPr>
            <a:xfrm>
              <a:off x="1273237" y="3566135"/>
              <a:ext cx="331273" cy="331051"/>
            </a:xfrm>
            <a:custGeom>
              <a:avLst/>
              <a:gdLst>
                <a:gd name="connsiteX0" fmla="*/ 177933 w 331273"/>
                <a:gd name="connsiteY0" fmla="*/ 279818 h 331051"/>
                <a:gd name="connsiteX1" fmla="*/ 50933 w 331273"/>
                <a:gd name="connsiteY1" fmla="*/ 330618 h 331051"/>
                <a:gd name="connsiteX2" fmla="*/ 133 w 331273"/>
                <a:gd name="connsiteY2" fmla="*/ 254418 h 331051"/>
                <a:gd name="connsiteX3" fmla="*/ 63633 w 331273"/>
                <a:gd name="connsiteY3" fmla="*/ 152818 h 331051"/>
                <a:gd name="connsiteX4" fmla="*/ 203333 w 331273"/>
                <a:gd name="connsiteY4" fmla="*/ 13118 h 331051"/>
                <a:gd name="connsiteX5" fmla="*/ 317633 w 331273"/>
                <a:gd name="connsiteY5" fmla="*/ 13118 h 331051"/>
                <a:gd name="connsiteX6" fmla="*/ 330333 w 331273"/>
                <a:gd name="connsiteY6" fmla="*/ 76618 h 331051"/>
                <a:gd name="connsiteX7" fmla="*/ 330333 w 331273"/>
                <a:gd name="connsiteY7" fmla="*/ 114718 h 331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31273" h="331051">
                  <a:moveTo>
                    <a:pt x="177933" y="279818"/>
                  </a:moveTo>
                  <a:cubicBezTo>
                    <a:pt x="129249" y="307334"/>
                    <a:pt x="80566" y="334851"/>
                    <a:pt x="50933" y="330618"/>
                  </a:cubicBezTo>
                  <a:cubicBezTo>
                    <a:pt x="21300" y="326385"/>
                    <a:pt x="-1984" y="284051"/>
                    <a:pt x="133" y="254418"/>
                  </a:cubicBezTo>
                  <a:cubicBezTo>
                    <a:pt x="2250" y="224785"/>
                    <a:pt x="29766" y="193035"/>
                    <a:pt x="63633" y="152818"/>
                  </a:cubicBezTo>
                  <a:cubicBezTo>
                    <a:pt x="97500" y="112601"/>
                    <a:pt x="161000" y="36401"/>
                    <a:pt x="203333" y="13118"/>
                  </a:cubicBezTo>
                  <a:cubicBezTo>
                    <a:pt x="245666" y="-10165"/>
                    <a:pt x="296466" y="2535"/>
                    <a:pt x="317633" y="13118"/>
                  </a:cubicBezTo>
                  <a:cubicBezTo>
                    <a:pt x="338800" y="23701"/>
                    <a:pt x="328216" y="59685"/>
                    <a:pt x="330333" y="76618"/>
                  </a:cubicBezTo>
                  <a:cubicBezTo>
                    <a:pt x="332450" y="93551"/>
                    <a:pt x="330333" y="114718"/>
                    <a:pt x="330333" y="114718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1B20415B-4ADE-4F42-84CB-CD636EAB8DD3}"/>
                </a:ext>
              </a:extLst>
            </p:cNvPr>
            <p:cNvSpPr/>
            <p:nvPr/>
          </p:nvSpPr>
          <p:spPr>
            <a:xfrm>
              <a:off x="816037" y="2804135"/>
              <a:ext cx="1373481" cy="2942152"/>
            </a:xfrm>
            <a:custGeom>
              <a:avLst/>
              <a:gdLst>
                <a:gd name="connsiteX0" fmla="*/ 1333500 w 1373481"/>
                <a:gd name="connsiteY0" fmla="*/ 822 h 2942152"/>
                <a:gd name="connsiteX1" fmla="*/ 1219200 w 1373481"/>
                <a:gd name="connsiteY1" fmla="*/ 191322 h 2942152"/>
                <a:gd name="connsiteX2" fmla="*/ 1079500 w 1373481"/>
                <a:gd name="connsiteY2" fmla="*/ 394522 h 2942152"/>
                <a:gd name="connsiteX3" fmla="*/ 939800 w 1373481"/>
                <a:gd name="connsiteY3" fmla="*/ 572322 h 2942152"/>
                <a:gd name="connsiteX4" fmla="*/ 850900 w 1373481"/>
                <a:gd name="connsiteY4" fmla="*/ 712022 h 2942152"/>
                <a:gd name="connsiteX5" fmla="*/ 787400 w 1373481"/>
                <a:gd name="connsiteY5" fmla="*/ 813622 h 2942152"/>
                <a:gd name="connsiteX6" fmla="*/ 736600 w 1373481"/>
                <a:gd name="connsiteY6" fmla="*/ 940622 h 2942152"/>
                <a:gd name="connsiteX7" fmla="*/ 647700 w 1373481"/>
                <a:gd name="connsiteY7" fmla="*/ 1029522 h 2942152"/>
                <a:gd name="connsiteX8" fmla="*/ 406400 w 1373481"/>
                <a:gd name="connsiteY8" fmla="*/ 1308922 h 2942152"/>
                <a:gd name="connsiteX9" fmla="*/ 317500 w 1373481"/>
                <a:gd name="connsiteY9" fmla="*/ 1435922 h 2942152"/>
                <a:gd name="connsiteX10" fmla="*/ 139700 w 1373481"/>
                <a:gd name="connsiteY10" fmla="*/ 1664522 h 2942152"/>
                <a:gd name="connsiteX11" fmla="*/ 88900 w 1373481"/>
                <a:gd name="connsiteY11" fmla="*/ 1829622 h 2942152"/>
                <a:gd name="connsiteX12" fmla="*/ 12700 w 1373481"/>
                <a:gd name="connsiteY12" fmla="*/ 1969322 h 2942152"/>
                <a:gd name="connsiteX13" fmla="*/ 0 w 1373481"/>
                <a:gd name="connsiteY13" fmla="*/ 2109022 h 2942152"/>
                <a:gd name="connsiteX14" fmla="*/ 0 w 1373481"/>
                <a:gd name="connsiteY14" fmla="*/ 2286822 h 2942152"/>
                <a:gd name="connsiteX15" fmla="*/ 12700 w 1373481"/>
                <a:gd name="connsiteY15" fmla="*/ 2464622 h 2942152"/>
                <a:gd name="connsiteX16" fmla="*/ 50800 w 1373481"/>
                <a:gd name="connsiteY16" fmla="*/ 2578922 h 2942152"/>
                <a:gd name="connsiteX17" fmla="*/ 139700 w 1373481"/>
                <a:gd name="connsiteY17" fmla="*/ 2655122 h 2942152"/>
                <a:gd name="connsiteX18" fmla="*/ 241300 w 1373481"/>
                <a:gd name="connsiteY18" fmla="*/ 2782122 h 2942152"/>
                <a:gd name="connsiteX19" fmla="*/ 419100 w 1373481"/>
                <a:gd name="connsiteY19" fmla="*/ 2909122 h 2942152"/>
                <a:gd name="connsiteX20" fmla="*/ 622300 w 1373481"/>
                <a:gd name="connsiteY20" fmla="*/ 2934522 h 2942152"/>
                <a:gd name="connsiteX21" fmla="*/ 825500 w 1373481"/>
                <a:gd name="connsiteY21" fmla="*/ 2934522 h 2942152"/>
                <a:gd name="connsiteX22" fmla="*/ 977900 w 1373481"/>
                <a:gd name="connsiteY22" fmla="*/ 2845622 h 2942152"/>
                <a:gd name="connsiteX23" fmla="*/ 1079500 w 1373481"/>
                <a:gd name="connsiteY23" fmla="*/ 2744022 h 2942152"/>
                <a:gd name="connsiteX24" fmla="*/ 1155700 w 1373481"/>
                <a:gd name="connsiteY24" fmla="*/ 2591622 h 2942152"/>
                <a:gd name="connsiteX25" fmla="*/ 1206500 w 1373481"/>
                <a:gd name="connsiteY25" fmla="*/ 2426522 h 2942152"/>
                <a:gd name="connsiteX26" fmla="*/ 1257300 w 1373481"/>
                <a:gd name="connsiteY26" fmla="*/ 2223322 h 2942152"/>
                <a:gd name="connsiteX27" fmla="*/ 1346200 w 1373481"/>
                <a:gd name="connsiteY27" fmla="*/ 1982022 h 2942152"/>
                <a:gd name="connsiteX28" fmla="*/ 1346200 w 1373481"/>
                <a:gd name="connsiteY28" fmla="*/ 1766122 h 2942152"/>
                <a:gd name="connsiteX29" fmla="*/ 1346200 w 1373481"/>
                <a:gd name="connsiteY29" fmla="*/ 1588322 h 2942152"/>
                <a:gd name="connsiteX30" fmla="*/ 1371600 w 1373481"/>
                <a:gd name="connsiteY30" fmla="*/ 1181922 h 2942152"/>
                <a:gd name="connsiteX31" fmla="*/ 1371600 w 1373481"/>
                <a:gd name="connsiteY31" fmla="*/ 940622 h 2942152"/>
                <a:gd name="connsiteX32" fmla="*/ 1371600 w 1373481"/>
                <a:gd name="connsiteY32" fmla="*/ 750122 h 2942152"/>
                <a:gd name="connsiteX33" fmla="*/ 1371600 w 1373481"/>
                <a:gd name="connsiteY33" fmla="*/ 559622 h 2942152"/>
                <a:gd name="connsiteX34" fmla="*/ 1358900 w 1373481"/>
                <a:gd name="connsiteY34" fmla="*/ 267522 h 2942152"/>
                <a:gd name="connsiteX35" fmla="*/ 1333500 w 1373481"/>
                <a:gd name="connsiteY35" fmla="*/ 822 h 29421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1373481" h="2942152">
                  <a:moveTo>
                    <a:pt x="1333500" y="822"/>
                  </a:moveTo>
                  <a:cubicBezTo>
                    <a:pt x="1310217" y="-11878"/>
                    <a:pt x="1261533" y="125705"/>
                    <a:pt x="1219200" y="191322"/>
                  </a:cubicBezTo>
                  <a:cubicBezTo>
                    <a:pt x="1176867" y="256939"/>
                    <a:pt x="1126067" y="331022"/>
                    <a:pt x="1079500" y="394522"/>
                  </a:cubicBezTo>
                  <a:cubicBezTo>
                    <a:pt x="1032933" y="458022"/>
                    <a:pt x="977900" y="519405"/>
                    <a:pt x="939800" y="572322"/>
                  </a:cubicBezTo>
                  <a:cubicBezTo>
                    <a:pt x="901700" y="625239"/>
                    <a:pt x="876300" y="671805"/>
                    <a:pt x="850900" y="712022"/>
                  </a:cubicBezTo>
                  <a:cubicBezTo>
                    <a:pt x="825500" y="752239"/>
                    <a:pt x="806450" y="775522"/>
                    <a:pt x="787400" y="813622"/>
                  </a:cubicBezTo>
                  <a:cubicBezTo>
                    <a:pt x="768350" y="851722"/>
                    <a:pt x="759883" y="904639"/>
                    <a:pt x="736600" y="940622"/>
                  </a:cubicBezTo>
                  <a:cubicBezTo>
                    <a:pt x="713317" y="976605"/>
                    <a:pt x="702733" y="968139"/>
                    <a:pt x="647700" y="1029522"/>
                  </a:cubicBezTo>
                  <a:cubicBezTo>
                    <a:pt x="592667" y="1090905"/>
                    <a:pt x="461433" y="1241189"/>
                    <a:pt x="406400" y="1308922"/>
                  </a:cubicBezTo>
                  <a:cubicBezTo>
                    <a:pt x="351367" y="1376655"/>
                    <a:pt x="361950" y="1376655"/>
                    <a:pt x="317500" y="1435922"/>
                  </a:cubicBezTo>
                  <a:cubicBezTo>
                    <a:pt x="273050" y="1495189"/>
                    <a:pt x="177800" y="1598905"/>
                    <a:pt x="139700" y="1664522"/>
                  </a:cubicBezTo>
                  <a:cubicBezTo>
                    <a:pt x="101600" y="1730139"/>
                    <a:pt x="110067" y="1778822"/>
                    <a:pt x="88900" y="1829622"/>
                  </a:cubicBezTo>
                  <a:cubicBezTo>
                    <a:pt x="67733" y="1880422"/>
                    <a:pt x="27517" y="1922755"/>
                    <a:pt x="12700" y="1969322"/>
                  </a:cubicBezTo>
                  <a:cubicBezTo>
                    <a:pt x="-2117" y="2015889"/>
                    <a:pt x="2117" y="2056105"/>
                    <a:pt x="0" y="2109022"/>
                  </a:cubicBezTo>
                  <a:cubicBezTo>
                    <a:pt x="-2117" y="2161939"/>
                    <a:pt x="-2117" y="2227555"/>
                    <a:pt x="0" y="2286822"/>
                  </a:cubicBezTo>
                  <a:cubicBezTo>
                    <a:pt x="2117" y="2346089"/>
                    <a:pt x="4233" y="2415939"/>
                    <a:pt x="12700" y="2464622"/>
                  </a:cubicBezTo>
                  <a:cubicBezTo>
                    <a:pt x="21167" y="2513305"/>
                    <a:pt x="29633" y="2547172"/>
                    <a:pt x="50800" y="2578922"/>
                  </a:cubicBezTo>
                  <a:cubicBezTo>
                    <a:pt x="71967" y="2610672"/>
                    <a:pt x="107950" y="2621255"/>
                    <a:pt x="139700" y="2655122"/>
                  </a:cubicBezTo>
                  <a:cubicBezTo>
                    <a:pt x="171450" y="2688989"/>
                    <a:pt x="194733" y="2739789"/>
                    <a:pt x="241300" y="2782122"/>
                  </a:cubicBezTo>
                  <a:cubicBezTo>
                    <a:pt x="287867" y="2824455"/>
                    <a:pt x="355600" y="2883722"/>
                    <a:pt x="419100" y="2909122"/>
                  </a:cubicBezTo>
                  <a:cubicBezTo>
                    <a:pt x="482600" y="2934522"/>
                    <a:pt x="554567" y="2930289"/>
                    <a:pt x="622300" y="2934522"/>
                  </a:cubicBezTo>
                  <a:cubicBezTo>
                    <a:pt x="690033" y="2938755"/>
                    <a:pt x="766233" y="2949339"/>
                    <a:pt x="825500" y="2934522"/>
                  </a:cubicBezTo>
                  <a:cubicBezTo>
                    <a:pt x="884767" y="2919705"/>
                    <a:pt x="935567" y="2877372"/>
                    <a:pt x="977900" y="2845622"/>
                  </a:cubicBezTo>
                  <a:cubicBezTo>
                    <a:pt x="1020233" y="2813872"/>
                    <a:pt x="1049867" y="2786355"/>
                    <a:pt x="1079500" y="2744022"/>
                  </a:cubicBezTo>
                  <a:cubicBezTo>
                    <a:pt x="1109133" y="2701689"/>
                    <a:pt x="1134533" y="2644539"/>
                    <a:pt x="1155700" y="2591622"/>
                  </a:cubicBezTo>
                  <a:cubicBezTo>
                    <a:pt x="1176867" y="2538705"/>
                    <a:pt x="1189567" y="2487905"/>
                    <a:pt x="1206500" y="2426522"/>
                  </a:cubicBezTo>
                  <a:cubicBezTo>
                    <a:pt x="1223433" y="2365139"/>
                    <a:pt x="1234017" y="2297405"/>
                    <a:pt x="1257300" y="2223322"/>
                  </a:cubicBezTo>
                  <a:cubicBezTo>
                    <a:pt x="1280583" y="2149239"/>
                    <a:pt x="1331383" y="2058222"/>
                    <a:pt x="1346200" y="1982022"/>
                  </a:cubicBezTo>
                  <a:cubicBezTo>
                    <a:pt x="1361017" y="1905822"/>
                    <a:pt x="1346200" y="1766122"/>
                    <a:pt x="1346200" y="1766122"/>
                  </a:cubicBezTo>
                  <a:cubicBezTo>
                    <a:pt x="1346200" y="1700505"/>
                    <a:pt x="1341967" y="1685689"/>
                    <a:pt x="1346200" y="1588322"/>
                  </a:cubicBezTo>
                  <a:cubicBezTo>
                    <a:pt x="1350433" y="1490955"/>
                    <a:pt x="1367367" y="1289872"/>
                    <a:pt x="1371600" y="1181922"/>
                  </a:cubicBezTo>
                  <a:cubicBezTo>
                    <a:pt x="1375833" y="1073972"/>
                    <a:pt x="1371600" y="940622"/>
                    <a:pt x="1371600" y="940622"/>
                  </a:cubicBezTo>
                  <a:lnTo>
                    <a:pt x="1371600" y="750122"/>
                  </a:lnTo>
                  <a:cubicBezTo>
                    <a:pt x="1371600" y="686622"/>
                    <a:pt x="1373717" y="640055"/>
                    <a:pt x="1371600" y="559622"/>
                  </a:cubicBezTo>
                  <a:cubicBezTo>
                    <a:pt x="1369483" y="479189"/>
                    <a:pt x="1363133" y="354305"/>
                    <a:pt x="1358900" y="267522"/>
                  </a:cubicBezTo>
                  <a:cubicBezTo>
                    <a:pt x="1354667" y="180739"/>
                    <a:pt x="1356783" y="13522"/>
                    <a:pt x="1333500" y="822"/>
                  </a:cubicBezTo>
                  <a:close/>
                </a:path>
              </a:pathLst>
            </a:custGeom>
            <a:noFill/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207">
                <a:solidFill>
                  <a:schemeClr val="tx1"/>
                </a:solidFill>
              </a:endParaRPr>
            </a:p>
          </p:txBody>
        </p:sp>
        <p:sp>
          <p:nvSpPr>
            <p:cNvPr id="67" name="Freeform 66">
              <a:extLst>
                <a:ext uri="{FF2B5EF4-FFF2-40B4-BE49-F238E27FC236}">
                  <a16:creationId xmlns:a16="http://schemas.microsoft.com/office/drawing/2014/main" id="{97196FCC-08E3-1847-81E0-586C118C5612}"/>
                </a:ext>
              </a:extLst>
            </p:cNvPr>
            <p:cNvSpPr/>
            <p:nvPr/>
          </p:nvSpPr>
          <p:spPr>
            <a:xfrm>
              <a:off x="457178" y="4193024"/>
              <a:ext cx="587459" cy="516111"/>
            </a:xfrm>
            <a:custGeom>
              <a:avLst/>
              <a:gdLst>
                <a:gd name="connsiteX0" fmla="*/ 584637 w 587459"/>
                <a:gd name="connsiteY0" fmla="*/ 55503 h 516111"/>
                <a:gd name="connsiteX1" fmla="*/ 559237 w 587459"/>
                <a:gd name="connsiteY1" fmla="*/ 220603 h 516111"/>
                <a:gd name="connsiteX2" fmla="*/ 381437 w 587459"/>
                <a:gd name="connsiteY2" fmla="*/ 436503 h 516111"/>
                <a:gd name="connsiteX3" fmla="*/ 190937 w 587459"/>
                <a:gd name="connsiteY3" fmla="*/ 500003 h 516111"/>
                <a:gd name="connsiteX4" fmla="*/ 63937 w 587459"/>
                <a:gd name="connsiteY4" fmla="*/ 512703 h 516111"/>
                <a:gd name="connsiteX5" fmla="*/ 437 w 587459"/>
                <a:gd name="connsiteY5" fmla="*/ 449203 h 516111"/>
                <a:gd name="connsiteX6" fmla="*/ 38537 w 587459"/>
                <a:gd name="connsiteY6" fmla="*/ 347603 h 516111"/>
                <a:gd name="connsiteX7" fmla="*/ 89337 w 587459"/>
                <a:gd name="connsiteY7" fmla="*/ 258703 h 516111"/>
                <a:gd name="connsiteX8" fmla="*/ 229037 w 587459"/>
                <a:gd name="connsiteY8" fmla="*/ 169803 h 516111"/>
                <a:gd name="connsiteX9" fmla="*/ 356037 w 587459"/>
                <a:gd name="connsiteY9" fmla="*/ 68203 h 516111"/>
                <a:gd name="connsiteX10" fmla="*/ 495737 w 587459"/>
                <a:gd name="connsiteY10" fmla="*/ 4703 h 516111"/>
                <a:gd name="connsiteX11" fmla="*/ 584637 w 587459"/>
                <a:gd name="connsiteY11" fmla="*/ 4703 h 516111"/>
                <a:gd name="connsiteX12" fmla="*/ 584637 w 587459"/>
                <a:gd name="connsiteY12" fmla="*/ 4703 h 516111"/>
                <a:gd name="connsiteX13" fmla="*/ 508437 w 587459"/>
                <a:gd name="connsiteY13" fmla="*/ 322203 h 5161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587459" h="516111">
                  <a:moveTo>
                    <a:pt x="584637" y="55503"/>
                  </a:moveTo>
                  <a:cubicBezTo>
                    <a:pt x="588870" y="106303"/>
                    <a:pt x="593104" y="157103"/>
                    <a:pt x="559237" y="220603"/>
                  </a:cubicBezTo>
                  <a:cubicBezTo>
                    <a:pt x="525370" y="284103"/>
                    <a:pt x="442820" y="389936"/>
                    <a:pt x="381437" y="436503"/>
                  </a:cubicBezTo>
                  <a:cubicBezTo>
                    <a:pt x="320054" y="483070"/>
                    <a:pt x="243854" y="487303"/>
                    <a:pt x="190937" y="500003"/>
                  </a:cubicBezTo>
                  <a:cubicBezTo>
                    <a:pt x="138020" y="512703"/>
                    <a:pt x="95687" y="521170"/>
                    <a:pt x="63937" y="512703"/>
                  </a:cubicBezTo>
                  <a:cubicBezTo>
                    <a:pt x="32187" y="504236"/>
                    <a:pt x="4670" y="476720"/>
                    <a:pt x="437" y="449203"/>
                  </a:cubicBezTo>
                  <a:cubicBezTo>
                    <a:pt x="-3796" y="421686"/>
                    <a:pt x="23720" y="379353"/>
                    <a:pt x="38537" y="347603"/>
                  </a:cubicBezTo>
                  <a:cubicBezTo>
                    <a:pt x="53354" y="315853"/>
                    <a:pt x="57587" y="288336"/>
                    <a:pt x="89337" y="258703"/>
                  </a:cubicBezTo>
                  <a:cubicBezTo>
                    <a:pt x="121087" y="229070"/>
                    <a:pt x="184587" y="201553"/>
                    <a:pt x="229037" y="169803"/>
                  </a:cubicBezTo>
                  <a:cubicBezTo>
                    <a:pt x="273487" y="138053"/>
                    <a:pt x="311587" y="95720"/>
                    <a:pt x="356037" y="68203"/>
                  </a:cubicBezTo>
                  <a:cubicBezTo>
                    <a:pt x="400487" y="40686"/>
                    <a:pt x="457637" y="15286"/>
                    <a:pt x="495737" y="4703"/>
                  </a:cubicBezTo>
                  <a:cubicBezTo>
                    <a:pt x="533837" y="-5880"/>
                    <a:pt x="584637" y="4703"/>
                    <a:pt x="584637" y="4703"/>
                  </a:cubicBezTo>
                  <a:lnTo>
                    <a:pt x="584637" y="4703"/>
                  </a:lnTo>
                  <a:lnTo>
                    <a:pt x="508437" y="322203"/>
                  </a:lnTo>
                </a:path>
              </a:pathLst>
            </a:custGeom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C098D1FC-076F-4345-AE96-D37E44A2D658}"/>
                </a:ext>
              </a:extLst>
            </p:cNvPr>
            <p:cNvSpPr/>
            <p:nvPr/>
          </p:nvSpPr>
          <p:spPr>
            <a:xfrm>
              <a:off x="2263837" y="3185135"/>
              <a:ext cx="190970" cy="787504"/>
            </a:xfrm>
            <a:custGeom>
              <a:avLst/>
              <a:gdLst>
                <a:gd name="connsiteX0" fmla="*/ 0 w 190970"/>
                <a:gd name="connsiteY0" fmla="*/ 787504 h 787504"/>
                <a:gd name="connsiteX1" fmla="*/ 177800 w 190970"/>
                <a:gd name="connsiteY1" fmla="*/ 698604 h 787504"/>
                <a:gd name="connsiteX2" fmla="*/ 177800 w 190970"/>
                <a:gd name="connsiteY2" fmla="*/ 482704 h 787504"/>
                <a:gd name="connsiteX3" fmla="*/ 177800 w 190970"/>
                <a:gd name="connsiteY3" fmla="*/ 292204 h 787504"/>
                <a:gd name="connsiteX4" fmla="*/ 127000 w 190970"/>
                <a:gd name="connsiteY4" fmla="*/ 89004 h 787504"/>
                <a:gd name="connsiteX5" fmla="*/ 38100 w 190970"/>
                <a:gd name="connsiteY5" fmla="*/ 12804 h 787504"/>
                <a:gd name="connsiteX6" fmla="*/ 0 w 190970"/>
                <a:gd name="connsiteY6" fmla="*/ 104 h 787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90970" h="787504">
                  <a:moveTo>
                    <a:pt x="0" y="787504"/>
                  </a:moveTo>
                  <a:cubicBezTo>
                    <a:pt x="74083" y="768454"/>
                    <a:pt x="148167" y="749404"/>
                    <a:pt x="177800" y="698604"/>
                  </a:cubicBezTo>
                  <a:cubicBezTo>
                    <a:pt x="207433" y="647804"/>
                    <a:pt x="177800" y="482704"/>
                    <a:pt x="177800" y="482704"/>
                  </a:cubicBezTo>
                  <a:cubicBezTo>
                    <a:pt x="177800" y="414971"/>
                    <a:pt x="186267" y="357821"/>
                    <a:pt x="177800" y="292204"/>
                  </a:cubicBezTo>
                  <a:cubicBezTo>
                    <a:pt x="169333" y="226587"/>
                    <a:pt x="150283" y="135571"/>
                    <a:pt x="127000" y="89004"/>
                  </a:cubicBezTo>
                  <a:cubicBezTo>
                    <a:pt x="103717" y="42437"/>
                    <a:pt x="59267" y="27621"/>
                    <a:pt x="38100" y="12804"/>
                  </a:cubicBezTo>
                  <a:cubicBezTo>
                    <a:pt x="16933" y="-2013"/>
                    <a:pt x="0" y="104"/>
                    <a:pt x="0" y="104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  <p:sp>
          <p:nvSpPr>
            <p:cNvPr id="69" name="テキスト ボックス 12">
              <a:extLst>
                <a:ext uri="{FF2B5EF4-FFF2-40B4-BE49-F238E27FC236}">
                  <a16:creationId xmlns:a16="http://schemas.microsoft.com/office/drawing/2014/main" id="{FB8EB497-9FF8-6449-BF5F-3CB7FD9DE4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31097" y="1828389"/>
              <a:ext cx="2183983" cy="4747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9pPr>
            </a:lstStyle>
            <a:p>
              <a:r>
                <a:rPr lang="en-US" altLang="ja-JP" sz="17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en brain atlas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0DF788EF-1571-FE45-A278-93450809E5C8}"/>
                </a:ext>
              </a:extLst>
            </p:cNvPr>
            <p:cNvSpPr/>
            <p:nvPr/>
          </p:nvSpPr>
          <p:spPr>
            <a:xfrm>
              <a:off x="2853045" y="2619650"/>
              <a:ext cx="1014498" cy="5647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2207" b="1" u="sng" dirty="0"/>
                <a:t>PAC1</a:t>
              </a:r>
            </a:p>
          </p:txBody>
        </p:sp>
      </p:grpSp>
      <p:pic>
        <p:nvPicPr>
          <p:cNvPr id="71" name="Picture 70" descr="A picture containing outdoor object, star, night&#10;&#10;Description automatically generated">
            <a:extLst>
              <a:ext uri="{FF2B5EF4-FFF2-40B4-BE49-F238E27FC236}">
                <a16:creationId xmlns:a16="http://schemas.microsoft.com/office/drawing/2014/main" id="{8861D1A2-EFD9-3048-AD9D-601A2D022BB1}"/>
              </a:ext>
            </a:extLst>
          </p:cNvPr>
          <p:cNvPicPr>
            <a:picLocks noChangeAspect="1"/>
          </p:cNvPicPr>
          <p:nvPr/>
        </p:nvPicPr>
        <p:blipFill>
          <a:blip r:embed="rId15" cstate="screen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82167" y="7068298"/>
            <a:ext cx="2311929" cy="1733947"/>
          </a:xfrm>
          <a:prstGeom prst="rect">
            <a:avLst/>
          </a:prstGeom>
        </p:spPr>
      </p:pic>
      <p:sp>
        <p:nvSpPr>
          <p:cNvPr id="74" name="TextBox 73">
            <a:extLst>
              <a:ext uri="{FF2B5EF4-FFF2-40B4-BE49-F238E27FC236}">
                <a16:creationId xmlns:a16="http://schemas.microsoft.com/office/drawing/2014/main" id="{4E9C90E2-C84C-684F-B88F-A8179B828ADF}"/>
              </a:ext>
            </a:extLst>
          </p:cNvPr>
          <p:cNvSpPr txBox="1"/>
          <p:nvPr/>
        </p:nvSpPr>
        <p:spPr>
          <a:xfrm>
            <a:off x="302063" y="365914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FC95791-F29E-204C-A3B1-5EE8DC303711}"/>
              </a:ext>
            </a:extLst>
          </p:cNvPr>
          <p:cNvSpPr txBox="1"/>
          <p:nvPr/>
        </p:nvSpPr>
        <p:spPr>
          <a:xfrm>
            <a:off x="73931" y="4451482"/>
            <a:ext cx="38985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CD247A1-A1AD-E94C-9428-ED03A244BF3A}"/>
              </a:ext>
            </a:extLst>
          </p:cNvPr>
          <p:cNvSpPr txBox="1"/>
          <p:nvPr/>
        </p:nvSpPr>
        <p:spPr>
          <a:xfrm>
            <a:off x="2923676" y="4451482"/>
            <a:ext cx="38985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584951" y="4914536"/>
            <a:ext cx="2274192" cy="1422009"/>
            <a:chOff x="31840" y="3996702"/>
            <a:chExt cx="2463472" cy="1540362"/>
          </a:xfrm>
        </p:grpSpPr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6B9AEA54-792D-EB4F-BF10-22F4DB21D9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screen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16629"/>
            <a:stretch/>
          </p:blipFill>
          <p:spPr>
            <a:xfrm>
              <a:off x="31840" y="3996702"/>
              <a:ext cx="2463472" cy="1540362"/>
            </a:xfrm>
            <a:prstGeom prst="rect">
              <a:avLst/>
            </a:prstGeom>
          </p:spPr>
        </p:pic>
        <p:sp>
          <p:nvSpPr>
            <p:cNvPr id="78" name="Oval 77">
              <a:extLst>
                <a:ext uri="{FF2B5EF4-FFF2-40B4-BE49-F238E27FC236}">
                  <a16:creationId xmlns:a16="http://schemas.microsoft.com/office/drawing/2014/main" id="{4F5111F2-75D0-3449-983C-EF2DCF321474}"/>
                </a:ext>
              </a:extLst>
            </p:cNvPr>
            <p:cNvSpPr/>
            <p:nvPr/>
          </p:nvSpPr>
          <p:spPr>
            <a:xfrm>
              <a:off x="1065357" y="4451479"/>
              <a:ext cx="359833" cy="231434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207"/>
            </a:p>
          </p:txBody>
        </p: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60A890E6-5F51-8240-8FC5-1BE339B053CE}"/>
              </a:ext>
            </a:extLst>
          </p:cNvPr>
          <p:cNvSpPr txBox="1"/>
          <p:nvPr/>
        </p:nvSpPr>
        <p:spPr>
          <a:xfrm>
            <a:off x="726843" y="4639076"/>
            <a:ext cx="1962397" cy="278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10" b="1" dirty="0">
                <a:latin typeface="Arial" charset="0"/>
                <a:ea typeface="Arial" charset="0"/>
                <a:cs typeface="Arial" charset="0"/>
              </a:rPr>
              <a:t>DAPI infusion in </a:t>
            </a:r>
            <a:r>
              <a:rPr lang="en-US" sz="1210" b="1" dirty="0" err="1">
                <a:latin typeface="Arial" charset="0"/>
                <a:ea typeface="Arial" charset="0"/>
                <a:cs typeface="Arial" charset="0"/>
              </a:rPr>
              <a:t>mICCs</a:t>
            </a:r>
            <a:r>
              <a:rPr lang="en-US" sz="1210" b="1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72" name="テキスト ボックス 12">
            <a:extLst>
              <a:ext uri="{FF2B5EF4-FFF2-40B4-BE49-F238E27FC236}">
                <a16:creationId xmlns:a16="http://schemas.microsoft.com/office/drawing/2014/main" id="{F6F39381-110F-2249-BFF0-FF33C86E13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2884" y="980585"/>
            <a:ext cx="1656479" cy="295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altLang="ja-JP" sz="1320" u="sng" dirty="0">
                <a:latin typeface="Arial" charset="0"/>
              </a:rPr>
              <a:t>Antisense for </a:t>
            </a:r>
            <a:r>
              <a:rPr lang="en-US" altLang="ja-JP" sz="1320" b="1" u="sng" dirty="0">
                <a:solidFill>
                  <a:srgbClr val="00B050"/>
                </a:solidFill>
                <a:latin typeface="Arial" charset="0"/>
              </a:rPr>
              <a:t>PAC1</a:t>
            </a:r>
          </a:p>
        </p:txBody>
      </p:sp>
      <p:pic>
        <p:nvPicPr>
          <p:cNvPr id="80" name="図 16">
            <a:extLst>
              <a:ext uri="{FF2B5EF4-FFF2-40B4-BE49-F238E27FC236}">
                <a16:creationId xmlns:a16="http://schemas.microsoft.com/office/drawing/2014/main" id="{64984A5C-FC06-B746-90B4-A42E9EC34363}"/>
              </a:ext>
            </a:extLst>
          </p:cNvPr>
          <p:cNvPicPr>
            <a:picLocks noChangeAspect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93798" y="1274107"/>
            <a:ext cx="1578677" cy="1203437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1" name="TextBox 5">
            <a:extLst>
              <a:ext uri="{FF2B5EF4-FFF2-40B4-BE49-F238E27FC236}">
                <a16:creationId xmlns:a16="http://schemas.microsoft.com/office/drawing/2014/main" id="{F534B771-6704-0F44-8DEC-9F74F79E00EB}"/>
              </a:ext>
            </a:extLst>
          </p:cNvPr>
          <p:cNvSpPr txBox="1">
            <a:spLocks noChangeArrowheads="1"/>
          </p:cNvSpPr>
          <p:nvPr/>
        </p:nvSpPr>
        <p:spPr bwMode="auto">
          <a:xfrm rot="3138057">
            <a:off x="5936545" y="1574904"/>
            <a:ext cx="1275085" cy="295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320" dirty="0">
                <a:solidFill>
                  <a:schemeClr val="bg1"/>
                </a:solidFill>
                <a:latin typeface="Arial" charset="0"/>
              </a:rPr>
              <a:t>ICCs</a:t>
            </a:r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226B0950-1256-D144-B0D9-5C622E2AABB9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6006156" y="1453097"/>
            <a:ext cx="295071" cy="79670"/>
          </a:xfrm>
          <a:prstGeom prst="straightConnector1">
            <a:avLst/>
          </a:prstGeom>
          <a:noFill/>
          <a:ln w="31750">
            <a:solidFill>
              <a:schemeClr val="bg1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83" name="Freeform 82">
            <a:extLst>
              <a:ext uri="{FF2B5EF4-FFF2-40B4-BE49-F238E27FC236}">
                <a16:creationId xmlns:a16="http://schemas.microsoft.com/office/drawing/2014/main" id="{76CC34B9-40F3-BD47-B12A-7D6C7499D7E6}"/>
              </a:ext>
            </a:extLst>
          </p:cNvPr>
          <p:cNvSpPr/>
          <p:nvPr/>
        </p:nvSpPr>
        <p:spPr>
          <a:xfrm>
            <a:off x="5015233" y="1309815"/>
            <a:ext cx="990924" cy="896407"/>
          </a:xfrm>
          <a:custGeom>
            <a:avLst/>
            <a:gdLst>
              <a:gd name="connsiteX0" fmla="*/ 0 w 1417330"/>
              <a:gd name="connsiteY0" fmla="*/ 69179 h 1198802"/>
              <a:gd name="connsiteX1" fmla="*/ 50800 w 1417330"/>
              <a:gd name="connsiteY1" fmla="*/ 450179 h 1198802"/>
              <a:gd name="connsiteX2" fmla="*/ 139700 w 1417330"/>
              <a:gd name="connsiteY2" fmla="*/ 716879 h 1198802"/>
              <a:gd name="connsiteX3" fmla="*/ 228600 w 1417330"/>
              <a:gd name="connsiteY3" fmla="*/ 843879 h 1198802"/>
              <a:gd name="connsiteX4" fmla="*/ 381000 w 1417330"/>
              <a:gd name="connsiteY4" fmla="*/ 1072479 h 1198802"/>
              <a:gd name="connsiteX5" fmla="*/ 711200 w 1417330"/>
              <a:gd name="connsiteY5" fmla="*/ 1186779 h 1198802"/>
              <a:gd name="connsiteX6" fmla="*/ 965200 w 1417330"/>
              <a:gd name="connsiteY6" fmla="*/ 1186779 h 1198802"/>
              <a:gd name="connsiteX7" fmla="*/ 1206500 w 1417330"/>
              <a:gd name="connsiteY7" fmla="*/ 1110579 h 1198802"/>
              <a:gd name="connsiteX8" fmla="*/ 1384300 w 1417330"/>
              <a:gd name="connsiteY8" fmla="*/ 996279 h 1198802"/>
              <a:gd name="connsiteX9" fmla="*/ 1409700 w 1417330"/>
              <a:gd name="connsiteY9" fmla="*/ 856579 h 1198802"/>
              <a:gd name="connsiteX10" fmla="*/ 1409700 w 1417330"/>
              <a:gd name="connsiteY10" fmla="*/ 653379 h 1198802"/>
              <a:gd name="connsiteX11" fmla="*/ 1320800 w 1417330"/>
              <a:gd name="connsiteY11" fmla="*/ 513679 h 1198802"/>
              <a:gd name="connsiteX12" fmla="*/ 1092200 w 1417330"/>
              <a:gd name="connsiteY12" fmla="*/ 335879 h 1198802"/>
              <a:gd name="connsiteX13" fmla="*/ 914400 w 1417330"/>
              <a:gd name="connsiteY13" fmla="*/ 196179 h 1198802"/>
              <a:gd name="connsiteX14" fmla="*/ 723900 w 1417330"/>
              <a:gd name="connsiteY14" fmla="*/ 158079 h 1198802"/>
              <a:gd name="connsiteX15" fmla="*/ 609600 w 1417330"/>
              <a:gd name="connsiteY15" fmla="*/ 18379 h 1198802"/>
              <a:gd name="connsiteX16" fmla="*/ 609600 w 1417330"/>
              <a:gd name="connsiteY16" fmla="*/ 5679 h 119880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1417330" h="1198802">
                <a:moveTo>
                  <a:pt x="0" y="69179"/>
                </a:moveTo>
                <a:cubicBezTo>
                  <a:pt x="13758" y="205704"/>
                  <a:pt x="27517" y="342229"/>
                  <a:pt x="50800" y="450179"/>
                </a:cubicBezTo>
                <a:cubicBezTo>
                  <a:pt x="74083" y="558129"/>
                  <a:pt x="110067" y="651262"/>
                  <a:pt x="139700" y="716879"/>
                </a:cubicBezTo>
                <a:cubicBezTo>
                  <a:pt x="169333" y="782496"/>
                  <a:pt x="188383" y="784612"/>
                  <a:pt x="228600" y="843879"/>
                </a:cubicBezTo>
                <a:cubicBezTo>
                  <a:pt x="268817" y="903146"/>
                  <a:pt x="300567" y="1015329"/>
                  <a:pt x="381000" y="1072479"/>
                </a:cubicBezTo>
                <a:cubicBezTo>
                  <a:pt x="461433" y="1129629"/>
                  <a:pt x="613833" y="1167729"/>
                  <a:pt x="711200" y="1186779"/>
                </a:cubicBezTo>
                <a:cubicBezTo>
                  <a:pt x="808567" y="1205829"/>
                  <a:pt x="882650" y="1199479"/>
                  <a:pt x="965200" y="1186779"/>
                </a:cubicBezTo>
                <a:cubicBezTo>
                  <a:pt x="1047750" y="1174079"/>
                  <a:pt x="1136650" y="1142329"/>
                  <a:pt x="1206500" y="1110579"/>
                </a:cubicBezTo>
                <a:cubicBezTo>
                  <a:pt x="1276350" y="1078829"/>
                  <a:pt x="1350433" y="1038612"/>
                  <a:pt x="1384300" y="996279"/>
                </a:cubicBezTo>
                <a:cubicBezTo>
                  <a:pt x="1418167" y="953946"/>
                  <a:pt x="1405467" y="913729"/>
                  <a:pt x="1409700" y="856579"/>
                </a:cubicBezTo>
                <a:cubicBezTo>
                  <a:pt x="1413933" y="799429"/>
                  <a:pt x="1424517" y="710529"/>
                  <a:pt x="1409700" y="653379"/>
                </a:cubicBezTo>
                <a:cubicBezTo>
                  <a:pt x="1394883" y="596229"/>
                  <a:pt x="1373717" y="566596"/>
                  <a:pt x="1320800" y="513679"/>
                </a:cubicBezTo>
                <a:cubicBezTo>
                  <a:pt x="1267883" y="460762"/>
                  <a:pt x="1092200" y="335879"/>
                  <a:pt x="1092200" y="335879"/>
                </a:cubicBezTo>
                <a:cubicBezTo>
                  <a:pt x="1024467" y="282962"/>
                  <a:pt x="975783" y="225812"/>
                  <a:pt x="914400" y="196179"/>
                </a:cubicBezTo>
                <a:cubicBezTo>
                  <a:pt x="853017" y="166546"/>
                  <a:pt x="774700" y="187712"/>
                  <a:pt x="723900" y="158079"/>
                </a:cubicBezTo>
                <a:cubicBezTo>
                  <a:pt x="673100" y="128446"/>
                  <a:pt x="628650" y="43779"/>
                  <a:pt x="609600" y="18379"/>
                </a:cubicBezTo>
                <a:cubicBezTo>
                  <a:pt x="590550" y="-7021"/>
                  <a:pt x="600075" y="-671"/>
                  <a:pt x="609600" y="5679"/>
                </a:cubicBezTo>
              </a:path>
            </a:pathLst>
          </a:custGeom>
          <a:ln w="9525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20"/>
          </a:p>
        </p:txBody>
      </p:sp>
      <p:sp>
        <p:nvSpPr>
          <p:cNvPr id="84" name="Freeform 83">
            <a:extLst>
              <a:ext uri="{FF2B5EF4-FFF2-40B4-BE49-F238E27FC236}">
                <a16:creationId xmlns:a16="http://schemas.microsoft.com/office/drawing/2014/main" id="{A56D8BC5-A684-834D-B62F-8120FC651D9E}"/>
              </a:ext>
            </a:extLst>
          </p:cNvPr>
          <p:cNvSpPr/>
          <p:nvPr/>
        </p:nvSpPr>
        <p:spPr>
          <a:xfrm>
            <a:off x="5662281" y="1299136"/>
            <a:ext cx="102343" cy="153403"/>
          </a:xfrm>
          <a:custGeom>
            <a:avLst/>
            <a:gdLst>
              <a:gd name="connsiteX0" fmla="*/ 0 w 133789"/>
              <a:gd name="connsiteY0" fmla="*/ 200538 h 200538"/>
              <a:gd name="connsiteX1" fmla="*/ 66836 w 133789"/>
              <a:gd name="connsiteY1" fmla="*/ 150404 h 200538"/>
              <a:gd name="connsiteX2" fmla="*/ 133672 w 133789"/>
              <a:gd name="connsiteY2" fmla="*/ 66846 h 200538"/>
              <a:gd name="connsiteX3" fmla="*/ 50127 w 133789"/>
              <a:gd name="connsiteY3" fmla="*/ 0 h 2005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3789" h="200538">
                <a:moveTo>
                  <a:pt x="0" y="200538"/>
                </a:moveTo>
                <a:cubicBezTo>
                  <a:pt x="22278" y="186612"/>
                  <a:pt x="44557" y="172686"/>
                  <a:pt x="66836" y="150404"/>
                </a:cubicBezTo>
                <a:cubicBezTo>
                  <a:pt x="89115" y="128122"/>
                  <a:pt x="136457" y="91913"/>
                  <a:pt x="133672" y="66846"/>
                </a:cubicBezTo>
                <a:cubicBezTo>
                  <a:pt x="130887" y="41779"/>
                  <a:pt x="50127" y="0"/>
                  <a:pt x="50127" y="0"/>
                </a:cubicBezTo>
              </a:path>
            </a:pathLst>
          </a:custGeom>
          <a:ln w="12700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20"/>
          </a:p>
        </p:txBody>
      </p:sp>
      <p:sp>
        <p:nvSpPr>
          <p:cNvPr id="85" name="Freeform 84">
            <a:extLst>
              <a:ext uri="{FF2B5EF4-FFF2-40B4-BE49-F238E27FC236}">
                <a16:creationId xmlns:a16="http://schemas.microsoft.com/office/drawing/2014/main" id="{CCD69860-BDD4-8345-AD88-2E82B89BADE3}"/>
              </a:ext>
            </a:extLst>
          </p:cNvPr>
          <p:cNvSpPr/>
          <p:nvPr/>
        </p:nvSpPr>
        <p:spPr>
          <a:xfrm>
            <a:off x="5802879" y="1469301"/>
            <a:ext cx="322916" cy="370534"/>
          </a:xfrm>
          <a:custGeom>
            <a:avLst/>
            <a:gdLst>
              <a:gd name="connsiteX0" fmla="*/ 0 w 422137"/>
              <a:gd name="connsiteY0" fmla="*/ 111781 h 484386"/>
              <a:gd name="connsiteX1" fmla="*/ 50127 w 422137"/>
              <a:gd name="connsiteY1" fmla="*/ 11512 h 484386"/>
              <a:gd name="connsiteX2" fmla="*/ 133672 w 422137"/>
              <a:gd name="connsiteY2" fmla="*/ 11512 h 484386"/>
              <a:gd name="connsiteX3" fmla="*/ 267344 w 422137"/>
              <a:gd name="connsiteY3" fmla="*/ 95069 h 484386"/>
              <a:gd name="connsiteX4" fmla="*/ 367598 w 422137"/>
              <a:gd name="connsiteY4" fmla="*/ 228762 h 484386"/>
              <a:gd name="connsiteX5" fmla="*/ 417725 w 422137"/>
              <a:gd name="connsiteY5" fmla="*/ 312319 h 484386"/>
              <a:gd name="connsiteX6" fmla="*/ 417725 w 422137"/>
              <a:gd name="connsiteY6" fmla="*/ 412589 h 484386"/>
              <a:gd name="connsiteX7" fmla="*/ 401016 w 422137"/>
              <a:gd name="connsiteY7" fmla="*/ 479435 h 484386"/>
              <a:gd name="connsiteX8" fmla="*/ 317471 w 422137"/>
              <a:gd name="connsiteY8" fmla="*/ 479435 h 4843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422137" h="484386">
                <a:moveTo>
                  <a:pt x="0" y="111781"/>
                </a:moveTo>
                <a:cubicBezTo>
                  <a:pt x="13924" y="70002"/>
                  <a:pt x="27848" y="28223"/>
                  <a:pt x="50127" y="11512"/>
                </a:cubicBezTo>
                <a:cubicBezTo>
                  <a:pt x="72406" y="-5199"/>
                  <a:pt x="97469" y="-2414"/>
                  <a:pt x="133672" y="11512"/>
                </a:cubicBezTo>
                <a:cubicBezTo>
                  <a:pt x="169875" y="25438"/>
                  <a:pt x="228356" y="58861"/>
                  <a:pt x="267344" y="95069"/>
                </a:cubicBezTo>
                <a:cubicBezTo>
                  <a:pt x="306332" y="131277"/>
                  <a:pt x="342535" y="192554"/>
                  <a:pt x="367598" y="228762"/>
                </a:cubicBezTo>
                <a:cubicBezTo>
                  <a:pt x="392661" y="264970"/>
                  <a:pt x="409371" y="281681"/>
                  <a:pt x="417725" y="312319"/>
                </a:cubicBezTo>
                <a:cubicBezTo>
                  <a:pt x="426079" y="342957"/>
                  <a:pt x="420510" y="384736"/>
                  <a:pt x="417725" y="412589"/>
                </a:cubicBezTo>
                <a:cubicBezTo>
                  <a:pt x="414940" y="440442"/>
                  <a:pt x="417725" y="468294"/>
                  <a:pt x="401016" y="479435"/>
                </a:cubicBezTo>
                <a:cubicBezTo>
                  <a:pt x="384307" y="490576"/>
                  <a:pt x="317471" y="479435"/>
                  <a:pt x="317471" y="479435"/>
                </a:cubicBezTo>
              </a:path>
            </a:pathLst>
          </a:custGeom>
          <a:ln w="12700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20"/>
          </a:p>
        </p:txBody>
      </p:sp>
      <p:pic>
        <p:nvPicPr>
          <p:cNvPr id="86" name="図 18">
            <a:extLst>
              <a:ext uri="{FF2B5EF4-FFF2-40B4-BE49-F238E27FC236}">
                <a16:creationId xmlns:a16="http://schemas.microsoft.com/office/drawing/2014/main" id="{B07AD558-B1A8-9A43-AE19-09ADA8D8FE62}"/>
              </a:ext>
            </a:extLst>
          </p:cNvPr>
          <p:cNvPicPr>
            <a:picLocks noChangeAspect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90028" y="2879003"/>
            <a:ext cx="1605393" cy="122408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87" name="Freeform 86">
            <a:extLst>
              <a:ext uri="{FF2B5EF4-FFF2-40B4-BE49-F238E27FC236}">
                <a16:creationId xmlns:a16="http://schemas.microsoft.com/office/drawing/2014/main" id="{A91B6D99-6DA3-7A45-8D50-F3144E56EB02}"/>
              </a:ext>
            </a:extLst>
          </p:cNvPr>
          <p:cNvSpPr/>
          <p:nvPr/>
        </p:nvSpPr>
        <p:spPr>
          <a:xfrm>
            <a:off x="5064896" y="2937293"/>
            <a:ext cx="903489" cy="892956"/>
          </a:xfrm>
          <a:custGeom>
            <a:avLst/>
            <a:gdLst>
              <a:gd name="connsiteX0" fmla="*/ 0 w 1500050"/>
              <a:gd name="connsiteY0" fmla="*/ 25400 h 1167330"/>
              <a:gd name="connsiteX1" fmla="*/ 12700 w 1500050"/>
              <a:gd name="connsiteY1" fmla="*/ 203200 h 1167330"/>
              <a:gd name="connsiteX2" fmla="*/ 12700 w 1500050"/>
              <a:gd name="connsiteY2" fmla="*/ 520700 h 1167330"/>
              <a:gd name="connsiteX3" fmla="*/ 139700 w 1500050"/>
              <a:gd name="connsiteY3" fmla="*/ 698500 h 1167330"/>
              <a:gd name="connsiteX4" fmla="*/ 317500 w 1500050"/>
              <a:gd name="connsiteY4" fmla="*/ 889000 h 1167330"/>
              <a:gd name="connsiteX5" fmla="*/ 685800 w 1500050"/>
              <a:gd name="connsiteY5" fmla="*/ 1143000 h 1167330"/>
              <a:gd name="connsiteX6" fmla="*/ 952500 w 1500050"/>
              <a:gd name="connsiteY6" fmla="*/ 1155700 h 1167330"/>
              <a:gd name="connsiteX7" fmla="*/ 1257300 w 1500050"/>
              <a:gd name="connsiteY7" fmla="*/ 1130300 h 1167330"/>
              <a:gd name="connsiteX8" fmla="*/ 1422400 w 1500050"/>
              <a:gd name="connsiteY8" fmla="*/ 1003300 h 1167330"/>
              <a:gd name="connsiteX9" fmla="*/ 1498600 w 1500050"/>
              <a:gd name="connsiteY9" fmla="*/ 711200 h 1167330"/>
              <a:gd name="connsiteX10" fmla="*/ 1460500 w 1500050"/>
              <a:gd name="connsiteY10" fmla="*/ 508000 h 1167330"/>
              <a:gd name="connsiteX11" fmla="*/ 1320800 w 1500050"/>
              <a:gd name="connsiteY11" fmla="*/ 342900 h 1167330"/>
              <a:gd name="connsiteX12" fmla="*/ 1219200 w 1500050"/>
              <a:gd name="connsiteY12" fmla="*/ 203200 h 1167330"/>
              <a:gd name="connsiteX13" fmla="*/ 1104900 w 1500050"/>
              <a:gd name="connsiteY13" fmla="*/ 50800 h 1167330"/>
              <a:gd name="connsiteX14" fmla="*/ 1016000 w 1500050"/>
              <a:gd name="connsiteY14" fmla="*/ 0 h 11673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1500050" h="1167330">
                <a:moveTo>
                  <a:pt x="0" y="25400"/>
                </a:moveTo>
                <a:cubicBezTo>
                  <a:pt x="5291" y="73025"/>
                  <a:pt x="10583" y="120650"/>
                  <a:pt x="12700" y="203200"/>
                </a:cubicBezTo>
                <a:cubicBezTo>
                  <a:pt x="14817" y="285750"/>
                  <a:pt x="-8467" y="438150"/>
                  <a:pt x="12700" y="520700"/>
                </a:cubicBezTo>
                <a:cubicBezTo>
                  <a:pt x="33867" y="603250"/>
                  <a:pt x="88900" y="637117"/>
                  <a:pt x="139700" y="698500"/>
                </a:cubicBezTo>
                <a:cubicBezTo>
                  <a:pt x="190500" y="759883"/>
                  <a:pt x="226483" y="814917"/>
                  <a:pt x="317500" y="889000"/>
                </a:cubicBezTo>
                <a:cubicBezTo>
                  <a:pt x="408517" y="963083"/>
                  <a:pt x="579967" y="1098550"/>
                  <a:pt x="685800" y="1143000"/>
                </a:cubicBezTo>
                <a:cubicBezTo>
                  <a:pt x="791633" y="1187450"/>
                  <a:pt x="857250" y="1157817"/>
                  <a:pt x="952500" y="1155700"/>
                </a:cubicBezTo>
                <a:cubicBezTo>
                  <a:pt x="1047750" y="1153583"/>
                  <a:pt x="1178983" y="1155700"/>
                  <a:pt x="1257300" y="1130300"/>
                </a:cubicBezTo>
                <a:cubicBezTo>
                  <a:pt x="1335617" y="1104900"/>
                  <a:pt x="1382183" y="1073150"/>
                  <a:pt x="1422400" y="1003300"/>
                </a:cubicBezTo>
                <a:cubicBezTo>
                  <a:pt x="1462617" y="933450"/>
                  <a:pt x="1492250" y="793750"/>
                  <a:pt x="1498600" y="711200"/>
                </a:cubicBezTo>
                <a:cubicBezTo>
                  <a:pt x="1504950" y="628650"/>
                  <a:pt x="1490133" y="569383"/>
                  <a:pt x="1460500" y="508000"/>
                </a:cubicBezTo>
                <a:cubicBezTo>
                  <a:pt x="1430867" y="446617"/>
                  <a:pt x="1361017" y="393700"/>
                  <a:pt x="1320800" y="342900"/>
                </a:cubicBezTo>
                <a:cubicBezTo>
                  <a:pt x="1280583" y="292100"/>
                  <a:pt x="1255183" y="251883"/>
                  <a:pt x="1219200" y="203200"/>
                </a:cubicBezTo>
                <a:cubicBezTo>
                  <a:pt x="1183217" y="154517"/>
                  <a:pt x="1138767" y="84667"/>
                  <a:pt x="1104900" y="50800"/>
                </a:cubicBezTo>
                <a:cubicBezTo>
                  <a:pt x="1071033" y="16933"/>
                  <a:pt x="1016000" y="0"/>
                  <a:pt x="1016000" y="0"/>
                </a:cubicBezTo>
              </a:path>
            </a:pathLst>
          </a:custGeom>
          <a:ln w="9525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320"/>
          </a:p>
        </p:txBody>
      </p:sp>
      <p:sp>
        <p:nvSpPr>
          <p:cNvPr id="88" name="テキスト ボックス 15">
            <a:extLst>
              <a:ext uri="{FF2B5EF4-FFF2-40B4-BE49-F238E27FC236}">
                <a16:creationId xmlns:a16="http://schemas.microsoft.com/office/drawing/2014/main" id="{EC62A01C-F8FA-3B44-8D16-C6511F2261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6322" y="2595074"/>
            <a:ext cx="1393587" cy="295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altLang="ja-JP" sz="1320" u="sng" dirty="0">
                <a:latin typeface="Arial" charset="0"/>
              </a:rPr>
              <a:t>Sense for </a:t>
            </a:r>
            <a:r>
              <a:rPr lang="en-US" altLang="ja-JP" sz="1320" b="1" u="sng" dirty="0">
                <a:solidFill>
                  <a:srgbClr val="00B050"/>
                </a:solidFill>
                <a:latin typeface="Arial" charset="0"/>
              </a:rPr>
              <a:t>PAC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9792F2B-C4DD-8B4F-A0A4-70E7E359C04A}"/>
              </a:ext>
            </a:extLst>
          </p:cNvPr>
          <p:cNvSpPr txBox="1"/>
          <p:nvPr/>
        </p:nvSpPr>
        <p:spPr>
          <a:xfrm>
            <a:off x="4408687" y="938673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8BA3718-EAEB-0D4F-876C-49147F803DAA}"/>
              </a:ext>
            </a:extLst>
          </p:cNvPr>
          <p:cNvSpPr txBox="1"/>
          <p:nvPr/>
        </p:nvSpPr>
        <p:spPr>
          <a:xfrm>
            <a:off x="146494" y="6582210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F01D90C-670A-D446-B363-A14E74655CB9}"/>
              </a:ext>
            </a:extLst>
          </p:cNvPr>
          <p:cNvSpPr txBox="1"/>
          <p:nvPr/>
        </p:nvSpPr>
        <p:spPr>
          <a:xfrm>
            <a:off x="2941180" y="851954"/>
            <a:ext cx="1106072" cy="2785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10" b="1" dirty="0">
                <a:solidFill>
                  <a:schemeClr val="accent4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C1 mRNA</a:t>
            </a:r>
          </a:p>
        </p:txBody>
      </p:sp>
      <p:sp>
        <p:nvSpPr>
          <p:cNvPr id="5" name="Freeform 4">
            <a:extLst>
              <a:ext uri="{FF2B5EF4-FFF2-40B4-BE49-F238E27FC236}">
                <a16:creationId xmlns:a16="http://schemas.microsoft.com/office/drawing/2014/main" id="{52672B73-8F87-BF49-8660-2CD5631C465C}"/>
              </a:ext>
            </a:extLst>
          </p:cNvPr>
          <p:cNvSpPr/>
          <p:nvPr/>
        </p:nvSpPr>
        <p:spPr>
          <a:xfrm>
            <a:off x="1303020" y="5151122"/>
            <a:ext cx="914648" cy="974795"/>
          </a:xfrm>
          <a:custGeom>
            <a:avLst/>
            <a:gdLst>
              <a:gd name="connsiteX0" fmla="*/ 0 w 831498"/>
              <a:gd name="connsiteY0" fmla="*/ 0 h 886177"/>
              <a:gd name="connsiteX1" fmla="*/ 55418 w 831498"/>
              <a:gd name="connsiteY1" fmla="*/ 180109 h 886177"/>
              <a:gd name="connsiteX2" fmla="*/ 180109 w 831498"/>
              <a:gd name="connsiteY2" fmla="*/ 429491 h 886177"/>
              <a:gd name="connsiteX3" fmla="*/ 401781 w 831498"/>
              <a:gd name="connsiteY3" fmla="*/ 817418 h 886177"/>
              <a:gd name="connsiteX4" fmla="*/ 678872 w 831498"/>
              <a:gd name="connsiteY4" fmla="*/ 872836 h 886177"/>
              <a:gd name="connsiteX5" fmla="*/ 831272 w 831498"/>
              <a:gd name="connsiteY5" fmla="*/ 665018 h 886177"/>
              <a:gd name="connsiteX6" fmla="*/ 706581 w 831498"/>
              <a:gd name="connsiteY6" fmla="*/ 415636 h 886177"/>
              <a:gd name="connsiteX7" fmla="*/ 457200 w 831498"/>
              <a:gd name="connsiteY7" fmla="*/ 263236 h 886177"/>
              <a:gd name="connsiteX8" fmla="*/ 360218 w 831498"/>
              <a:gd name="connsiteY8" fmla="*/ 207818 h 886177"/>
              <a:gd name="connsiteX9" fmla="*/ 193963 w 831498"/>
              <a:gd name="connsiteY9" fmla="*/ 138545 h 886177"/>
              <a:gd name="connsiteX10" fmla="*/ 69272 w 831498"/>
              <a:gd name="connsiteY10" fmla="*/ 55418 h 8861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831498" h="886177">
                <a:moveTo>
                  <a:pt x="0" y="0"/>
                </a:moveTo>
                <a:cubicBezTo>
                  <a:pt x="12700" y="54263"/>
                  <a:pt x="25400" y="108527"/>
                  <a:pt x="55418" y="180109"/>
                </a:cubicBezTo>
                <a:cubicBezTo>
                  <a:pt x="85436" y="251691"/>
                  <a:pt x="122382" y="323273"/>
                  <a:pt x="180109" y="429491"/>
                </a:cubicBezTo>
                <a:cubicBezTo>
                  <a:pt x="237836" y="535709"/>
                  <a:pt x="318654" y="743527"/>
                  <a:pt x="401781" y="817418"/>
                </a:cubicBezTo>
                <a:cubicBezTo>
                  <a:pt x="484908" y="891309"/>
                  <a:pt x="607290" y="898236"/>
                  <a:pt x="678872" y="872836"/>
                </a:cubicBezTo>
                <a:cubicBezTo>
                  <a:pt x="750454" y="847436"/>
                  <a:pt x="826654" y="741218"/>
                  <a:pt x="831272" y="665018"/>
                </a:cubicBezTo>
                <a:cubicBezTo>
                  <a:pt x="835890" y="588818"/>
                  <a:pt x="768926" y="482600"/>
                  <a:pt x="706581" y="415636"/>
                </a:cubicBezTo>
                <a:cubicBezTo>
                  <a:pt x="644236" y="348672"/>
                  <a:pt x="514927" y="297872"/>
                  <a:pt x="457200" y="263236"/>
                </a:cubicBezTo>
                <a:cubicBezTo>
                  <a:pt x="399473" y="228600"/>
                  <a:pt x="404091" y="228600"/>
                  <a:pt x="360218" y="207818"/>
                </a:cubicBezTo>
                <a:cubicBezTo>
                  <a:pt x="316345" y="187036"/>
                  <a:pt x="242454" y="163945"/>
                  <a:pt x="193963" y="138545"/>
                </a:cubicBezTo>
                <a:cubicBezTo>
                  <a:pt x="145472" y="113145"/>
                  <a:pt x="107372" y="84281"/>
                  <a:pt x="69272" y="55418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1E61C121-727E-FA4A-B97E-B1F3271AAD6B}"/>
              </a:ext>
            </a:extLst>
          </p:cNvPr>
          <p:cNvSpPr/>
          <p:nvPr/>
        </p:nvSpPr>
        <p:spPr>
          <a:xfrm>
            <a:off x="3741420" y="4953000"/>
            <a:ext cx="685799" cy="1127761"/>
          </a:xfrm>
          <a:custGeom>
            <a:avLst/>
            <a:gdLst>
              <a:gd name="connsiteX0" fmla="*/ 623454 w 623454"/>
              <a:gd name="connsiteY0" fmla="*/ 0 h 1025237"/>
              <a:gd name="connsiteX1" fmla="*/ 512618 w 623454"/>
              <a:gd name="connsiteY1" fmla="*/ 152400 h 1025237"/>
              <a:gd name="connsiteX2" fmla="*/ 374073 w 623454"/>
              <a:gd name="connsiteY2" fmla="*/ 415637 h 1025237"/>
              <a:gd name="connsiteX3" fmla="*/ 235527 w 623454"/>
              <a:gd name="connsiteY3" fmla="*/ 678873 h 1025237"/>
              <a:gd name="connsiteX4" fmla="*/ 124691 w 623454"/>
              <a:gd name="connsiteY4" fmla="*/ 872837 h 1025237"/>
              <a:gd name="connsiteX5" fmla="*/ 0 w 623454"/>
              <a:gd name="connsiteY5" fmla="*/ 1025237 h 1025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23454" h="1025237">
                <a:moveTo>
                  <a:pt x="623454" y="0"/>
                </a:moveTo>
                <a:cubicBezTo>
                  <a:pt x="588818" y="41563"/>
                  <a:pt x="554182" y="83127"/>
                  <a:pt x="512618" y="152400"/>
                </a:cubicBezTo>
                <a:cubicBezTo>
                  <a:pt x="471054" y="221673"/>
                  <a:pt x="374073" y="415637"/>
                  <a:pt x="374073" y="415637"/>
                </a:cubicBezTo>
                <a:cubicBezTo>
                  <a:pt x="327891" y="503383"/>
                  <a:pt x="277091" y="602673"/>
                  <a:pt x="235527" y="678873"/>
                </a:cubicBezTo>
                <a:cubicBezTo>
                  <a:pt x="193963" y="755073"/>
                  <a:pt x="163945" y="815110"/>
                  <a:pt x="124691" y="872837"/>
                </a:cubicBezTo>
                <a:cubicBezTo>
                  <a:pt x="85437" y="930564"/>
                  <a:pt x="42718" y="977900"/>
                  <a:pt x="0" y="1025237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90" name="Freeform 89">
            <a:extLst>
              <a:ext uri="{FF2B5EF4-FFF2-40B4-BE49-F238E27FC236}">
                <a16:creationId xmlns:a16="http://schemas.microsoft.com/office/drawing/2014/main" id="{C8E4139D-F3FA-6D4D-9D1B-55A79CB7FB9A}"/>
              </a:ext>
            </a:extLst>
          </p:cNvPr>
          <p:cNvSpPr/>
          <p:nvPr/>
        </p:nvSpPr>
        <p:spPr>
          <a:xfrm>
            <a:off x="5237043" y="4953000"/>
            <a:ext cx="685799" cy="1127761"/>
          </a:xfrm>
          <a:custGeom>
            <a:avLst/>
            <a:gdLst>
              <a:gd name="connsiteX0" fmla="*/ 623454 w 623454"/>
              <a:gd name="connsiteY0" fmla="*/ 0 h 1025237"/>
              <a:gd name="connsiteX1" fmla="*/ 512618 w 623454"/>
              <a:gd name="connsiteY1" fmla="*/ 152400 h 1025237"/>
              <a:gd name="connsiteX2" fmla="*/ 374073 w 623454"/>
              <a:gd name="connsiteY2" fmla="*/ 415637 h 1025237"/>
              <a:gd name="connsiteX3" fmla="*/ 235527 w 623454"/>
              <a:gd name="connsiteY3" fmla="*/ 678873 h 1025237"/>
              <a:gd name="connsiteX4" fmla="*/ 124691 w 623454"/>
              <a:gd name="connsiteY4" fmla="*/ 872837 h 1025237"/>
              <a:gd name="connsiteX5" fmla="*/ 0 w 623454"/>
              <a:gd name="connsiteY5" fmla="*/ 1025237 h 1025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23454" h="1025237">
                <a:moveTo>
                  <a:pt x="623454" y="0"/>
                </a:moveTo>
                <a:cubicBezTo>
                  <a:pt x="588818" y="41563"/>
                  <a:pt x="554182" y="83127"/>
                  <a:pt x="512618" y="152400"/>
                </a:cubicBezTo>
                <a:cubicBezTo>
                  <a:pt x="471054" y="221673"/>
                  <a:pt x="374073" y="415637"/>
                  <a:pt x="374073" y="415637"/>
                </a:cubicBezTo>
                <a:cubicBezTo>
                  <a:pt x="327891" y="503383"/>
                  <a:pt x="277091" y="602673"/>
                  <a:pt x="235527" y="678873"/>
                </a:cubicBezTo>
                <a:cubicBezTo>
                  <a:pt x="193963" y="755073"/>
                  <a:pt x="163945" y="815110"/>
                  <a:pt x="124691" y="872837"/>
                </a:cubicBezTo>
                <a:cubicBezTo>
                  <a:pt x="85437" y="930564"/>
                  <a:pt x="42718" y="977900"/>
                  <a:pt x="0" y="1025237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91" name="Freeform 90">
            <a:extLst>
              <a:ext uri="{FF2B5EF4-FFF2-40B4-BE49-F238E27FC236}">
                <a16:creationId xmlns:a16="http://schemas.microsoft.com/office/drawing/2014/main" id="{BE2D5B5F-CAE9-6B4D-9A39-6D0A5BFBCBD2}"/>
              </a:ext>
            </a:extLst>
          </p:cNvPr>
          <p:cNvSpPr/>
          <p:nvPr/>
        </p:nvSpPr>
        <p:spPr>
          <a:xfrm>
            <a:off x="6782944" y="4998156"/>
            <a:ext cx="685799" cy="1127761"/>
          </a:xfrm>
          <a:custGeom>
            <a:avLst/>
            <a:gdLst>
              <a:gd name="connsiteX0" fmla="*/ 623454 w 623454"/>
              <a:gd name="connsiteY0" fmla="*/ 0 h 1025237"/>
              <a:gd name="connsiteX1" fmla="*/ 512618 w 623454"/>
              <a:gd name="connsiteY1" fmla="*/ 152400 h 1025237"/>
              <a:gd name="connsiteX2" fmla="*/ 374073 w 623454"/>
              <a:gd name="connsiteY2" fmla="*/ 415637 h 1025237"/>
              <a:gd name="connsiteX3" fmla="*/ 235527 w 623454"/>
              <a:gd name="connsiteY3" fmla="*/ 678873 h 1025237"/>
              <a:gd name="connsiteX4" fmla="*/ 124691 w 623454"/>
              <a:gd name="connsiteY4" fmla="*/ 872837 h 1025237"/>
              <a:gd name="connsiteX5" fmla="*/ 0 w 623454"/>
              <a:gd name="connsiteY5" fmla="*/ 1025237 h 1025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23454" h="1025237">
                <a:moveTo>
                  <a:pt x="623454" y="0"/>
                </a:moveTo>
                <a:cubicBezTo>
                  <a:pt x="588818" y="41563"/>
                  <a:pt x="554182" y="83127"/>
                  <a:pt x="512618" y="152400"/>
                </a:cubicBezTo>
                <a:cubicBezTo>
                  <a:pt x="471054" y="221673"/>
                  <a:pt x="374073" y="415637"/>
                  <a:pt x="374073" y="415637"/>
                </a:cubicBezTo>
                <a:cubicBezTo>
                  <a:pt x="327891" y="503383"/>
                  <a:pt x="277091" y="602673"/>
                  <a:pt x="235527" y="678873"/>
                </a:cubicBezTo>
                <a:cubicBezTo>
                  <a:pt x="193963" y="755073"/>
                  <a:pt x="163945" y="815110"/>
                  <a:pt x="124691" y="872837"/>
                </a:cubicBezTo>
                <a:cubicBezTo>
                  <a:pt x="85437" y="930564"/>
                  <a:pt x="42718" y="977900"/>
                  <a:pt x="0" y="1025237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7" name="Freeform 6">
            <a:extLst>
              <a:ext uri="{FF2B5EF4-FFF2-40B4-BE49-F238E27FC236}">
                <a16:creationId xmlns:a16="http://schemas.microsoft.com/office/drawing/2014/main" id="{235DD3DE-67DD-814D-8A32-E551D511CC7A}"/>
              </a:ext>
            </a:extLst>
          </p:cNvPr>
          <p:cNvSpPr/>
          <p:nvPr/>
        </p:nvSpPr>
        <p:spPr>
          <a:xfrm>
            <a:off x="4533900" y="4953000"/>
            <a:ext cx="182881" cy="152401"/>
          </a:xfrm>
          <a:custGeom>
            <a:avLst/>
            <a:gdLst>
              <a:gd name="connsiteX0" fmla="*/ 0 w 166255"/>
              <a:gd name="connsiteY0" fmla="*/ 138546 h 138546"/>
              <a:gd name="connsiteX1" fmla="*/ 69273 w 166255"/>
              <a:gd name="connsiteY1" fmla="*/ 55418 h 138546"/>
              <a:gd name="connsiteX2" fmla="*/ 166255 w 166255"/>
              <a:gd name="connsiteY2" fmla="*/ 0 h 1385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66255" h="138546">
                <a:moveTo>
                  <a:pt x="0" y="138546"/>
                </a:moveTo>
                <a:cubicBezTo>
                  <a:pt x="20782" y="108527"/>
                  <a:pt x="41564" y="78509"/>
                  <a:pt x="69273" y="55418"/>
                </a:cubicBezTo>
                <a:cubicBezTo>
                  <a:pt x="96982" y="32327"/>
                  <a:pt x="131618" y="16163"/>
                  <a:pt x="166255" y="0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92" name="Freeform 91">
            <a:extLst>
              <a:ext uri="{FF2B5EF4-FFF2-40B4-BE49-F238E27FC236}">
                <a16:creationId xmlns:a16="http://schemas.microsoft.com/office/drawing/2014/main" id="{5C9D5EDE-7A7D-9D4E-A517-BCBA9677229F}"/>
              </a:ext>
            </a:extLst>
          </p:cNvPr>
          <p:cNvSpPr/>
          <p:nvPr/>
        </p:nvSpPr>
        <p:spPr>
          <a:xfrm>
            <a:off x="6091908" y="4906635"/>
            <a:ext cx="182881" cy="152401"/>
          </a:xfrm>
          <a:custGeom>
            <a:avLst/>
            <a:gdLst>
              <a:gd name="connsiteX0" fmla="*/ 0 w 166255"/>
              <a:gd name="connsiteY0" fmla="*/ 138546 h 138546"/>
              <a:gd name="connsiteX1" fmla="*/ 69273 w 166255"/>
              <a:gd name="connsiteY1" fmla="*/ 55418 h 138546"/>
              <a:gd name="connsiteX2" fmla="*/ 166255 w 166255"/>
              <a:gd name="connsiteY2" fmla="*/ 0 h 1385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66255" h="138546">
                <a:moveTo>
                  <a:pt x="0" y="138546"/>
                </a:moveTo>
                <a:cubicBezTo>
                  <a:pt x="20782" y="108527"/>
                  <a:pt x="41564" y="78509"/>
                  <a:pt x="69273" y="55418"/>
                </a:cubicBezTo>
                <a:cubicBezTo>
                  <a:pt x="96982" y="32327"/>
                  <a:pt x="131618" y="16163"/>
                  <a:pt x="166255" y="0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E71BAA-8E50-1F46-99ED-3358B7200801}"/>
              </a:ext>
            </a:extLst>
          </p:cNvPr>
          <p:cNvSpPr txBox="1"/>
          <p:nvPr/>
        </p:nvSpPr>
        <p:spPr>
          <a:xfrm>
            <a:off x="3143192" y="5262470"/>
            <a:ext cx="558166" cy="32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9CFD456-F9FC-F540-B266-3B490F9F0FBE}"/>
              </a:ext>
            </a:extLst>
          </p:cNvPr>
          <p:cNvSpPr txBox="1"/>
          <p:nvPr/>
        </p:nvSpPr>
        <p:spPr>
          <a:xfrm>
            <a:off x="4726756" y="5353252"/>
            <a:ext cx="558166" cy="32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670D332-72DA-5E43-A83B-D2A89D757D16}"/>
              </a:ext>
            </a:extLst>
          </p:cNvPr>
          <p:cNvSpPr txBox="1"/>
          <p:nvPr/>
        </p:nvSpPr>
        <p:spPr>
          <a:xfrm>
            <a:off x="6300568" y="5365415"/>
            <a:ext cx="558166" cy="32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</a:p>
        </p:txBody>
      </p:sp>
      <p:sp>
        <p:nvSpPr>
          <p:cNvPr id="95" name="TextBox 22">
            <a:extLst>
              <a:ext uri="{FF2B5EF4-FFF2-40B4-BE49-F238E27FC236}">
                <a16:creationId xmlns:a16="http://schemas.microsoft.com/office/drawing/2014/main" id="{02A7C72B-B58E-8742-B768-FF11F66D6B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4582" y="6823692"/>
            <a:ext cx="1260281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>
                <a:solidFill>
                  <a:srgbClr val="FF0000"/>
                </a:solidFill>
                <a:latin typeface="Arial" charset="0"/>
              </a:rPr>
              <a:t>PAC1 </a:t>
            </a:r>
            <a:r>
              <a:rPr lang="en-US" sz="1114" dirty="0">
                <a:solidFill>
                  <a:srgbClr val="00B050"/>
                </a:solidFill>
                <a:latin typeface="Arial" charset="0"/>
              </a:rPr>
              <a:t>GFP</a:t>
            </a:r>
            <a:r>
              <a:rPr lang="en-US" sz="1114" dirty="0">
                <a:latin typeface="Arial" charset="0"/>
              </a:rPr>
              <a:t> </a:t>
            </a:r>
            <a:r>
              <a:rPr lang="en-US" sz="1114" dirty="0">
                <a:solidFill>
                  <a:srgbClr val="0070C0"/>
                </a:solidFill>
                <a:latin typeface="Arial" charset="0"/>
              </a:rPr>
              <a:t>DAPI</a:t>
            </a:r>
          </a:p>
        </p:txBody>
      </p:sp>
      <p:sp>
        <p:nvSpPr>
          <p:cNvPr id="96" name="TextBox 22">
            <a:extLst>
              <a:ext uri="{FF2B5EF4-FFF2-40B4-BE49-F238E27FC236}">
                <a16:creationId xmlns:a16="http://schemas.microsoft.com/office/drawing/2014/main" id="{ED988439-0F20-D54E-9164-E0855CD000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8134" y="6839198"/>
            <a:ext cx="1539204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>
                <a:solidFill>
                  <a:srgbClr val="FF0000"/>
                </a:solidFill>
                <a:latin typeface="Arial" charset="0"/>
              </a:rPr>
              <a:t>PAC1 </a:t>
            </a:r>
            <a:r>
              <a:rPr lang="en-US" sz="1114" dirty="0" err="1">
                <a:solidFill>
                  <a:srgbClr val="00B050"/>
                </a:solidFill>
                <a:latin typeface="Arial" charset="0"/>
              </a:rPr>
              <a:t>Cre</a:t>
            </a:r>
            <a:r>
              <a:rPr lang="en-US" sz="1114" dirty="0">
                <a:solidFill>
                  <a:srgbClr val="00B050"/>
                </a:solidFill>
                <a:latin typeface="Arial" charset="0"/>
              </a:rPr>
              <a:t>-GFP</a:t>
            </a:r>
            <a:r>
              <a:rPr lang="en-US" sz="1114" dirty="0">
                <a:latin typeface="Arial" charset="0"/>
              </a:rPr>
              <a:t> </a:t>
            </a:r>
            <a:r>
              <a:rPr lang="en-US" sz="1114" dirty="0">
                <a:solidFill>
                  <a:srgbClr val="0070C0"/>
                </a:solidFill>
                <a:latin typeface="Arial" charset="0"/>
              </a:rPr>
              <a:t>DAPI</a:t>
            </a:r>
          </a:p>
        </p:txBody>
      </p:sp>
      <p:sp>
        <p:nvSpPr>
          <p:cNvPr id="9" name="Freeform 8">
            <a:extLst>
              <a:ext uri="{FF2B5EF4-FFF2-40B4-BE49-F238E27FC236}">
                <a16:creationId xmlns:a16="http://schemas.microsoft.com/office/drawing/2014/main" id="{E8C7C6FB-CC25-F746-98AF-BFAF98C39B4A}"/>
              </a:ext>
            </a:extLst>
          </p:cNvPr>
          <p:cNvSpPr/>
          <p:nvPr/>
        </p:nvSpPr>
        <p:spPr>
          <a:xfrm>
            <a:off x="1146995" y="7555445"/>
            <a:ext cx="1237844" cy="1200224"/>
          </a:xfrm>
          <a:custGeom>
            <a:avLst/>
            <a:gdLst>
              <a:gd name="connsiteX0" fmla="*/ 0 w 1155971"/>
              <a:gd name="connsiteY0" fmla="*/ 0 h 1165074"/>
              <a:gd name="connsiteX1" fmla="*/ 41564 w 1155971"/>
              <a:gd name="connsiteY1" fmla="*/ 207818 h 1165074"/>
              <a:gd name="connsiteX2" fmla="*/ 96982 w 1155971"/>
              <a:gd name="connsiteY2" fmla="*/ 581891 h 1165074"/>
              <a:gd name="connsiteX3" fmla="*/ 263237 w 1155971"/>
              <a:gd name="connsiteY3" fmla="*/ 858982 h 1165074"/>
              <a:gd name="connsiteX4" fmla="*/ 526473 w 1155971"/>
              <a:gd name="connsiteY4" fmla="*/ 1080654 h 1165074"/>
              <a:gd name="connsiteX5" fmla="*/ 858982 w 1155971"/>
              <a:gd name="connsiteY5" fmla="*/ 1163782 h 1165074"/>
              <a:gd name="connsiteX6" fmla="*/ 1094509 w 1155971"/>
              <a:gd name="connsiteY6" fmla="*/ 1025236 h 1165074"/>
              <a:gd name="connsiteX7" fmla="*/ 1149928 w 1155971"/>
              <a:gd name="connsiteY7" fmla="*/ 831273 h 1165074"/>
              <a:gd name="connsiteX8" fmla="*/ 983673 w 1155971"/>
              <a:gd name="connsiteY8" fmla="*/ 484909 h 1165074"/>
              <a:gd name="connsiteX9" fmla="*/ 817418 w 1155971"/>
              <a:gd name="connsiteY9" fmla="*/ 290945 h 1165074"/>
              <a:gd name="connsiteX10" fmla="*/ 540328 w 1155971"/>
              <a:gd name="connsiteY10" fmla="*/ 207818 h 1165074"/>
              <a:gd name="connsiteX11" fmla="*/ 249382 w 1155971"/>
              <a:gd name="connsiteY11" fmla="*/ 41564 h 1165074"/>
              <a:gd name="connsiteX12" fmla="*/ 69273 w 1155971"/>
              <a:gd name="connsiteY12" fmla="*/ 13854 h 11650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1155971" h="1165074">
                <a:moveTo>
                  <a:pt x="0" y="0"/>
                </a:moveTo>
                <a:cubicBezTo>
                  <a:pt x="12700" y="55418"/>
                  <a:pt x="25400" y="110836"/>
                  <a:pt x="41564" y="207818"/>
                </a:cubicBezTo>
                <a:cubicBezTo>
                  <a:pt x="57728" y="304800"/>
                  <a:pt x="60037" y="473364"/>
                  <a:pt x="96982" y="581891"/>
                </a:cubicBezTo>
                <a:cubicBezTo>
                  <a:pt x="133928" y="690418"/>
                  <a:pt x="191655" y="775855"/>
                  <a:pt x="263237" y="858982"/>
                </a:cubicBezTo>
                <a:cubicBezTo>
                  <a:pt x="334819" y="942109"/>
                  <a:pt x="427182" y="1029854"/>
                  <a:pt x="526473" y="1080654"/>
                </a:cubicBezTo>
                <a:cubicBezTo>
                  <a:pt x="625764" y="1131454"/>
                  <a:pt x="764309" y="1173018"/>
                  <a:pt x="858982" y="1163782"/>
                </a:cubicBezTo>
                <a:cubicBezTo>
                  <a:pt x="953655" y="1154546"/>
                  <a:pt x="1046018" y="1080654"/>
                  <a:pt x="1094509" y="1025236"/>
                </a:cubicBezTo>
                <a:cubicBezTo>
                  <a:pt x="1143000" y="969818"/>
                  <a:pt x="1168401" y="921328"/>
                  <a:pt x="1149928" y="831273"/>
                </a:cubicBezTo>
                <a:cubicBezTo>
                  <a:pt x="1131455" y="741219"/>
                  <a:pt x="1039091" y="574963"/>
                  <a:pt x="983673" y="484909"/>
                </a:cubicBezTo>
                <a:cubicBezTo>
                  <a:pt x="928255" y="394855"/>
                  <a:pt x="891309" y="337127"/>
                  <a:pt x="817418" y="290945"/>
                </a:cubicBezTo>
                <a:cubicBezTo>
                  <a:pt x="743527" y="244763"/>
                  <a:pt x="635001" y="249382"/>
                  <a:pt x="540328" y="207818"/>
                </a:cubicBezTo>
                <a:cubicBezTo>
                  <a:pt x="445655" y="166255"/>
                  <a:pt x="327891" y="73891"/>
                  <a:pt x="249382" y="41564"/>
                </a:cubicBezTo>
                <a:cubicBezTo>
                  <a:pt x="170873" y="9237"/>
                  <a:pt x="120073" y="11545"/>
                  <a:pt x="69273" y="13854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24A734E0-10EB-264D-A588-E79F3547749A}"/>
              </a:ext>
            </a:extLst>
          </p:cNvPr>
          <p:cNvCxnSpPr>
            <a:cxnSpLocks/>
          </p:cNvCxnSpPr>
          <p:nvPr/>
        </p:nvCxnSpPr>
        <p:spPr>
          <a:xfrm flipH="1">
            <a:off x="2162628" y="7617911"/>
            <a:ext cx="126080" cy="177169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Freeform 98">
            <a:extLst>
              <a:ext uri="{FF2B5EF4-FFF2-40B4-BE49-F238E27FC236}">
                <a16:creationId xmlns:a16="http://schemas.microsoft.com/office/drawing/2014/main" id="{36216E6A-F81A-EF4F-85C6-E4CE37B9C9BB}"/>
              </a:ext>
            </a:extLst>
          </p:cNvPr>
          <p:cNvSpPr/>
          <p:nvPr/>
        </p:nvSpPr>
        <p:spPr>
          <a:xfrm>
            <a:off x="3909061" y="5365414"/>
            <a:ext cx="583320" cy="882987"/>
          </a:xfrm>
          <a:custGeom>
            <a:avLst/>
            <a:gdLst>
              <a:gd name="connsiteX0" fmla="*/ 623454 w 623454"/>
              <a:gd name="connsiteY0" fmla="*/ 0 h 1025237"/>
              <a:gd name="connsiteX1" fmla="*/ 512618 w 623454"/>
              <a:gd name="connsiteY1" fmla="*/ 152400 h 1025237"/>
              <a:gd name="connsiteX2" fmla="*/ 374073 w 623454"/>
              <a:gd name="connsiteY2" fmla="*/ 415637 h 1025237"/>
              <a:gd name="connsiteX3" fmla="*/ 235527 w 623454"/>
              <a:gd name="connsiteY3" fmla="*/ 678873 h 1025237"/>
              <a:gd name="connsiteX4" fmla="*/ 124691 w 623454"/>
              <a:gd name="connsiteY4" fmla="*/ 872837 h 1025237"/>
              <a:gd name="connsiteX5" fmla="*/ 0 w 623454"/>
              <a:gd name="connsiteY5" fmla="*/ 1025237 h 1025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23454" h="1025237">
                <a:moveTo>
                  <a:pt x="623454" y="0"/>
                </a:moveTo>
                <a:cubicBezTo>
                  <a:pt x="588818" y="41563"/>
                  <a:pt x="554182" y="83127"/>
                  <a:pt x="512618" y="152400"/>
                </a:cubicBezTo>
                <a:cubicBezTo>
                  <a:pt x="471054" y="221673"/>
                  <a:pt x="374073" y="415637"/>
                  <a:pt x="374073" y="415637"/>
                </a:cubicBezTo>
                <a:cubicBezTo>
                  <a:pt x="327891" y="503383"/>
                  <a:pt x="277091" y="602673"/>
                  <a:pt x="235527" y="678873"/>
                </a:cubicBezTo>
                <a:cubicBezTo>
                  <a:pt x="193963" y="755073"/>
                  <a:pt x="163945" y="815110"/>
                  <a:pt x="124691" y="872837"/>
                </a:cubicBezTo>
                <a:cubicBezTo>
                  <a:pt x="85437" y="930564"/>
                  <a:pt x="42718" y="977900"/>
                  <a:pt x="0" y="1025237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00" name="Freeform 99">
            <a:extLst>
              <a:ext uri="{FF2B5EF4-FFF2-40B4-BE49-F238E27FC236}">
                <a16:creationId xmlns:a16="http://schemas.microsoft.com/office/drawing/2014/main" id="{FCF46BC1-8966-AE4F-9A78-FD52B064191A}"/>
              </a:ext>
            </a:extLst>
          </p:cNvPr>
          <p:cNvSpPr/>
          <p:nvPr/>
        </p:nvSpPr>
        <p:spPr>
          <a:xfrm>
            <a:off x="3043928" y="4937635"/>
            <a:ext cx="182881" cy="152401"/>
          </a:xfrm>
          <a:custGeom>
            <a:avLst/>
            <a:gdLst>
              <a:gd name="connsiteX0" fmla="*/ 0 w 166255"/>
              <a:gd name="connsiteY0" fmla="*/ 138546 h 138546"/>
              <a:gd name="connsiteX1" fmla="*/ 69273 w 166255"/>
              <a:gd name="connsiteY1" fmla="*/ 55418 h 138546"/>
              <a:gd name="connsiteX2" fmla="*/ 166255 w 166255"/>
              <a:gd name="connsiteY2" fmla="*/ 0 h 1385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66255" h="138546">
                <a:moveTo>
                  <a:pt x="0" y="138546"/>
                </a:moveTo>
                <a:cubicBezTo>
                  <a:pt x="20782" y="108527"/>
                  <a:pt x="41564" y="78509"/>
                  <a:pt x="69273" y="55418"/>
                </a:cubicBezTo>
                <a:cubicBezTo>
                  <a:pt x="96982" y="32327"/>
                  <a:pt x="131618" y="16163"/>
                  <a:pt x="166255" y="0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02" name="Freeform 101">
            <a:extLst>
              <a:ext uri="{FF2B5EF4-FFF2-40B4-BE49-F238E27FC236}">
                <a16:creationId xmlns:a16="http://schemas.microsoft.com/office/drawing/2014/main" id="{C093862F-F916-064E-A93B-D11956A0E55C}"/>
              </a:ext>
            </a:extLst>
          </p:cNvPr>
          <p:cNvSpPr/>
          <p:nvPr/>
        </p:nvSpPr>
        <p:spPr>
          <a:xfrm>
            <a:off x="5401065" y="5319345"/>
            <a:ext cx="583320" cy="882987"/>
          </a:xfrm>
          <a:custGeom>
            <a:avLst/>
            <a:gdLst>
              <a:gd name="connsiteX0" fmla="*/ 623454 w 623454"/>
              <a:gd name="connsiteY0" fmla="*/ 0 h 1025237"/>
              <a:gd name="connsiteX1" fmla="*/ 512618 w 623454"/>
              <a:gd name="connsiteY1" fmla="*/ 152400 h 1025237"/>
              <a:gd name="connsiteX2" fmla="*/ 374073 w 623454"/>
              <a:gd name="connsiteY2" fmla="*/ 415637 h 1025237"/>
              <a:gd name="connsiteX3" fmla="*/ 235527 w 623454"/>
              <a:gd name="connsiteY3" fmla="*/ 678873 h 1025237"/>
              <a:gd name="connsiteX4" fmla="*/ 124691 w 623454"/>
              <a:gd name="connsiteY4" fmla="*/ 872837 h 1025237"/>
              <a:gd name="connsiteX5" fmla="*/ 0 w 623454"/>
              <a:gd name="connsiteY5" fmla="*/ 1025237 h 1025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23454" h="1025237">
                <a:moveTo>
                  <a:pt x="623454" y="0"/>
                </a:moveTo>
                <a:cubicBezTo>
                  <a:pt x="588818" y="41563"/>
                  <a:pt x="554182" y="83127"/>
                  <a:pt x="512618" y="152400"/>
                </a:cubicBezTo>
                <a:cubicBezTo>
                  <a:pt x="471054" y="221673"/>
                  <a:pt x="374073" y="415637"/>
                  <a:pt x="374073" y="415637"/>
                </a:cubicBezTo>
                <a:cubicBezTo>
                  <a:pt x="327891" y="503383"/>
                  <a:pt x="277091" y="602673"/>
                  <a:pt x="235527" y="678873"/>
                </a:cubicBezTo>
                <a:cubicBezTo>
                  <a:pt x="193963" y="755073"/>
                  <a:pt x="163945" y="815110"/>
                  <a:pt x="124691" y="872837"/>
                </a:cubicBezTo>
                <a:cubicBezTo>
                  <a:pt x="85437" y="930564"/>
                  <a:pt x="42718" y="977900"/>
                  <a:pt x="0" y="1025237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03" name="Freeform 102">
            <a:extLst>
              <a:ext uri="{FF2B5EF4-FFF2-40B4-BE49-F238E27FC236}">
                <a16:creationId xmlns:a16="http://schemas.microsoft.com/office/drawing/2014/main" id="{323A8196-56F9-4045-B5BE-83048F368F7D}"/>
              </a:ext>
            </a:extLst>
          </p:cNvPr>
          <p:cNvSpPr/>
          <p:nvPr/>
        </p:nvSpPr>
        <p:spPr>
          <a:xfrm>
            <a:off x="6998186" y="5319345"/>
            <a:ext cx="583320" cy="882987"/>
          </a:xfrm>
          <a:custGeom>
            <a:avLst/>
            <a:gdLst>
              <a:gd name="connsiteX0" fmla="*/ 623454 w 623454"/>
              <a:gd name="connsiteY0" fmla="*/ 0 h 1025237"/>
              <a:gd name="connsiteX1" fmla="*/ 512618 w 623454"/>
              <a:gd name="connsiteY1" fmla="*/ 152400 h 1025237"/>
              <a:gd name="connsiteX2" fmla="*/ 374073 w 623454"/>
              <a:gd name="connsiteY2" fmla="*/ 415637 h 1025237"/>
              <a:gd name="connsiteX3" fmla="*/ 235527 w 623454"/>
              <a:gd name="connsiteY3" fmla="*/ 678873 h 1025237"/>
              <a:gd name="connsiteX4" fmla="*/ 124691 w 623454"/>
              <a:gd name="connsiteY4" fmla="*/ 872837 h 1025237"/>
              <a:gd name="connsiteX5" fmla="*/ 0 w 623454"/>
              <a:gd name="connsiteY5" fmla="*/ 1025237 h 1025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23454" h="1025237">
                <a:moveTo>
                  <a:pt x="623454" y="0"/>
                </a:moveTo>
                <a:cubicBezTo>
                  <a:pt x="588818" y="41563"/>
                  <a:pt x="554182" y="83127"/>
                  <a:pt x="512618" y="152400"/>
                </a:cubicBezTo>
                <a:cubicBezTo>
                  <a:pt x="471054" y="221673"/>
                  <a:pt x="374073" y="415637"/>
                  <a:pt x="374073" y="415637"/>
                </a:cubicBezTo>
                <a:cubicBezTo>
                  <a:pt x="327891" y="503383"/>
                  <a:pt x="277091" y="602673"/>
                  <a:pt x="235527" y="678873"/>
                </a:cubicBezTo>
                <a:cubicBezTo>
                  <a:pt x="193963" y="755073"/>
                  <a:pt x="163945" y="815110"/>
                  <a:pt x="124691" y="872837"/>
                </a:cubicBezTo>
                <a:cubicBezTo>
                  <a:pt x="85437" y="930564"/>
                  <a:pt x="42718" y="977900"/>
                  <a:pt x="0" y="1025237"/>
                </a:cubicBezTo>
              </a:path>
            </a:pathLst>
          </a:cu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</p:spTree>
    <p:extLst>
      <p:ext uri="{BB962C8B-B14F-4D97-AF65-F5344CB8AC3E}">
        <p14:creationId xmlns:p14="http://schemas.microsoft.com/office/powerpoint/2010/main" val="8005346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indoor&#10;&#10;Description automatically generated">
            <a:extLst>
              <a:ext uri="{FF2B5EF4-FFF2-40B4-BE49-F238E27FC236}">
                <a16:creationId xmlns:a16="http://schemas.microsoft.com/office/drawing/2014/main" id="{C85C0717-A25B-6645-954E-38136E6D83E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3678" y="959148"/>
            <a:ext cx="2540953" cy="2540953"/>
          </a:xfrm>
          <a:prstGeom prst="rect">
            <a:avLst/>
          </a:prstGeom>
        </p:spPr>
      </p:pic>
      <p:pic>
        <p:nvPicPr>
          <p:cNvPr id="6" name="Picture 5" descr="A picture containing indoor, night&#10;&#10;Description automatically generated">
            <a:extLst>
              <a:ext uri="{FF2B5EF4-FFF2-40B4-BE49-F238E27FC236}">
                <a16:creationId xmlns:a16="http://schemas.microsoft.com/office/drawing/2014/main" id="{2FDFBB06-1099-8F4D-8CC9-A9BEE1A49AFE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8663" y="959148"/>
            <a:ext cx="2540953" cy="2540953"/>
          </a:xfrm>
          <a:prstGeom prst="rect">
            <a:avLst/>
          </a:prstGeom>
        </p:spPr>
      </p:pic>
      <p:pic>
        <p:nvPicPr>
          <p:cNvPr id="10" name="Picture 9" descr="A picture containing tree, grass, outdoor, sitting&#10;&#10;Description automatically generated">
            <a:extLst>
              <a:ext uri="{FF2B5EF4-FFF2-40B4-BE49-F238E27FC236}">
                <a16:creationId xmlns:a16="http://schemas.microsoft.com/office/drawing/2014/main" id="{0C35E0AF-2C50-BE45-ADB0-A4197B4562C9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1453" y="4141510"/>
            <a:ext cx="2693178" cy="201988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08749C43-3A7D-8745-A870-22412EB02437}"/>
              </a:ext>
            </a:extLst>
          </p:cNvPr>
          <p:cNvSpPr txBox="1"/>
          <p:nvPr/>
        </p:nvSpPr>
        <p:spPr>
          <a:xfrm>
            <a:off x="391393" y="617011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996BEE1-1334-BF4B-B81A-810470F96D09}"/>
              </a:ext>
            </a:extLst>
          </p:cNvPr>
          <p:cNvSpPr txBox="1"/>
          <p:nvPr/>
        </p:nvSpPr>
        <p:spPr>
          <a:xfrm>
            <a:off x="299251" y="3445900"/>
            <a:ext cx="38985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C0CBF0D-AEAB-A840-AAEE-5CE0294AE4C5}"/>
              </a:ext>
            </a:extLst>
          </p:cNvPr>
          <p:cNvSpPr txBox="1"/>
          <p:nvPr/>
        </p:nvSpPr>
        <p:spPr>
          <a:xfrm>
            <a:off x="3650126" y="498417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E79885-3FC7-8843-9FDA-AE6F19726510}"/>
              </a:ext>
            </a:extLst>
          </p:cNvPr>
          <p:cNvSpPr txBox="1"/>
          <p:nvPr/>
        </p:nvSpPr>
        <p:spPr>
          <a:xfrm>
            <a:off x="3502420" y="3500100"/>
            <a:ext cx="38985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FF81C11-1A25-5A40-86C6-64FA6E1D57A4}"/>
              </a:ext>
            </a:extLst>
          </p:cNvPr>
          <p:cNvSpPr txBox="1"/>
          <p:nvPr/>
        </p:nvSpPr>
        <p:spPr>
          <a:xfrm>
            <a:off x="5697418" y="9753701"/>
            <a:ext cx="1984839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Rajbhandari Figure S3</a:t>
            </a:r>
          </a:p>
        </p:txBody>
      </p:sp>
      <p:sp>
        <p:nvSpPr>
          <p:cNvPr id="12" name="TextBox 22">
            <a:extLst>
              <a:ext uri="{FF2B5EF4-FFF2-40B4-BE49-F238E27FC236}">
                <a16:creationId xmlns:a16="http://schemas.microsoft.com/office/drawing/2014/main" id="{99A05E8C-81DF-4042-982B-DFBED01239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4207" y="701675"/>
            <a:ext cx="2332690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 err="1">
                <a:solidFill>
                  <a:srgbClr val="FF0000"/>
                </a:solidFill>
                <a:latin typeface="Arial" charset="0"/>
              </a:rPr>
              <a:t>RNAscope</a:t>
            </a:r>
            <a:r>
              <a:rPr lang="en-US" sz="1114" dirty="0">
                <a:solidFill>
                  <a:srgbClr val="FF0000"/>
                </a:solidFill>
                <a:latin typeface="Arial" charset="0"/>
              </a:rPr>
              <a:t> positive control in BLA</a:t>
            </a:r>
            <a:endParaRPr lang="en-US" sz="1114" dirty="0">
              <a:solidFill>
                <a:srgbClr val="0070C0"/>
              </a:solidFill>
              <a:latin typeface="Arial" charset="0"/>
            </a:endParaRPr>
          </a:p>
        </p:txBody>
      </p:sp>
      <p:sp>
        <p:nvSpPr>
          <p:cNvPr id="13" name="TextBox 22">
            <a:extLst>
              <a:ext uri="{FF2B5EF4-FFF2-40B4-BE49-F238E27FC236}">
                <a16:creationId xmlns:a16="http://schemas.microsoft.com/office/drawing/2014/main" id="{76C00B25-62B0-6942-A0CA-B6E24DA55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7271" y="701549"/>
            <a:ext cx="2388795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 err="1">
                <a:solidFill>
                  <a:srgbClr val="FF0000"/>
                </a:solidFill>
                <a:latin typeface="Arial" charset="0"/>
              </a:rPr>
              <a:t>RNAscope</a:t>
            </a:r>
            <a:r>
              <a:rPr lang="en-US" sz="1114" dirty="0">
                <a:solidFill>
                  <a:srgbClr val="FF0000"/>
                </a:solidFill>
                <a:latin typeface="Arial" charset="0"/>
              </a:rPr>
              <a:t> negative control in BLA</a:t>
            </a:r>
            <a:endParaRPr lang="en-US" sz="1114" dirty="0">
              <a:solidFill>
                <a:srgbClr val="0070C0"/>
              </a:solidFill>
              <a:latin typeface="Arial" charset="0"/>
            </a:endParaRPr>
          </a:p>
        </p:txBody>
      </p:sp>
      <p:sp>
        <p:nvSpPr>
          <p:cNvPr id="14" name="TextBox 22">
            <a:extLst>
              <a:ext uri="{FF2B5EF4-FFF2-40B4-BE49-F238E27FC236}">
                <a16:creationId xmlns:a16="http://schemas.microsoft.com/office/drawing/2014/main" id="{E8868F20-A725-FE4A-BD66-E2E1010CCC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6409" y="3852165"/>
            <a:ext cx="1157689" cy="26379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r>
              <a:rPr lang="en-US" sz="1114" dirty="0">
                <a:solidFill>
                  <a:srgbClr val="00B050"/>
                </a:solidFill>
                <a:latin typeface="Arial" charset="0"/>
              </a:rPr>
              <a:t>FoxP2</a:t>
            </a:r>
            <a:r>
              <a:rPr lang="en-US" sz="1114" dirty="0">
                <a:solidFill>
                  <a:srgbClr val="FF0000"/>
                </a:solidFill>
                <a:latin typeface="Arial" charset="0"/>
              </a:rPr>
              <a:t> </a:t>
            </a:r>
            <a:r>
              <a:rPr lang="en-US" sz="1114" dirty="0" err="1">
                <a:solidFill>
                  <a:srgbClr val="FF0000"/>
                </a:solidFill>
                <a:latin typeface="Arial" charset="0"/>
              </a:rPr>
              <a:t>mcherry</a:t>
            </a:r>
            <a:endParaRPr lang="en-US" sz="1114" dirty="0">
              <a:solidFill>
                <a:srgbClr val="FF0000"/>
              </a:solidFill>
              <a:latin typeface="Arial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8DDFB8E-F995-794E-9531-8D20FCCC94AA}"/>
              </a:ext>
            </a:extLst>
          </p:cNvPr>
          <p:cNvSpPr txBox="1"/>
          <p:nvPr/>
        </p:nvSpPr>
        <p:spPr>
          <a:xfrm rot="16383052">
            <a:off x="2826802" y="5289184"/>
            <a:ext cx="873957" cy="363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6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CCs</a:t>
            </a:r>
            <a:endParaRPr lang="en-US" sz="176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2B519CD-7534-DF48-BF83-0D4DF8C87E17}"/>
              </a:ext>
            </a:extLst>
          </p:cNvPr>
          <p:cNvSpPr txBox="1"/>
          <p:nvPr/>
        </p:nvSpPr>
        <p:spPr>
          <a:xfrm>
            <a:off x="1459638" y="4847174"/>
            <a:ext cx="623889" cy="363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6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A</a:t>
            </a:r>
            <a:endParaRPr lang="en-US" sz="176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Freeform 6">
            <a:extLst>
              <a:ext uri="{FF2B5EF4-FFF2-40B4-BE49-F238E27FC236}">
                <a16:creationId xmlns:a16="http://schemas.microsoft.com/office/drawing/2014/main" id="{2469A4C2-6C23-D044-8CD3-9CE56037C928}"/>
              </a:ext>
            </a:extLst>
          </p:cNvPr>
          <p:cNvSpPr/>
          <p:nvPr/>
        </p:nvSpPr>
        <p:spPr>
          <a:xfrm>
            <a:off x="1058870" y="4164360"/>
            <a:ext cx="1824225" cy="1926239"/>
          </a:xfrm>
          <a:custGeom>
            <a:avLst/>
            <a:gdLst>
              <a:gd name="connsiteX0" fmla="*/ 1247348 w 1658386"/>
              <a:gd name="connsiteY0" fmla="*/ 1751126 h 1751126"/>
              <a:gd name="connsiteX1" fmla="*/ 1524439 w 1658386"/>
              <a:gd name="connsiteY1" fmla="*/ 1598726 h 1751126"/>
              <a:gd name="connsiteX2" fmla="*/ 1649130 w 1658386"/>
              <a:gd name="connsiteY2" fmla="*/ 1377053 h 1751126"/>
              <a:gd name="connsiteX3" fmla="*/ 1635276 w 1658386"/>
              <a:gd name="connsiteY3" fmla="*/ 1016835 h 1751126"/>
              <a:gd name="connsiteX4" fmla="*/ 1524439 w 1658386"/>
              <a:gd name="connsiteY4" fmla="*/ 518071 h 1751126"/>
              <a:gd name="connsiteX5" fmla="*/ 1455167 w 1658386"/>
              <a:gd name="connsiteY5" fmla="*/ 240980 h 1751126"/>
              <a:gd name="connsiteX6" fmla="*/ 1275057 w 1658386"/>
              <a:gd name="connsiteY6" fmla="*/ 60871 h 1751126"/>
              <a:gd name="connsiteX7" fmla="*/ 942548 w 1658386"/>
              <a:gd name="connsiteY7" fmla="*/ 5453 h 1751126"/>
              <a:gd name="connsiteX8" fmla="*/ 471494 w 1658386"/>
              <a:gd name="connsiteY8" fmla="*/ 19308 h 1751126"/>
              <a:gd name="connsiteX9" fmla="*/ 97421 w 1658386"/>
              <a:gd name="connsiteY9" fmla="*/ 157853 h 1751126"/>
              <a:gd name="connsiteX10" fmla="*/ 439 w 1658386"/>
              <a:gd name="connsiteY10" fmla="*/ 421089 h 1751126"/>
              <a:gd name="connsiteX11" fmla="*/ 69712 w 1658386"/>
              <a:gd name="connsiteY11" fmla="*/ 753599 h 1751126"/>
              <a:gd name="connsiteX12" fmla="*/ 249821 w 1658386"/>
              <a:gd name="connsiteY12" fmla="*/ 1280071 h 1751126"/>
              <a:gd name="connsiteX13" fmla="*/ 651603 w 1658386"/>
              <a:gd name="connsiteY13" fmla="*/ 1571017 h 1751126"/>
              <a:gd name="connsiteX14" fmla="*/ 984112 w 1658386"/>
              <a:gd name="connsiteY14" fmla="*/ 1681853 h 1751126"/>
              <a:gd name="connsiteX15" fmla="*/ 1178076 w 1658386"/>
              <a:gd name="connsiteY15" fmla="*/ 1709562 h 17511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658386" h="1751126">
                <a:moveTo>
                  <a:pt x="1247348" y="1751126"/>
                </a:moveTo>
                <a:cubicBezTo>
                  <a:pt x="1352411" y="1706098"/>
                  <a:pt x="1457475" y="1661071"/>
                  <a:pt x="1524439" y="1598726"/>
                </a:cubicBezTo>
                <a:cubicBezTo>
                  <a:pt x="1591403" y="1536381"/>
                  <a:pt x="1630657" y="1474035"/>
                  <a:pt x="1649130" y="1377053"/>
                </a:cubicBezTo>
                <a:cubicBezTo>
                  <a:pt x="1667603" y="1280071"/>
                  <a:pt x="1656058" y="1159999"/>
                  <a:pt x="1635276" y="1016835"/>
                </a:cubicBezTo>
                <a:cubicBezTo>
                  <a:pt x="1614494" y="873671"/>
                  <a:pt x="1554457" y="647380"/>
                  <a:pt x="1524439" y="518071"/>
                </a:cubicBezTo>
                <a:cubicBezTo>
                  <a:pt x="1494421" y="388762"/>
                  <a:pt x="1496731" y="317180"/>
                  <a:pt x="1455167" y="240980"/>
                </a:cubicBezTo>
                <a:cubicBezTo>
                  <a:pt x="1413603" y="164780"/>
                  <a:pt x="1360493" y="100125"/>
                  <a:pt x="1275057" y="60871"/>
                </a:cubicBezTo>
                <a:cubicBezTo>
                  <a:pt x="1189621" y="21617"/>
                  <a:pt x="1076475" y="12380"/>
                  <a:pt x="942548" y="5453"/>
                </a:cubicBezTo>
                <a:cubicBezTo>
                  <a:pt x="808621" y="-1474"/>
                  <a:pt x="612348" y="-6092"/>
                  <a:pt x="471494" y="19308"/>
                </a:cubicBezTo>
                <a:cubicBezTo>
                  <a:pt x="330640" y="44708"/>
                  <a:pt x="175930" y="90890"/>
                  <a:pt x="97421" y="157853"/>
                </a:cubicBezTo>
                <a:cubicBezTo>
                  <a:pt x="18912" y="224816"/>
                  <a:pt x="5057" y="321798"/>
                  <a:pt x="439" y="421089"/>
                </a:cubicBezTo>
                <a:cubicBezTo>
                  <a:pt x="-4179" y="520380"/>
                  <a:pt x="28148" y="610435"/>
                  <a:pt x="69712" y="753599"/>
                </a:cubicBezTo>
                <a:cubicBezTo>
                  <a:pt x="111276" y="896763"/>
                  <a:pt x="152839" y="1143835"/>
                  <a:pt x="249821" y="1280071"/>
                </a:cubicBezTo>
                <a:cubicBezTo>
                  <a:pt x="346803" y="1416307"/>
                  <a:pt x="529221" y="1504053"/>
                  <a:pt x="651603" y="1571017"/>
                </a:cubicBezTo>
                <a:cubicBezTo>
                  <a:pt x="773985" y="1637981"/>
                  <a:pt x="896367" y="1658762"/>
                  <a:pt x="984112" y="1681853"/>
                </a:cubicBezTo>
                <a:cubicBezTo>
                  <a:pt x="1071857" y="1704944"/>
                  <a:pt x="1124966" y="1707253"/>
                  <a:pt x="1178076" y="1709562"/>
                </a:cubicBezTo>
              </a:path>
            </a:pathLst>
          </a:cu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971FB22-A15B-1649-AB53-626ECBDA290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10059" y="3932078"/>
            <a:ext cx="2889057" cy="2752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92843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3926E40-212C-234F-BBBC-94616DA1FC2F}"/>
              </a:ext>
            </a:extLst>
          </p:cNvPr>
          <p:cNvSpPr txBox="1"/>
          <p:nvPr/>
        </p:nvSpPr>
        <p:spPr>
          <a:xfrm>
            <a:off x="5656399" y="9739336"/>
            <a:ext cx="1984839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Rajbhandari Figure S4</a:t>
            </a:r>
          </a:p>
        </p:txBody>
      </p:sp>
      <p:pic>
        <p:nvPicPr>
          <p:cNvPr id="6" name="Picture 5" descr="A picture containing indoor, sitting, tree&#10;&#10;Description automatically generated">
            <a:extLst>
              <a:ext uri="{FF2B5EF4-FFF2-40B4-BE49-F238E27FC236}">
                <a16:creationId xmlns:a16="http://schemas.microsoft.com/office/drawing/2014/main" id="{08CFF54F-4B45-6544-A7E9-A58B0D32AF1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33136"/>
          <a:stretch/>
        </p:blipFill>
        <p:spPr>
          <a:xfrm>
            <a:off x="1166096" y="3906065"/>
            <a:ext cx="5049299" cy="4951728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6C26D75-469A-4B42-917C-2DBD08FCFD01}"/>
              </a:ext>
            </a:extLst>
          </p:cNvPr>
          <p:cNvSpPr txBox="1"/>
          <p:nvPr/>
        </p:nvSpPr>
        <p:spPr>
          <a:xfrm>
            <a:off x="738921" y="278750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4DAD250-F959-FB4A-AB4E-8C8DB4D3DA37}"/>
              </a:ext>
            </a:extLst>
          </p:cNvPr>
          <p:cNvSpPr txBox="1"/>
          <p:nvPr/>
        </p:nvSpPr>
        <p:spPr>
          <a:xfrm>
            <a:off x="738442" y="3277947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 descr="Trial3_3_Overlay.tif">
            <a:extLst>
              <a:ext uri="{FF2B5EF4-FFF2-40B4-BE49-F238E27FC236}">
                <a16:creationId xmlns:a16="http://schemas.microsoft.com/office/drawing/2014/main" id="{BDEA6B89-FD0A-B84E-895E-A0AA003FF10F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80621" y="953030"/>
            <a:ext cx="2761988" cy="207149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F628EC2-C465-AD44-A1BF-2EC49E572026}"/>
              </a:ext>
            </a:extLst>
          </p:cNvPr>
          <p:cNvSpPr txBox="1"/>
          <p:nvPr/>
        </p:nvSpPr>
        <p:spPr>
          <a:xfrm>
            <a:off x="1853789" y="614476"/>
            <a:ext cx="1391728" cy="32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cytin </a:t>
            </a:r>
            <a:r>
              <a:rPr lang="en-US" sz="154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A05D7C-32D0-8446-96A1-774592C9FE04}"/>
              </a:ext>
            </a:extLst>
          </p:cNvPr>
          <p:cNvSpPr txBox="1"/>
          <p:nvPr/>
        </p:nvSpPr>
        <p:spPr>
          <a:xfrm>
            <a:off x="4484360" y="3567511"/>
            <a:ext cx="1391728" cy="3293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54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cytin </a:t>
            </a:r>
            <a:r>
              <a:rPr lang="en-US" sz="154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5" name="Freeform 4">
            <a:extLst>
              <a:ext uri="{FF2B5EF4-FFF2-40B4-BE49-F238E27FC236}">
                <a16:creationId xmlns:a16="http://schemas.microsoft.com/office/drawing/2014/main" id="{9432DE8C-3A01-2445-81F2-6E3393DBE247}"/>
              </a:ext>
            </a:extLst>
          </p:cNvPr>
          <p:cNvSpPr/>
          <p:nvPr/>
        </p:nvSpPr>
        <p:spPr>
          <a:xfrm>
            <a:off x="2415176" y="1661159"/>
            <a:ext cx="747124" cy="951071"/>
          </a:xfrm>
          <a:custGeom>
            <a:avLst/>
            <a:gdLst>
              <a:gd name="connsiteX0" fmla="*/ 679204 w 679204"/>
              <a:gd name="connsiteY0" fmla="*/ 0 h 864610"/>
              <a:gd name="connsiteX1" fmla="*/ 651495 w 679204"/>
              <a:gd name="connsiteY1" fmla="*/ 263237 h 864610"/>
              <a:gd name="connsiteX2" fmla="*/ 609931 w 679204"/>
              <a:gd name="connsiteY2" fmla="*/ 374073 h 864610"/>
              <a:gd name="connsiteX3" fmla="*/ 582222 w 679204"/>
              <a:gd name="connsiteY3" fmla="*/ 512619 h 864610"/>
              <a:gd name="connsiteX4" fmla="*/ 540659 w 679204"/>
              <a:gd name="connsiteY4" fmla="*/ 595746 h 864610"/>
              <a:gd name="connsiteX5" fmla="*/ 471386 w 679204"/>
              <a:gd name="connsiteY5" fmla="*/ 692728 h 864610"/>
              <a:gd name="connsiteX6" fmla="*/ 415968 w 679204"/>
              <a:gd name="connsiteY6" fmla="*/ 748146 h 864610"/>
              <a:gd name="connsiteX7" fmla="*/ 346695 w 679204"/>
              <a:gd name="connsiteY7" fmla="*/ 817419 h 864610"/>
              <a:gd name="connsiteX8" fmla="*/ 249713 w 679204"/>
              <a:gd name="connsiteY8" fmla="*/ 845128 h 864610"/>
              <a:gd name="connsiteX9" fmla="*/ 138877 w 679204"/>
              <a:gd name="connsiteY9" fmla="*/ 858982 h 864610"/>
              <a:gd name="connsiteX10" fmla="*/ 331 w 679204"/>
              <a:gd name="connsiteY10" fmla="*/ 748146 h 864610"/>
              <a:gd name="connsiteX11" fmla="*/ 97313 w 679204"/>
              <a:gd name="connsiteY11" fmla="*/ 581891 h 864610"/>
              <a:gd name="connsiteX12" fmla="*/ 111168 w 679204"/>
              <a:gd name="connsiteY12" fmla="*/ 526473 h 864610"/>
              <a:gd name="connsiteX13" fmla="*/ 152731 w 679204"/>
              <a:gd name="connsiteY13" fmla="*/ 429491 h 864610"/>
              <a:gd name="connsiteX14" fmla="*/ 208150 w 679204"/>
              <a:gd name="connsiteY14" fmla="*/ 346364 h 864610"/>
              <a:gd name="connsiteX15" fmla="*/ 208150 w 679204"/>
              <a:gd name="connsiteY15" fmla="*/ 346364 h 8646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679204" h="864610">
                <a:moveTo>
                  <a:pt x="679204" y="0"/>
                </a:moveTo>
                <a:cubicBezTo>
                  <a:pt x="671122" y="100446"/>
                  <a:pt x="663040" y="200892"/>
                  <a:pt x="651495" y="263237"/>
                </a:cubicBezTo>
                <a:cubicBezTo>
                  <a:pt x="639949" y="325583"/>
                  <a:pt x="621476" y="332509"/>
                  <a:pt x="609931" y="374073"/>
                </a:cubicBezTo>
                <a:cubicBezTo>
                  <a:pt x="598386" y="415637"/>
                  <a:pt x="582222" y="512619"/>
                  <a:pt x="582222" y="512619"/>
                </a:cubicBezTo>
                <a:cubicBezTo>
                  <a:pt x="570677" y="549565"/>
                  <a:pt x="559132" y="565728"/>
                  <a:pt x="540659" y="595746"/>
                </a:cubicBezTo>
                <a:cubicBezTo>
                  <a:pt x="522186" y="625764"/>
                  <a:pt x="471386" y="692728"/>
                  <a:pt x="471386" y="692728"/>
                </a:cubicBezTo>
                <a:cubicBezTo>
                  <a:pt x="450604" y="718128"/>
                  <a:pt x="415968" y="748146"/>
                  <a:pt x="415968" y="748146"/>
                </a:cubicBezTo>
                <a:cubicBezTo>
                  <a:pt x="395186" y="768928"/>
                  <a:pt x="374404" y="801255"/>
                  <a:pt x="346695" y="817419"/>
                </a:cubicBezTo>
                <a:cubicBezTo>
                  <a:pt x="318986" y="833583"/>
                  <a:pt x="284349" y="838201"/>
                  <a:pt x="249713" y="845128"/>
                </a:cubicBezTo>
                <a:cubicBezTo>
                  <a:pt x="215077" y="852055"/>
                  <a:pt x="180441" y="875146"/>
                  <a:pt x="138877" y="858982"/>
                </a:cubicBezTo>
                <a:cubicBezTo>
                  <a:pt x="97313" y="842818"/>
                  <a:pt x="7258" y="794328"/>
                  <a:pt x="331" y="748146"/>
                </a:cubicBezTo>
                <a:cubicBezTo>
                  <a:pt x="-6596" y="701964"/>
                  <a:pt x="97313" y="581891"/>
                  <a:pt x="97313" y="581891"/>
                </a:cubicBezTo>
                <a:cubicBezTo>
                  <a:pt x="115786" y="544946"/>
                  <a:pt x="101932" y="551873"/>
                  <a:pt x="111168" y="526473"/>
                </a:cubicBezTo>
                <a:cubicBezTo>
                  <a:pt x="120404" y="501073"/>
                  <a:pt x="152731" y="429491"/>
                  <a:pt x="152731" y="429491"/>
                </a:cubicBezTo>
                <a:cubicBezTo>
                  <a:pt x="168895" y="399473"/>
                  <a:pt x="208150" y="346364"/>
                  <a:pt x="208150" y="346364"/>
                </a:cubicBezTo>
                <a:lnTo>
                  <a:pt x="208150" y="346364"/>
                </a:lnTo>
              </a:path>
            </a:pathLst>
          </a:cu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9" name="Freeform 8">
            <a:extLst>
              <a:ext uri="{FF2B5EF4-FFF2-40B4-BE49-F238E27FC236}">
                <a16:creationId xmlns:a16="http://schemas.microsoft.com/office/drawing/2014/main" id="{CBF68A70-A29C-F046-8296-FFF1035B3168}"/>
              </a:ext>
            </a:extLst>
          </p:cNvPr>
          <p:cNvSpPr/>
          <p:nvPr/>
        </p:nvSpPr>
        <p:spPr>
          <a:xfrm>
            <a:off x="2811781" y="1661160"/>
            <a:ext cx="320040" cy="243840"/>
          </a:xfrm>
          <a:custGeom>
            <a:avLst/>
            <a:gdLst>
              <a:gd name="connsiteX0" fmla="*/ 0 w 290945"/>
              <a:gd name="connsiteY0" fmla="*/ 221673 h 221673"/>
              <a:gd name="connsiteX1" fmla="*/ 55418 w 290945"/>
              <a:gd name="connsiteY1" fmla="*/ 166255 h 221673"/>
              <a:gd name="connsiteX2" fmla="*/ 166254 w 290945"/>
              <a:gd name="connsiteY2" fmla="*/ 55419 h 221673"/>
              <a:gd name="connsiteX3" fmla="*/ 290945 w 290945"/>
              <a:gd name="connsiteY3" fmla="*/ 0 h 22167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0945" h="221673">
                <a:moveTo>
                  <a:pt x="0" y="221673"/>
                </a:moveTo>
                <a:lnTo>
                  <a:pt x="55418" y="166255"/>
                </a:lnTo>
                <a:cubicBezTo>
                  <a:pt x="83127" y="138546"/>
                  <a:pt x="127000" y="83128"/>
                  <a:pt x="166254" y="55419"/>
                </a:cubicBezTo>
                <a:cubicBezTo>
                  <a:pt x="205508" y="27710"/>
                  <a:pt x="248226" y="13855"/>
                  <a:pt x="290945" y="0"/>
                </a:cubicBezTo>
              </a:path>
            </a:pathLst>
          </a:cu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24953D9-2D67-E947-85EA-3835E5EF3318}"/>
              </a:ext>
            </a:extLst>
          </p:cNvPr>
          <p:cNvSpPr txBox="1"/>
          <p:nvPr/>
        </p:nvSpPr>
        <p:spPr>
          <a:xfrm>
            <a:off x="2597686" y="2136695"/>
            <a:ext cx="479618" cy="2785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1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</a:p>
        </p:txBody>
      </p:sp>
    </p:spTree>
    <p:extLst>
      <p:ext uri="{BB962C8B-B14F-4D97-AF65-F5344CB8AC3E}">
        <p14:creationId xmlns:p14="http://schemas.microsoft.com/office/powerpoint/2010/main" val="14400691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map&#10;&#10;Description automatically generated">
            <a:extLst>
              <a:ext uri="{FF2B5EF4-FFF2-40B4-BE49-F238E27FC236}">
                <a16:creationId xmlns:a16="http://schemas.microsoft.com/office/drawing/2014/main" id="{B5C0C5C3-A3FE-E541-879D-D7A67E684D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4584" r="69982" b="1"/>
          <a:stretch/>
        </p:blipFill>
        <p:spPr>
          <a:xfrm>
            <a:off x="1416816" y="4023709"/>
            <a:ext cx="4485735" cy="326017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2CE173A-268A-6E4C-B9AF-319465DF68D7}"/>
              </a:ext>
            </a:extLst>
          </p:cNvPr>
          <p:cNvSpPr txBox="1"/>
          <p:nvPr/>
        </p:nvSpPr>
        <p:spPr>
          <a:xfrm>
            <a:off x="5656399" y="9738975"/>
            <a:ext cx="1984839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b="1" dirty="0">
                <a:latin typeface="Arial" panose="020B0604020202020204" pitchFamily="34" charset="0"/>
                <a:cs typeface="Arial" panose="020B0604020202020204" pitchFamily="34" charset="0"/>
              </a:rPr>
              <a:t>Rajbhandari Figure S5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B2629BF-0D09-0540-AA5F-3289E97B6787}"/>
              </a:ext>
            </a:extLst>
          </p:cNvPr>
          <p:cNvSpPr/>
          <p:nvPr/>
        </p:nvSpPr>
        <p:spPr>
          <a:xfrm>
            <a:off x="424634" y="1223522"/>
            <a:ext cx="303481" cy="3742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E666C27-FB16-524E-A8EE-AF8E8E8500DC}"/>
              </a:ext>
            </a:extLst>
          </p:cNvPr>
          <p:cNvSpPr/>
          <p:nvPr/>
        </p:nvSpPr>
        <p:spPr>
          <a:xfrm>
            <a:off x="1416816" y="1194368"/>
            <a:ext cx="303481" cy="3742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6AF209C-6526-534F-A075-B1CA6BDA512E}"/>
              </a:ext>
            </a:extLst>
          </p:cNvPr>
          <p:cNvSpPr/>
          <p:nvPr/>
        </p:nvSpPr>
        <p:spPr>
          <a:xfrm>
            <a:off x="902801" y="4023710"/>
            <a:ext cx="303481" cy="3742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4004C0-2940-F747-A7D4-07A2E31197A4}"/>
              </a:ext>
            </a:extLst>
          </p:cNvPr>
          <p:cNvSpPr txBox="1"/>
          <p:nvPr/>
        </p:nvSpPr>
        <p:spPr>
          <a:xfrm>
            <a:off x="516285" y="1140529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6FA5D2F-68D2-C44D-AA3B-93650E658C0C}"/>
              </a:ext>
            </a:extLst>
          </p:cNvPr>
          <p:cNvSpPr txBox="1"/>
          <p:nvPr/>
        </p:nvSpPr>
        <p:spPr>
          <a:xfrm>
            <a:off x="475861" y="4194821"/>
            <a:ext cx="373820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519A1BD-1A19-E447-8E51-A6689AE026F6}"/>
              </a:ext>
            </a:extLst>
          </p:cNvPr>
          <p:cNvSpPr/>
          <p:nvPr/>
        </p:nvSpPr>
        <p:spPr>
          <a:xfrm>
            <a:off x="2110296" y="1071362"/>
            <a:ext cx="303481" cy="3742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pic>
        <p:nvPicPr>
          <p:cNvPr id="12" name="Picture 11" descr="A close up of a map&#10;&#10;Description automatically generated">
            <a:extLst>
              <a:ext uri="{FF2B5EF4-FFF2-40B4-BE49-F238E27FC236}">
                <a16:creationId xmlns:a16="http://schemas.microsoft.com/office/drawing/2014/main" id="{0F228E0A-CBE0-F641-90CD-0DA608451F3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6113" t="24060" b="50193"/>
          <a:stretch/>
        </p:blipFill>
        <p:spPr>
          <a:xfrm>
            <a:off x="1206281" y="1047879"/>
            <a:ext cx="6007460" cy="3025355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4451FBB4-D2E7-4C4B-BFB4-FC77E3352CC4}"/>
              </a:ext>
            </a:extLst>
          </p:cNvPr>
          <p:cNvSpPr/>
          <p:nvPr/>
        </p:nvSpPr>
        <p:spPr>
          <a:xfrm>
            <a:off x="1206282" y="934002"/>
            <a:ext cx="303481" cy="3742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C87B6FC-889A-6F4E-B7DF-869A255759D8}"/>
              </a:ext>
            </a:extLst>
          </p:cNvPr>
          <p:cNvSpPr/>
          <p:nvPr/>
        </p:nvSpPr>
        <p:spPr>
          <a:xfrm>
            <a:off x="1416816" y="4043715"/>
            <a:ext cx="303481" cy="37424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207"/>
          </a:p>
        </p:txBody>
      </p:sp>
    </p:spTree>
    <p:extLst>
      <p:ext uri="{BB962C8B-B14F-4D97-AF65-F5344CB8AC3E}">
        <p14:creationId xmlns:p14="http://schemas.microsoft.com/office/powerpoint/2010/main" val="3981357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43</TotalTime>
  <Words>137</Words>
  <Application>Microsoft Macintosh PowerPoint</Application>
  <PresentationFormat>Custom</PresentationFormat>
  <Paragraphs>70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a Rajbhandari</dc:creator>
  <cp:lastModifiedBy>Microsoft Office User</cp:lastModifiedBy>
  <cp:revision>205</cp:revision>
  <cp:lastPrinted>2019-10-15T13:24:02Z</cp:lastPrinted>
  <dcterms:created xsi:type="dcterms:W3CDTF">2018-11-19T16:52:17Z</dcterms:created>
  <dcterms:modified xsi:type="dcterms:W3CDTF">2019-10-15T13:24:07Z</dcterms:modified>
</cp:coreProperties>
</file>